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4.xml" ContentType="application/vnd.openxmlformats-officedocument.drawingml.chartshapes+xml"/>
  <Override PartName="/ppt/charts/chart6.xml" ContentType="application/vnd.openxmlformats-officedocument.drawingml.chart+xml"/>
  <Override PartName="/ppt/drawings/drawing5.xml" ContentType="application/vnd.openxmlformats-officedocument.drawingml.chartshapes+xml"/>
  <Override PartName="/ppt/charts/chart7.xml" ContentType="application/vnd.openxmlformats-officedocument.drawingml.chart+xml"/>
  <Override PartName="/ppt/drawings/drawing6.xml" ContentType="application/vnd.openxmlformats-officedocument.drawingml.chartshapes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  <Override PartName="/ppt/charts/colors7.xml" ContentType="application/vnd.ms-office.chartcolorstyle+xml"/>
  <Override PartName="/ppt/charts/style7.xml" ContentType="application/vnd.ms-office.chartstyle+xml"/>
  <Override PartName="/ppt/charts/style8.xml" ContentType="application/vnd.ms-office.chartstyle+xml"/>
  <Override PartName="/ppt/charts/colors8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362" userDrawn="1">
          <p15:clr>
            <a:srgbClr val="A4A3A4"/>
          </p15:clr>
        </p15:guide>
        <p15:guide id="2" pos="1481" userDrawn="1">
          <p15:clr>
            <a:srgbClr val="A4A3A4"/>
          </p15:clr>
        </p15:guide>
        <p15:guide id="3" pos="52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laudius Gottschalk" initials="CG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5280" autoAdjust="0"/>
  </p:normalViewPr>
  <p:slideViewPr>
    <p:cSldViewPr snapToGrid="0" showGuides="1">
      <p:cViewPr varScale="1">
        <p:scale>
          <a:sx n="113" d="100"/>
          <a:sy n="113" d="100"/>
        </p:scale>
        <p:origin x="-138" y="-234"/>
      </p:cViewPr>
      <p:guideLst>
        <p:guide orient="horz" pos="3362"/>
        <p:guide pos="1481"/>
        <p:guide pos="52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Relationship Id="rId4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2.xlsx"/><Relationship Id="rId4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Worksheet3.xlsx"/><Relationship Id="rId4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1" Type="http://schemas.openxmlformats.org/officeDocument/2006/relationships/package" Target="../embeddings/Microsoft_Excel_Worksheet4.xlsx"/><Relationship Id="rId4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openxmlformats.org/officeDocument/2006/relationships/chartUserShapes" Target="../drawings/drawing4.xml"/><Relationship Id="rId1" Type="http://schemas.openxmlformats.org/officeDocument/2006/relationships/package" Target="../embeddings/Microsoft_Excel_Worksheet5.xlsx"/><Relationship Id="rId4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openxmlformats.org/officeDocument/2006/relationships/chartUserShapes" Target="../drawings/drawing5.xml"/><Relationship Id="rId1" Type="http://schemas.openxmlformats.org/officeDocument/2006/relationships/package" Target="../embeddings/Microsoft_Excel_Worksheet6.xlsx"/><Relationship Id="rId4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openxmlformats.org/officeDocument/2006/relationships/chartUserShapes" Target="../drawings/drawing6.xml"/><Relationship Id="rId1" Type="http://schemas.openxmlformats.org/officeDocument/2006/relationships/package" Target="../embeddings/Microsoft_Excel_Worksheet7.xlsx"/><Relationship Id="rId4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Style" Target="style8.xml"/><Relationship Id="rId2" Type="http://schemas.microsoft.com/office/2011/relationships/chartColorStyle" Target="colors8.xml"/><Relationship Id="rId1" Type="http://schemas.openxmlformats.org/officeDocument/2006/relationships/package" Target="../embeddings/Microsoft_Excel_Worksheet8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94791666666666"/>
          <c:y val="2.9545370370370371E-2"/>
          <c:w val="0.75852326388888891"/>
          <c:h val="0.81182222222222233"/>
        </c:manualLayout>
      </c:layout>
      <c:scatterChart>
        <c:scatterStyle val="line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MN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174</c:f>
              <c:numCache>
                <c:formatCode>0</c:formatCode>
                <c:ptCount val="173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B$2:$B$174</c:f>
              <c:numCache>
                <c:formatCode>0.0</c:formatCode>
                <c:ptCount val="173"/>
                <c:pt idx="0">
                  <c:v>1.0933999999999999</c:v>
                </c:pt>
                <c:pt idx="1">
                  <c:v>1.863</c:v>
                </c:pt>
                <c:pt idx="2">
                  <c:v>0.6794</c:v>
                </c:pt>
                <c:pt idx="3">
                  <c:v>1.6576000000000002</c:v>
                </c:pt>
                <c:pt idx="4">
                  <c:v>1.323</c:v>
                </c:pt>
                <c:pt idx="5">
                  <c:v>2.6624000000000003</c:v>
                </c:pt>
                <c:pt idx="6">
                  <c:v>1.7489999999999999</c:v>
                </c:pt>
                <c:pt idx="7">
                  <c:v>2.1470000000000002</c:v>
                </c:pt>
                <c:pt idx="8">
                  <c:v>1.6529999999999998</c:v>
                </c:pt>
                <c:pt idx="9">
                  <c:v>1.6192000000000002</c:v>
                </c:pt>
                <c:pt idx="10">
                  <c:v>2.8898999999999999</c:v>
                </c:pt>
                <c:pt idx="11">
                  <c:v>2.3630000000000004</c:v>
                </c:pt>
                <c:pt idx="12">
                  <c:v>1.4274</c:v>
                </c:pt>
                <c:pt idx="13">
                  <c:v>1.2062000000000002</c:v>
                </c:pt>
                <c:pt idx="14">
                  <c:v>1.8479999999999999</c:v>
                </c:pt>
                <c:pt idx="15">
                  <c:v>2.5983999999999998</c:v>
                </c:pt>
                <c:pt idx="16">
                  <c:v>1.8360000000000003</c:v>
                </c:pt>
                <c:pt idx="17">
                  <c:v>0.97599999999999998</c:v>
                </c:pt>
                <c:pt idx="18">
                  <c:v>2.0531999999999999</c:v>
                </c:pt>
                <c:pt idx="19">
                  <c:v>3.5874999999999999</c:v>
                </c:pt>
                <c:pt idx="20">
                  <c:v>2.9375999999999998</c:v>
                </c:pt>
                <c:pt idx="21">
                  <c:v>2.5615000000000001</c:v>
                </c:pt>
                <c:pt idx="22">
                  <c:v>1.4973000000000003</c:v>
                </c:pt>
                <c:pt idx="23">
                  <c:v>1.3139999999999998</c:v>
                </c:pt>
                <c:pt idx="24">
                  <c:v>2.3328000000000002</c:v>
                </c:pt>
                <c:pt idx="25">
                  <c:v>3.0240000000000005</c:v>
                </c:pt>
                <c:pt idx="26">
                  <c:v>0.96050000000000013</c:v>
                </c:pt>
                <c:pt idx="27">
                  <c:v>1.5005999999999999</c:v>
                </c:pt>
                <c:pt idx="28">
                  <c:v>0.61599999999999999</c:v>
                </c:pt>
                <c:pt idx="29">
                  <c:v>2.0124</c:v>
                </c:pt>
                <c:pt idx="30">
                  <c:v>3.4398</c:v>
                </c:pt>
                <c:pt idx="31">
                  <c:v>1.0625</c:v>
                </c:pt>
                <c:pt idx="32">
                  <c:v>1.7674999999999998</c:v>
                </c:pt>
                <c:pt idx="33">
                  <c:v>2.2994999999999997</c:v>
                </c:pt>
                <c:pt idx="34">
                  <c:v>1.5566</c:v>
                </c:pt>
                <c:pt idx="35">
                  <c:v>2.7641000000000004</c:v>
                </c:pt>
                <c:pt idx="36">
                  <c:v>0.98899999999999988</c:v>
                </c:pt>
                <c:pt idx="37">
                  <c:v>0.9447000000000001</c:v>
                </c:pt>
                <c:pt idx="38">
                  <c:v>2.73</c:v>
                </c:pt>
                <c:pt idx="39">
                  <c:v>0.99909999999999999</c:v>
                </c:pt>
                <c:pt idx="40">
                  <c:v>0.86139999999999994</c:v>
                </c:pt>
                <c:pt idx="41">
                  <c:v>1.7578</c:v>
                </c:pt>
                <c:pt idx="42">
                  <c:v>2.5724000000000005</c:v>
                </c:pt>
                <c:pt idx="43">
                  <c:v>1.5708</c:v>
                </c:pt>
                <c:pt idx="44">
                  <c:v>0.75600000000000012</c:v>
                </c:pt>
                <c:pt idx="45">
                  <c:v>1.2813999999999999</c:v>
                </c:pt>
                <c:pt idx="46">
                  <c:v>2.5134000000000003</c:v>
                </c:pt>
                <c:pt idx="47">
                  <c:v>3.6463999999999994</c:v>
                </c:pt>
                <c:pt idx="48">
                  <c:v>1.1534</c:v>
                </c:pt>
                <c:pt idx="49">
                  <c:v>1.2342</c:v>
                </c:pt>
                <c:pt idx="50">
                  <c:v>1.905</c:v>
                </c:pt>
                <c:pt idx="51">
                  <c:v>1.083</c:v>
                </c:pt>
                <c:pt idx="52">
                  <c:v>0.9225000000000001</c:v>
                </c:pt>
                <c:pt idx="53">
                  <c:v>1.5145000000000002</c:v>
                </c:pt>
                <c:pt idx="54">
                  <c:v>1.3139999999999998</c:v>
                </c:pt>
                <c:pt idx="55">
                  <c:v>1.9982</c:v>
                </c:pt>
                <c:pt idx="56">
                  <c:v>1.7836000000000001</c:v>
                </c:pt>
                <c:pt idx="57">
                  <c:v>1.8211999999999997</c:v>
                </c:pt>
                <c:pt idx="58">
                  <c:v>1.5619999999999998</c:v>
                </c:pt>
                <c:pt idx="59">
                  <c:v>1.5621</c:v>
                </c:pt>
                <c:pt idx="60">
                  <c:v>0.66</c:v>
                </c:pt>
                <c:pt idx="61">
                  <c:v>2.6084999999999998</c:v>
                </c:pt>
                <c:pt idx="62">
                  <c:v>0.94530000000000003</c:v>
                </c:pt>
                <c:pt idx="63">
                  <c:v>1.45</c:v>
                </c:pt>
                <c:pt idx="64">
                  <c:v>1.1400000000000001</c:v>
                </c:pt>
                <c:pt idx="65">
                  <c:v>1.125</c:v>
                </c:pt>
                <c:pt idx="66">
                  <c:v>1.0691999999999999</c:v>
                </c:pt>
                <c:pt idx="67">
                  <c:v>1.3746</c:v>
                </c:pt>
                <c:pt idx="68">
                  <c:v>1.3804000000000001</c:v>
                </c:pt>
                <c:pt idx="69">
                  <c:v>1.2995000000000001</c:v>
                </c:pt>
                <c:pt idx="70">
                  <c:v>2.3220000000000001</c:v>
                </c:pt>
                <c:pt idx="71">
                  <c:v>1.5029999999999999</c:v>
                </c:pt>
                <c:pt idx="72">
                  <c:v>0.92399999999999993</c:v>
                </c:pt>
                <c:pt idx="73">
                  <c:v>1.1179999999999999</c:v>
                </c:pt>
                <c:pt idx="74">
                  <c:v>1.3225</c:v>
                </c:pt>
                <c:pt idx="75">
                  <c:v>1.1374</c:v>
                </c:pt>
                <c:pt idx="76">
                  <c:v>0.61709999999999998</c:v>
                </c:pt>
                <c:pt idx="77">
                  <c:v>0.93059999999999998</c:v>
                </c:pt>
                <c:pt idx="78">
                  <c:v>1.0211999999999999</c:v>
                </c:pt>
                <c:pt idx="79">
                  <c:v>1.0396000000000001</c:v>
                </c:pt>
                <c:pt idx="80">
                  <c:v>0.47520000000000007</c:v>
                </c:pt>
                <c:pt idx="81">
                  <c:v>1.8972000000000002</c:v>
                </c:pt>
                <c:pt idx="82">
                  <c:v>1.4580000000000002</c:v>
                </c:pt>
                <c:pt idx="83">
                  <c:v>2.6884000000000006</c:v>
                </c:pt>
                <c:pt idx="84">
                  <c:v>2.1951999999999998</c:v>
                </c:pt>
                <c:pt idx="85">
                  <c:v>0.52200000000000002</c:v>
                </c:pt>
                <c:pt idx="86">
                  <c:v>1.0292000000000001</c:v>
                </c:pt>
                <c:pt idx="87">
                  <c:v>2.0010000000000003</c:v>
                </c:pt>
                <c:pt idx="88">
                  <c:v>1.032</c:v>
                </c:pt>
                <c:pt idx="89">
                  <c:v>1.1778</c:v>
                </c:pt>
                <c:pt idx="90">
                  <c:v>1.1865000000000001</c:v>
                </c:pt>
                <c:pt idx="91">
                  <c:v>1.7645999999999999</c:v>
                </c:pt>
                <c:pt idx="92">
                  <c:v>1.5023000000000002</c:v>
                </c:pt>
                <c:pt idx="93">
                  <c:v>2.625999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AB5-4C29-8FF4-C70DBD0C10A3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Spalte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174</c:f>
              <c:numCache>
                <c:formatCode>0</c:formatCode>
                <c:ptCount val="173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C$2:$C$174</c:f>
              <c:numCache>
                <c:formatCode>General</c:formatCode>
                <c:ptCount val="173"/>
                <c:pt idx="95" formatCode="0.0">
                  <c:v>1.5136000000000001</c:v>
                </c:pt>
                <c:pt idx="96" formatCode="0.0">
                  <c:v>4.1496000000000004</c:v>
                </c:pt>
                <c:pt idx="97" formatCode="0.0">
                  <c:v>2.6695000000000002</c:v>
                </c:pt>
                <c:pt idx="98" formatCode="0.0">
                  <c:v>4.2897000000000007</c:v>
                </c:pt>
                <c:pt idx="99" formatCode="0.0">
                  <c:v>1.7871000000000001</c:v>
                </c:pt>
                <c:pt idx="100" formatCode="0.0">
                  <c:v>3.7240000000000006</c:v>
                </c:pt>
                <c:pt idx="101" formatCode="0.0">
                  <c:v>1.0027999999999999</c:v>
                </c:pt>
                <c:pt idx="102" formatCode="0.0">
                  <c:v>2.7477</c:v>
                </c:pt>
                <c:pt idx="103" formatCode="0.0">
                  <c:v>1.0296000000000001</c:v>
                </c:pt>
                <c:pt idx="104" formatCode="0.0">
                  <c:v>1.8953999999999998</c:v>
                </c:pt>
                <c:pt idx="105" formatCode="0.0">
                  <c:v>2.7709999999999999</c:v>
                </c:pt>
                <c:pt idx="106" formatCode="0.0">
                  <c:v>3.9122999999999997</c:v>
                </c:pt>
                <c:pt idx="107" formatCode="0.0">
                  <c:v>1.5645</c:v>
                </c:pt>
                <c:pt idx="108" formatCode="0.0">
                  <c:v>1.5228000000000002</c:v>
                </c:pt>
                <c:pt idx="109" formatCode="0.0">
                  <c:v>1.5519999999999998</c:v>
                </c:pt>
                <c:pt idx="110" formatCode="0.0">
                  <c:v>3.0560000000000005</c:v>
                </c:pt>
                <c:pt idx="111" formatCode="0.0">
                  <c:v>2.1888000000000001</c:v>
                </c:pt>
                <c:pt idx="112" formatCode="0.0">
                  <c:v>0.4355</c:v>
                </c:pt>
                <c:pt idx="113" formatCode="0.0">
                  <c:v>2.7749999999999999</c:v>
                </c:pt>
                <c:pt idx="114" formatCode="0.0">
                  <c:v>1.2150000000000001</c:v>
                </c:pt>
                <c:pt idx="115" formatCode="0.0">
                  <c:v>1.0125</c:v>
                </c:pt>
                <c:pt idx="116" formatCode="0.0">
                  <c:v>2.6448</c:v>
                </c:pt>
                <c:pt idx="117" formatCode="0.0">
                  <c:v>1.2090000000000001</c:v>
                </c:pt>
                <c:pt idx="118" formatCode="0.0">
                  <c:v>1.4329000000000001</c:v>
                </c:pt>
                <c:pt idx="119" formatCode="0.0">
                  <c:v>0.72599999999999998</c:v>
                </c:pt>
                <c:pt idx="120" formatCode="0.0">
                  <c:v>5.0751999999999997</c:v>
                </c:pt>
                <c:pt idx="121" formatCode="0.0">
                  <c:v>1.026</c:v>
                </c:pt>
                <c:pt idx="122" formatCode="0.0">
                  <c:v>2.8388</c:v>
                </c:pt>
                <c:pt idx="123" formatCode="0.0">
                  <c:v>0.59670000000000001</c:v>
                </c:pt>
                <c:pt idx="124" formatCode="0.0">
                  <c:v>1.3415999999999999</c:v>
                </c:pt>
                <c:pt idx="125" formatCode="0.0">
                  <c:v>2.2320000000000002</c:v>
                </c:pt>
                <c:pt idx="126" formatCode="0.0">
                  <c:v>1.296</c:v>
                </c:pt>
                <c:pt idx="127" formatCode="0.0">
                  <c:v>2.3643000000000001</c:v>
                </c:pt>
                <c:pt idx="128" formatCode="0.0">
                  <c:v>2.0196000000000001</c:v>
                </c:pt>
                <c:pt idx="129" formatCode="0.0">
                  <c:v>7.1136999999999997</c:v>
                </c:pt>
                <c:pt idx="130" formatCode="0.0">
                  <c:v>1.0529999999999999</c:v>
                </c:pt>
                <c:pt idx="131" formatCode="0.0">
                  <c:v>2.2230000000000003</c:v>
                </c:pt>
                <c:pt idx="132" formatCode="0.0">
                  <c:v>3.4668000000000005</c:v>
                </c:pt>
                <c:pt idx="133" formatCode="0.0">
                  <c:v>5.3391999999999999</c:v>
                </c:pt>
                <c:pt idx="134" formatCode="0.0">
                  <c:v>4.2827999999999991</c:v>
                </c:pt>
                <c:pt idx="135" formatCode="0.0">
                  <c:v>1.5980000000000001</c:v>
                </c:pt>
                <c:pt idx="136" formatCode="0.0">
                  <c:v>4.7614000000000001</c:v>
                </c:pt>
                <c:pt idx="137" formatCode="0.0">
                  <c:v>1.1815000000000002</c:v>
                </c:pt>
                <c:pt idx="138" formatCode="0.0">
                  <c:v>1.6904999999999999</c:v>
                </c:pt>
                <c:pt idx="139" formatCode="0.0">
                  <c:v>4.2273000000000005</c:v>
                </c:pt>
                <c:pt idx="140" formatCode="0.0">
                  <c:v>0.90160000000000007</c:v>
                </c:pt>
                <c:pt idx="141" formatCode="0.0">
                  <c:v>2.2868999999999997</c:v>
                </c:pt>
                <c:pt idx="142" formatCode="0.0">
                  <c:v>1.4835</c:v>
                </c:pt>
                <c:pt idx="143" formatCode="0.0">
                  <c:v>2.3010000000000002</c:v>
                </c:pt>
                <c:pt idx="144" formatCode="0.0">
                  <c:v>3.5474999999999999</c:v>
                </c:pt>
                <c:pt idx="145" formatCode="0.0">
                  <c:v>1.7010000000000001</c:v>
                </c:pt>
                <c:pt idx="146" formatCode="0.0">
                  <c:v>1.5679999999999998</c:v>
                </c:pt>
                <c:pt idx="147" formatCode="0.0">
                  <c:v>5.4962999999999989</c:v>
                </c:pt>
                <c:pt idx="148" formatCode="0.0">
                  <c:v>0.85119999999999985</c:v>
                </c:pt>
                <c:pt idx="149" formatCode="0.0">
                  <c:v>2.9580000000000002</c:v>
                </c:pt>
                <c:pt idx="150" formatCode="0.0">
                  <c:v>1.2424999999999999</c:v>
                </c:pt>
                <c:pt idx="151" formatCode="0.0">
                  <c:v>1.4259999999999999</c:v>
                </c:pt>
                <c:pt idx="152" formatCode="0.0">
                  <c:v>1.6512000000000002</c:v>
                </c:pt>
                <c:pt idx="153" formatCode="0.0">
                  <c:v>2.0357999999999996</c:v>
                </c:pt>
                <c:pt idx="154" formatCode="0.0">
                  <c:v>1.1315</c:v>
                </c:pt>
                <c:pt idx="155" formatCode="0.0">
                  <c:v>2.6884000000000001</c:v>
                </c:pt>
                <c:pt idx="156" formatCode="0.0">
                  <c:v>1.5773999999999999</c:v>
                </c:pt>
                <c:pt idx="157" formatCode="0.0">
                  <c:v>1.6872</c:v>
                </c:pt>
                <c:pt idx="158" formatCode="0.0">
                  <c:v>2.1947999999999999</c:v>
                </c:pt>
                <c:pt idx="159" formatCode="0.0">
                  <c:v>3.4540000000000002</c:v>
                </c:pt>
                <c:pt idx="160" formatCode="0.0">
                  <c:v>4.3460000000000001</c:v>
                </c:pt>
                <c:pt idx="161" formatCode="0.0">
                  <c:v>2.5676000000000001</c:v>
                </c:pt>
                <c:pt idx="162" formatCode="0.0">
                  <c:v>3.1486000000000001</c:v>
                </c:pt>
                <c:pt idx="163" formatCode="0.0">
                  <c:v>0.81199999999999994</c:v>
                </c:pt>
                <c:pt idx="164" formatCode="0.0">
                  <c:v>2.0671999999999997</c:v>
                </c:pt>
                <c:pt idx="165" formatCode="0.0">
                  <c:v>1.1251999999999998</c:v>
                </c:pt>
                <c:pt idx="166" formatCode="0.0">
                  <c:v>2.4803999999999999</c:v>
                </c:pt>
                <c:pt idx="167" formatCode="0.0">
                  <c:v>0.76380000000000003</c:v>
                </c:pt>
                <c:pt idx="168" formatCode="0.0">
                  <c:v>3.0129999999999999</c:v>
                </c:pt>
                <c:pt idx="169" formatCode="0.0">
                  <c:v>1.2733000000000001</c:v>
                </c:pt>
                <c:pt idx="170" formatCode="0.0">
                  <c:v>1.3800000000000001</c:v>
                </c:pt>
                <c:pt idx="171" formatCode="0.0">
                  <c:v>1.2529000000000001</c:v>
                </c:pt>
                <c:pt idx="172" formatCode="0.0">
                  <c:v>1.825799999999999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5AB5-4C29-8FF4-C70DBD0C10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921664"/>
        <c:axId val="73923584"/>
      </c:scatterChart>
      <c:valAx>
        <c:axId val="73921664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>
                    <a:solidFill>
                      <a:schemeClr val="tx1"/>
                    </a:solidFill>
                  </a:rPr>
                  <a:t>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73923584"/>
        <c:crosses val="autoZero"/>
        <c:crossBetween val="midCat"/>
        <c:majorUnit val="20"/>
        <c:minorUnit val="4"/>
      </c:valAx>
      <c:valAx>
        <c:axId val="73923584"/>
        <c:scaling>
          <c:orientation val="minMax"/>
        </c:scaling>
        <c:delete val="0"/>
        <c:axPos val="l"/>
        <c:numFmt formatCode="0.0" sourceLinked="1"/>
        <c:majorTickMark val="in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739216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 i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94791666666666"/>
          <c:y val="2.9545370370370371E-2"/>
          <c:w val="0.75852326388888891"/>
          <c:h val="0.81182222222222233"/>
        </c:manualLayout>
      </c:layout>
      <c:scatterChart>
        <c:scatterStyle val="line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CD31-Me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B$2:$B$609</c:f>
              <c:numCache>
                <c:formatCode>0.0</c:formatCode>
                <c:ptCount val="608"/>
                <c:pt idx="0">
                  <c:v>4.4800999999999993</c:v>
                </c:pt>
                <c:pt idx="1">
                  <c:v>5.4394999999999998</c:v>
                </c:pt>
                <c:pt idx="2">
                  <c:v>6.0114000000000001</c:v>
                </c:pt>
                <c:pt idx="3">
                  <c:v>3.5668000000000006</c:v>
                </c:pt>
                <c:pt idx="4">
                  <c:v>4.1257999999999999</c:v>
                </c:pt>
                <c:pt idx="5">
                  <c:v>7.04</c:v>
                </c:pt>
                <c:pt idx="6">
                  <c:v>5.6604000000000001</c:v>
                </c:pt>
                <c:pt idx="7">
                  <c:v>6.0228999999999999</c:v>
                </c:pt>
                <c:pt idx="8">
                  <c:v>5.1109999999999998</c:v>
                </c:pt>
                <c:pt idx="9">
                  <c:v>4.9312000000000005</c:v>
                </c:pt>
                <c:pt idx="10">
                  <c:v>9.0921999999999983</c:v>
                </c:pt>
                <c:pt idx="11">
                  <c:v>3.9355000000000002</c:v>
                </c:pt>
                <c:pt idx="12">
                  <c:v>4.8516000000000004</c:v>
                </c:pt>
                <c:pt idx="13">
                  <c:v>3.8850000000000007</c:v>
                </c:pt>
                <c:pt idx="14">
                  <c:v>8.3159999999999989</c:v>
                </c:pt>
                <c:pt idx="15">
                  <c:v>5.8927999999999994</c:v>
                </c:pt>
                <c:pt idx="16">
                  <c:v>3.4056000000000002</c:v>
                </c:pt>
                <c:pt idx="17">
                  <c:v>3.9466999999999999</c:v>
                </c:pt>
                <c:pt idx="18">
                  <c:v>7.2923999999999998</c:v>
                </c:pt>
                <c:pt idx="19">
                  <c:v>5.35</c:v>
                </c:pt>
                <c:pt idx="20">
                  <c:v>5.5487999999999991</c:v>
                </c:pt>
                <c:pt idx="21">
                  <c:v>4.7415000000000003</c:v>
                </c:pt>
                <c:pt idx="22">
                  <c:v>5.8962000000000003</c:v>
                </c:pt>
                <c:pt idx="23">
                  <c:v>4.9319999999999995</c:v>
                </c:pt>
                <c:pt idx="24">
                  <c:v>5.8968000000000007</c:v>
                </c:pt>
                <c:pt idx="25">
                  <c:v>8.89</c:v>
                </c:pt>
                <c:pt idx="26">
                  <c:v>5.7205000000000004</c:v>
                </c:pt>
                <c:pt idx="27">
                  <c:v>4.7313999999999998</c:v>
                </c:pt>
                <c:pt idx="28">
                  <c:v>3.7235</c:v>
                </c:pt>
                <c:pt idx="29">
                  <c:v>6.0839999999999996</c:v>
                </c:pt>
                <c:pt idx="30">
                  <c:v>7.8372000000000002</c:v>
                </c:pt>
                <c:pt idx="31">
                  <c:v>8.8625000000000007</c:v>
                </c:pt>
                <c:pt idx="32">
                  <c:v>5.9287000000000001</c:v>
                </c:pt>
                <c:pt idx="33">
                  <c:v>5.5229999999999997</c:v>
                </c:pt>
                <c:pt idx="34">
                  <c:v>5.7447999999999997</c:v>
                </c:pt>
                <c:pt idx="35">
                  <c:v>6.4976000000000003</c:v>
                </c:pt>
                <c:pt idx="36">
                  <c:v>5.9683999999999999</c:v>
                </c:pt>
                <c:pt idx="37">
                  <c:v>2.6555</c:v>
                </c:pt>
                <c:pt idx="38">
                  <c:v>6.6464999999999996</c:v>
                </c:pt>
                <c:pt idx="39">
                  <c:v>6.8093999999999992</c:v>
                </c:pt>
                <c:pt idx="40">
                  <c:v>5.1975999999999996</c:v>
                </c:pt>
                <c:pt idx="41">
                  <c:v>5.3579999999999997</c:v>
                </c:pt>
                <c:pt idx="42">
                  <c:v>7.2688000000000006</c:v>
                </c:pt>
                <c:pt idx="43">
                  <c:v>6.3647999999999998</c:v>
                </c:pt>
                <c:pt idx="44">
                  <c:v>4.2280000000000006</c:v>
                </c:pt>
                <c:pt idx="45">
                  <c:v>5.7964000000000002</c:v>
                </c:pt>
                <c:pt idx="46">
                  <c:v>7.6700000000000008</c:v>
                </c:pt>
                <c:pt idx="47">
                  <c:v>9.9931999999999999</c:v>
                </c:pt>
                <c:pt idx="48">
                  <c:v>5.9171000000000005</c:v>
                </c:pt>
                <c:pt idx="49">
                  <c:v>3.6696000000000004</c:v>
                </c:pt>
                <c:pt idx="50">
                  <c:v>10.058400000000001</c:v>
                </c:pt>
                <c:pt idx="51">
                  <c:v>8.595600000000001</c:v>
                </c:pt>
                <c:pt idx="52">
                  <c:v>10.0983</c:v>
                </c:pt>
                <c:pt idx="53">
                  <c:v>3.9584999999999999</c:v>
                </c:pt>
                <c:pt idx="54">
                  <c:v>5.7149999999999999</c:v>
                </c:pt>
                <c:pt idx="55">
                  <c:v>6.8803999999999998</c:v>
                </c:pt>
                <c:pt idx="56">
                  <c:v>5.2688999999999995</c:v>
                </c:pt>
                <c:pt idx="57">
                  <c:v>8.3520000000000003</c:v>
                </c:pt>
                <c:pt idx="58">
                  <c:v>10.2524</c:v>
                </c:pt>
                <c:pt idx="59">
                  <c:v>9.156699999999999</c:v>
                </c:pt>
                <c:pt idx="60">
                  <c:v>5.4384000000000006</c:v>
                </c:pt>
                <c:pt idx="61">
                  <c:v>6.3380999999999998</c:v>
                </c:pt>
                <c:pt idx="62">
                  <c:v>4.8162000000000003</c:v>
                </c:pt>
                <c:pt idx="63">
                  <c:v>8.85</c:v>
                </c:pt>
                <c:pt idx="64">
                  <c:v>7.91</c:v>
                </c:pt>
                <c:pt idx="65">
                  <c:v>5.5425000000000004</c:v>
                </c:pt>
                <c:pt idx="66">
                  <c:v>5.8482000000000003</c:v>
                </c:pt>
                <c:pt idx="67">
                  <c:v>5.0024999999999995</c:v>
                </c:pt>
                <c:pt idx="68">
                  <c:v>9.698500000000001</c:v>
                </c:pt>
                <c:pt idx="69">
                  <c:v>8.5202000000000009</c:v>
                </c:pt>
                <c:pt idx="70">
                  <c:v>6.6636000000000015</c:v>
                </c:pt>
                <c:pt idx="71">
                  <c:v>6.66</c:v>
                </c:pt>
                <c:pt idx="72">
                  <c:v>4.9279999999999999</c:v>
                </c:pt>
                <c:pt idx="73">
                  <c:v>6.3897999999999993</c:v>
                </c:pt>
                <c:pt idx="74">
                  <c:v>9.5105000000000004</c:v>
                </c:pt>
                <c:pt idx="75">
                  <c:v>6.2886000000000006</c:v>
                </c:pt>
                <c:pt idx="76">
                  <c:v>9.7525999999999993</c:v>
                </c:pt>
                <c:pt idx="77">
                  <c:v>4.4022000000000006</c:v>
                </c:pt>
                <c:pt idx="78">
                  <c:v>9.6237000000000013</c:v>
                </c:pt>
                <c:pt idx="79">
                  <c:v>5.6947999999999999</c:v>
                </c:pt>
                <c:pt idx="80">
                  <c:v>9.4068000000000005</c:v>
                </c:pt>
                <c:pt idx="81">
                  <c:v>5.8404000000000007</c:v>
                </c:pt>
                <c:pt idx="82">
                  <c:v>10.0845</c:v>
                </c:pt>
                <c:pt idx="83">
                  <c:v>10.439000000000002</c:v>
                </c:pt>
                <c:pt idx="84">
                  <c:v>6.3406000000000002</c:v>
                </c:pt>
                <c:pt idx="85">
                  <c:v>7.0469999999999997</c:v>
                </c:pt>
                <c:pt idx="86">
                  <c:v>6.3329000000000004</c:v>
                </c:pt>
                <c:pt idx="87">
                  <c:v>11.053800000000001</c:v>
                </c:pt>
                <c:pt idx="88">
                  <c:v>6.1360000000000001</c:v>
                </c:pt>
                <c:pt idx="89">
                  <c:v>6.1386000000000003</c:v>
                </c:pt>
                <c:pt idx="90">
                  <c:v>8.7149999999999999</c:v>
                </c:pt>
                <c:pt idx="91">
                  <c:v>7.9559999999999995</c:v>
                </c:pt>
                <c:pt idx="92">
                  <c:v>6.0092000000000008</c:v>
                </c:pt>
                <c:pt idx="93">
                  <c:v>15.27119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07E-4810-A45B-B2B22775EAA0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Spalte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C$2:$C$609</c:f>
              <c:numCache>
                <c:formatCode>General</c:formatCode>
                <c:ptCount val="608"/>
                <c:pt idx="95" formatCode="0.0">
                  <c:v>5.59</c:v>
                </c:pt>
                <c:pt idx="96" formatCode="0.0">
                  <c:v>10.428599999999999</c:v>
                </c:pt>
                <c:pt idx="97" formatCode="0.0">
                  <c:v>4.7690000000000001</c:v>
                </c:pt>
                <c:pt idx="98" formatCode="0.0">
                  <c:v>10.443700000000002</c:v>
                </c:pt>
                <c:pt idx="99" formatCode="0.0">
                  <c:v>7.2260999999999997</c:v>
                </c:pt>
                <c:pt idx="100" formatCode="0.0">
                  <c:v>6.1320000000000006</c:v>
                </c:pt>
                <c:pt idx="101" formatCode="0.0">
                  <c:v>6.3204000000000002</c:v>
                </c:pt>
                <c:pt idx="102" formatCode="0.0">
                  <c:v>8.4881999999999991</c:v>
                </c:pt>
                <c:pt idx="103" formatCode="0.0">
                  <c:v>5.7112000000000007</c:v>
                </c:pt>
                <c:pt idx="104" formatCode="0.0">
                  <c:v>6.1425000000000001</c:v>
                </c:pt>
                <c:pt idx="105" formatCode="0.0">
                  <c:v>9.5681000000000012</c:v>
                </c:pt>
                <c:pt idx="106" formatCode="0.0">
                  <c:v>12.585599999999999</c:v>
                </c:pt>
                <c:pt idx="107" formatCode="0.0">
                  <c:v>11.1601</c:v>
                </c:pt>
                <c:pt idx="108" formatCode="0.0">
                  <c:v>6.1992000000000003</c:v>
                </c:pt>
                <c:pt idx="109" formatCode="0.0">
                  <c:v>3.8080000000000003</c:v>
                </c:pt>
                <c:pt idx="110" formatCode="0.0">
                  <c:v>10.432</c:v>
                </c:pt>
                <c:pt idx="111" formatCode="0.0">
                  <c:v>10.555200000000001</c:v>
                </c:pt>
                <c:pt idx="112" formatCode="0.0">
                  <c:v>5.5342000000000002</c:v>
                </c:pt>
                <c:pt idx="113" formatCode="0.0">
                  <c:v>4.5399000000000003</c:v>
                </c:pt>
                <c:pt idx="114" formatCode="0.0">
                  <c:v>5.0544000000000002</c:v>
                </c:pt>
                <c:pt idx="115" formatCode="0.0">
                  <c:v>4.8675000000000006</c:v>
                </c:pt>
                <c:pt idx="116" formatCode="0.0">
                  <c:v>18.327999999999999</c:v>
                </c:pt>
                <c:pt idx="117" formatCode="0.0">
                  <c:v>4.8048000000000002</c:v>
                </c:pt>
                <c:pt idx="118" formatCode="0.0">
                  <c:v>11.978400000000001</c:v>
                </c:pt>
                <c:pt idx="119" formatCode="0.0">
                  <c:v>9.8735999999999997</c:v>
                </c:pt>
                <c:pt idx="120" formatCode="0.0">
                  <c:v>30.534400000000005</c:v>
                </c:pt>
                <c:pt idx="121" formatCode="0.0">
                  <c:v>6.878000000000001</c:v>
                </c:pt>
                <c:pt idx="122" formatCode="0.0">
                  <c:v>14.4948</c:v>
                </c:pt>
                <c:pt idx="123" formatCode="0.0">
                  <c:v>20.332000000000001</c:v>
                </c:pt>
                <c:pt idx="124" formatCode="0.0">
                  <c:v>4.992</c:v>
                </c:pt>
                <c:pt idx="125" formatCode="0.0">
                  <c:v>4.9755000000000011</c:v>
                </c:pt>
                <c:pt idx="126" formatCode="0.0">
                  <c:v>3.6239999999999997</c:v>
                </c:pt>
                <c:pt idx="127" formatCode="0.0">
                  <c:v>7.3815</c:v>
                </c:pt>
                <c:pt idx="128" formatCode="0.0">
                  <c:v>9.1212</c:v>
                </c:pt>
                <c:pt idx="129" formatCode="0.0">
                  <c:v>11.306100000000001</c:v>
                </c:pt>
                <c:pt idx="130" formatCode="0.0">
                  <c:v>6.6869999999999994</c:v>
                </c:pt>
                <c:pt idx="131" formatCode="0.0">
                  <c:v>13.252500000000001</c:v>
                </c:pt>
                <c:pt idx="132" formatCode="0.0">
                  <c:v>5.1732000000000005</c:v>
                </c:pt>
                <c:pt idx="133" formatCode="0.0">
                  <c:v>11.261200000000001</c:v>
                </c:pt>
                <c:pt idx="134" formatCode="0.0">
                  <c:v>9.3739999999999988</c:v>
                </c:pt>
                <c:pt idx="135" formatCode="0.0">
                  <c:v>6.6928000000000001</c:v>
                </c:pt>
                <c:pt idx="136" formatCode="0.0">
                  <c:v>11.652899999999999</c:v>
                </c:pt>
                <c:pt idx="137" formatCode="0.0">
                  <c:v>11.717700000000001</c:v>
                </c:pt>
                <c:pt idx="138" formatCode="0.0">
                  <c:v>8.418000000000001</c:v>
                </c:pt>
                <c:pt idx="139" formatCode="0.0">
                  <c:v>16.839900000000004</c:v>
                </c:pt>
                <c:pt idx="140" formatCode="0.0">
                  <c:v>7.0380000000000003</c:v>
                </c:pt>
                <c:pt idx="141" formatCode="0.0">
                  <c:v>8.7604000000000006</c:v>
                </c:pt>
                <c:pt idx="142" formatCode="0.0">
                  <c:v>10.1007</c:v>
                </c:pt>
                <c:pt idx="143" formatCode="0.0">
                  <c:v>8.1066000000000003</c:v>
                </c:pt>
                <c:pt idx="144" formatCode="0.0">
                  <c:v>15.716499999999998</c:v>
                </c:pt>
                <c:pt idx="145" formatCode="0.0">
                  <c:v>10.516500000000001</c:v>
                </c:pt>
                <c:pt idx="146" formatCode="0.0">
                  <c:v>7.3695999999999993</c:v>
                </c:pt>
                <c:pt idx="147" formatCode="0.0">
                  <c:v>9.9484999999999992</c:v>
                </c:pt>
                <c:pt idx="148" formatCode="0.0">
                  <c:v>7.5711999999999984</c:v>
                </c:pt>
                <c:pt idx="149" formatCode="0.0">
                  <c:v>11.321999999999999</c:v>
                </c:pt>
                <c:pt idx="150" formatCode="0.0">
                  <c:v>5.3604999999999992</c:v>
                </c:pt>
                <c:pt idx="151" formatCode="0.0">
                  <c:v>9.4983999999999984</c:v>
                </c:pt>
                <c:pt idx="152" formatCode="0.0">
                  <c:v>8.7074999999999996</c:v>
                </c:pt>
                <c:pt idx="153" formatCode="0.0">
                  <c:v>5.942099999999999</c:v>
                </c:pt>
                <c:pt idx="154" formatCode="0.0">
                  <c:v>4.9128999999999996</c:v>
                </c:pt>
                <c:pt idx="155" formatCode="0.0">
                  <c:v>5.7809999999999997</c:v>
                </c:pt>
                <c:pt idx="156" formatCode="0.0">
                  <c:v>3.7884000000000002</c:v>
                </c:pt>
                <c:pt idx="157" formatCode="0.0">
                  <c:v>7.548</c:v>
                </c:pt>
                <c:pt idx="158" formatCode="0.0">
                  <c:v>7.9112</c:v>
                </c:pt>
                <c:pt idx="159" formatCode="0.0">
                  <c:v>10.0951</c:v>
                </c:pt>
                <c:pt idx="160" formatCode="0.0">
                  <c:v>19.424500000000002</c:v>
                </c:pt>
                <c:pt idx="161" formatCode="0.0">
                  <c:v>14.562799999999999</c:v>
                </c:pt>
                <c:pt idx="162" formatCode="0.0">
                  <c:v>13.195</c:v>
                </c:pt>
                <c:pt idx="163" formatCode="0.0">
                  <c:v>12.76</c:v>
                </c:pt>
                <c:pt idx="164" formatCode="0.0">
                  <c:v>12.16</c:v>
                </c:pt>
                <c:pt idx="165" formatCode="0.0">
                  <c:v>7.7308999999999992</c:v>
                </c:pt>
                <c:pt idx="166" formatCode="0.0">
                  <c:v>11.341200000000001</c:v>
                </c:pt>
                <c:pt idx="167" formatCode="0.0">
                  <c:v>9.7469999999999999</c:v>
                </c:pt>
                <c:pt idx="168" formatCode="0.0">
                  <c:v>7.7290000000000001</c:v>
                </c:pt>
                <c:pt idx="169" formatCode="0.0">
                  <c:v>8.4252000000000002</c:v>
                </c:pt>
                <c:pt idx="170" formatCode="0.0">
                  <c:v>11.191800000000001</c:v>
                </c:pt>
                <c:pt idx="171" formatCode="0.0">
                  <c:v>16.250299999999999</c:v>
                </c:pt>
                <c:pt idx="172" formatCode="0.0">
                  <c:v>7.578599999999998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07E-4810-A45B-B2B22775EA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5674240"/>
        <c:axId val="85692800"/>
      </c:scatterChart>
      <c:valAx>
        <c:axId val="85674240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>
                    <a:solidFill>
                      <a:schemeClr val="tx1"/>
                    </a:solidFill>
                  </a:rPr>
                  <a:t>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85692800"/>
        <c:crosses val="autoZero"/>
        <c:crossBetween val="midCat"/>
        <c:majorUnit val="20"/>
        <c:minorUnit val="4"/>
      </c:valAx>
      <c:valAx>
        <c:axId val="85692800"/>
        <c:scaling>
          <c:orientation val="minMax"/>
        </c:scaling>
        <c:delete val="0"/>
        <c:axPos val="l"/>
        <c:numFmt formatCode="0.0" sourceLinked="1"/>
        <c:majorTickMark val="in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856742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 i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94791666666666"/>
          <c:y val="2.9545370370370371E-2"/>
          <c:w val="0.75852326388888891"/>
          <c:h val="0.81182222222222233"/>
        </c:manualLayout>
      </c:layout>
      <c:scatterChart>
        <c:scatterStyle val="line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MN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174</c:f>
              <c:numCache>
                <c:formatCode>0</c:formatCode>
                <c:ptCount val="173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B$2:$B$174</c:f>
              <c:numCache>
                <c:formatCode>0.0</c:formatCode>
                <c:ptCount val="173"/>
                <c:pt idx="0">
                  <c:v>15.590399999999999</c:v>
                </c:pt>
                <c:pt idx="1">
                  <c:v>12.9801</c:v>
                </c:pt>
                <c:pt idx="2">
                  <c:v>8.8658000000000001</c:v>
                </c:pt>
                <c:pt idx="3">
                  <c:v>24.090299999999999</c:v>
                </c:pt>
                <c:pt idx="4">
                  <c:v>8.91</c:v>
                </c:pt>
                <c:pt idx="5">
                  <c:v>18.857300000000002</c:v>
                </c:pt>
                <c:pt idx="6">
                  <c:v>8.93</c:v>
                </c:pt>
                <c:pt idx="7">
                  <c:v>10.089</c:v>
                </c:pt>
                <c:pt idx="8">
                  <c:v>13.56</c:v>
                </c:pt>
                <c:pt idx="9">
                  <c:v>19.047000000000001</c:v>
                </c:pt>
                <c:pt idx="10">
                  <c:v>12.088799999999999</c:v>
                </c:pt>
                <c:pt idx="11">
                  <c:v>30.744000000000003</c:v>
                </c:pt>
                <c:pt idx="12">
                  <c:v>12.065099999999999</c:v>
                </c:pt>
                <c:pt idx="13">
                  <c:v>16.650000000000002</c:v>
                </c:pt>
                <c:pt idx="14">
                  <c:v>24.348299999999998</c:v>
                </c:pt>
                <c:pt idx="15">
                  <c:v>17.355699999999999</c:v>
                </c:pt>
                <c:pt idx="16">
                  <c:v>12.978000000000002</c:v>
                </c:pt>
                <c:pt idx="17">
                  <c:v>20.8505</c:v>
                </c:pt>
                <c:pt idx="18">
                  <c:v>19.338000000000001</c:v>
                </c:pt>
                <c:pt idx="19">
                  <c:v>12.803699999999999</c:v>
                </c:pt>
                <c:pt idx="20">
                  <c:v>23.284099999999999</c:v>
                </c:pt>
                <c:pt idx="21">
                  <c:v>12.890499999999999</c:v>
                </c:pt>
                <c:pt idx="22">
                  <c:v>13.408799999999999</c:v>
                </c:pt>
                <c:pt idx="23">
                  <c:v>12.726000000000001</c:v>
                </c:pt>
                <c:pt idx="24">
                  <c:v>17.730899999999998</c:v>
                </c:pt>
                <c:pt idx="25">
                  <c:v>20.381999999999998</c:v>
                </c:pt>
                <c:pt idx="26">
                  <c:v>15.812200000000001</c:v>
                </c:pt>
                <c:pt idx="27">
                  <c:v>15.113999999999999</c:v>
                </c:pt>
                <c:pt idx="28">
                  <c:v>18.049500000000002</c:v>
                </c:pt>
                <c:pt idx="29">
                  <c:v>9.2714999999999996</c:v>
                </c:pt>
                <c:pt idx="30">
                  <c:v>28.8963</c:v>
                </c:pt>
                <c:pt idx="31">
                  <c:v>7.8052999999999999</c:v>
                </c:pt>
                <c:pt idx="32">
                  <c:v>10.327</c:v>
                </c:pt>
                <c:pt idx="33">
                  <c:v>12.890499999999999</c:v>
                </c:pt>
                <c:pt idx="34">
                  <c:v>14.956799999999999</c:v>
                </c:pt>
                <c:pt idx="35">
                  <c:v>15.224</c:v>
                </c:pt>
                <c:pt idx="36">
                  <c:v>12.142899999999999</c:v>
                </c:pt>
                <c:pt idx="37">
                  <c:v>25.540399999999998</c:v>
                </c:pt>
                <c:pt idx="38">
                  <c:v>23.601599999999998</c:v>
                </c:pt>
                <c:pt idx="39">
                  <c:v>16.055600000000002</c:v>
                </c:pt>
                <c:pt idx="40">
                  <c:v>17.352399999999999</c:v>
                </c:pt>
                <c:pt idx="41">
                  <c:v>14.670000000000002</c:v>
                </c:pt>
                <c:pt idx="42">
                  <c:v>7.5421999999999993</c:v>
                </c:pt>
                <c:pt idx="43">
                  <c:v>11.840399999999999</c:v>
                </c:pt>
                <c:pt idx="44">
                  <c:v>9.3828999999999994</c:v>
                </c:pt>
                <c:pt idx="45">
                  <c:v>18.148799999999998</c:v>
                </c:pt>
                <c:pt idx="46">
                  <c:v>32.0105</c:v>
                </c:pt>
                <c:pt idx="47">
                  <c:v>16.291900000000002</c:v>
                </c:pt>
                <c:pt idx="48">
                  <c:v>12.603999999999999</c:v>
                </c:pt>
                <c:pt idx="49">
                  <c:v>33.645200000000003</c:v>
                </c:pt>
                <c:pt idx="50">
                  <c:v>18.878400000000003</c:v>
                </c:pt>
                <c:pt idx="51">
                  <c:v>10.531500000000001</c:v>
                </c:pt>
                <c:pt idx="52">
                  <c:v>8.1282000000000014</c:v>
                </c:pt>
                <c:pt idx="53">
                  <c:v>21.692</c:v>
                </c:pt>
                <c:pt idx="54">
                  <c:v>15.453000000000001</c:v>
                </c:pt>
                <c:pt idx="55">
                  <c:v>17.2224</c:v>
                </c:pt>
                <c:pt idx="56">
                  <c:v>14.6188</c:v>
                </c:pt>
                <c:pt idx="57">
                  <c:v>18.366400000000002</c:v>
                </c:pt>
                <c:pt idx="58">
                  <c:v>19.1296</c:v>
                </c:pt>
                <c:pt idx="59">
                  <c:v>13.125</c:v>
                </c:pt>
                <c:pt idx="60">
                  <c:v>28.393599999999999</c:v>
                </c:pt>
                <c:pt idx="61">
                  <c:v>18.2928</c:v>
                </c:pt>
                <c:pt idx="62">
                  <c:v>27.341999999999999</c:v>
                </c:pt>
                <c:pt idx="63">
                  <c:v>22.986200000000004</c:v>
                </c:pt>
                <c:pt idx="64">
                  <c:v>24.273</c:v>
                </c:pt>
                <c:pt idx="65">
                  <c:v>29.4756</c:v>
                </c:pt>
                <c:pt idx="66">
                  <c:v>20.8613</c:v>
                </c:pt>
                <c:pt idx="67">
                  <c:v>38.311</c:v>
                </c:pt>
                <c:pt idx="68">
                  <c:v>25.108499999999996</c:v>
                </c:pt>
                <c:pt idx="69">
                  <c:v>11.6197</c:v>
                </c:pt>
                <c:pt idx="70">
                  <c:v>23.192</c:v>
                </c:pt>
                <c:pt idx="71">
                  <c:v>23.880399999999998</c:v>
                </c:pt>
                <c:pt idx="72">
                  <c:v>15.506399999999999</c:v>
                </c:pt>
                <c:pt idx="73">
                  <c:v>29.581199999999995</c:v>
                </c:pt>
                <c:pt idx="74">
                  <c:v>28.1996</c:v>
                </c:pt>
                <c:pt idx="75">
                  <c:v>14.373600000000001</c:v>
                </c:pt>
                <c:pt idx="76">
                  <c:v>7.7264000000000008</c:v>
                </c:pt>
                <c:pt idx="77">
                  <c:v>15.114599999999998</c:v>
                </c:pt>
                <c:pt idx="78">
                  <c:v>21.288</c:v>
                </c:pt>
                <c:pt idx="79">
                  <c:v>23.219200000000001</c:v>
                </c:pt>
                <c:pt idx="80">
                  <c:v>11.2392</c:v>
                </c:pt>
                <c:pt idx="81">
                  <c:v>20.113199999999999</c:v>
                </c:pt>
                <c:pt idx="82">
                  <c:v>11.61</c:v>
                </c:pt>
                <c:pt idx="83">
                  <c:v>21.057600000000001</c:v>
                </c:pt>
                <c:pt idx="84">
                  <c:v>24.39</c:v>
                </c:pt>
                <c:pt idx="85">
                  <c:v>18.351299999999998</c:v>
                </c:pt>
                <c:pt idx="86">
                  <c:v>45.024700000000003</c:v>
                </c:pt>
                <c:pt idx="87">
                  <c:v>22.153399999999998</c:v>
                </c:pt>
                <c:pt idx="88">
                  <c:v>23.603200000000001</c:v>
                </c:pt>
                <c:pt idx="89">
                  <c:v>34.537499999999994</c:v>
                </c:pt>
                <c:pt idx="90">
                  <c:v>35.979000000000006</c:v>
                </c:pt>
                <c:pt idx="91">
                  <c:v>36.279200000000003</c:v>
                </c:pt>
                <c:pt idx="92">
                  <c:v>31.143999999999998</c:v>
                </c:pt>
                <c:pt idx="93">
                  <c:v>29.20679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45F-4BDE-BD8B-6CBEF8FBBF82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Spalte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174</c:f>
              <c:numCache>
                <c:formatCode>0</c:formatCode>
                <c:ptCount val="173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C$2:$C$174</c:f>
              <c:numCache>
                <c:formatCode>General</c:formatCode>
                <c:ptCount val="173"/>
                <c:pt idx="95" formatCode="0.0">
                  <c:v>13.6037</c:v>
                </c:pt>
                <c:pt idx="96" formatCode="0.0">
                  <c:v>11.711700000000002</c:v>
                </c:pt>
                <c:pt idx="97" formatCode="0.0">
                  <c:v>22.468799999999998</c:v>
                </c:pt>
                <c:pt idx="98" formatCode="0.0">
                  <c:v>17.526599999999998</c:v>
                </c:pt>
                <c:pt idx="99" formatCode="0.0">
                  <c:v>17.138400000000001</c:v>
                </c:pt>
                <c:pt idx="100" formatCode="0.0">
                  <c:v>11.782</c:v>
                </c:pt>
                <c:pt idx="101" formatCode="0.0">
                  <c:v>4.8123999999999993</c:v>
                </c:pt>
                <c:pt idx="102" formatCode="0.0">
                  <c:v>21.398799999999998</c:v>
                </c:pt>
                <c:pt idx="103" formatCode="0.0">
                  <c:v>8.2992000000000008</c:v>
                </c:pt>
                <c:pt idx="104" formatCode="0.0">
                  <c:v>6.0927000000000007</c:v>
                </c:pt>
                <c:pt idx="105" formatCode="0.0">
                  <c:v>11.703999999999999</c:v>
                </c:pt>
                <c:pt idx="106" formatCode="0.0">
                  <c:v>23.1264</c:v>
                </c:pt>
                <c:pt idx="107" formatCode="0.0">
                  <c:v>10.5152</c:v>
                </c:pt>
                <c:pt idx="108" formatCode="0.0">
                  <c:v>13.364999999999998</c:v>
                </c:pt>
                <c:pt idx="109" formatCode="0.0">
                  <c:v>13.6012</c:v>
                </c:pt>
                <c:pt idx="110" formatCode="0.0">
                  <c:v>20.639400000000002</c:v>
                </c:pt>
                <c:pt idx="111" formatCode="0.0">
                  <c:v>20.898499999999999</c:v>
                </c:pt>
                <c:pt idx="112" formatCode="0.0">
                  <c:v>16.140899999999998</c:v>
                </c:pt>
                <c:pt idx="113" formatCode="0.0">
                  <c:v>16.339199999999998</c:v>
                </c:pt>
                <c:pt idx="114" formatCode="0.0">
                  <c:v>12.576599999999999</c:v>
                </c:pt>
                <c:pt idx="115" formatCode="0.0">
                  <c:v>11.3529</c:v>
                </c:pt>
                <c:pt idx="116" formatCode="0.0">
                  <c:v>19.7119</c:v>
                </c:pt>
                <c:pt idx="117" formatCode="0.0">
                  <c:v>9.9576000000000011</c:v>
                </c:pt>
                <c:pt idx="118" formatCode="0.0">
                  <c:v>7.7934000000000001</c:v>
                </c:pt>
                <c:pt idx="119" formatCode="0.0">
                  <c:v>10.824999999999999</c:v>
                </c:pt>
                <c:pt idx="120" formatCode="0.0">
                  <c:v>6.4268999999999989</c:v>
                </c:pt>
                <c:pt idx="121" formatCode="0.0">
                  <c:v>14.661</c:v>
                </c:pt>
                <c:pt idx="122" formatCode="0.0">
                  <c:v>12.6015</c:v>
                </c:pt>
                <c:pt idx="123" formatCode="0.0">
                  <c:v>6.3795999999999999</c:v>
                </c:pt>
                <c:pt idx="124" formatCode="0.0">
                  <c:v>18.419999999999998</c:v>
                </c:pt>
                <c:pt idx="125" formatCode="0.0">
                  <c:v>18.774899999999999</c:v>
                </c:pt>
                <c:pt idx="126" formatCode="0.0">
                  <c:v>35.456399999999995</c:v>
                </c:pt>
                <c:pt idx="127" formatCode="0.0">
                  <c:v>16.605599999999999</c:v>
                </c:pt>
                <c:pt idx="128" formatCode="0.0">
                  <c:v>14.218799999999998</c:v>
                </c:pt>
                <c:pt idx="129" formatCode="0.0">
                  <c:v>21.107199999999995</c:v>
                </c:pt>
                <c:pt idx="130" formatCode="0.0">
                  <c:v>13.65</c:v>
                </c:pt>
                <c:pt idx="131" formatCode="0.0">
                  <c:v>17.470800000000001</c:v>
                </c:pt>
                <c:pt idx="132" formatCode="0.0">
                  <c:v>23.585000000000001</c:v>
                </c:pt>
                <c:pt idx="133" formatCode="0.0">
                  <c:v>20.898000000000003</c:v>
                </c:pt>
                <c:pt idx="134" formatCode="0.0">
                  <c:v>17.387999999999998</c:v>
                </c:pt>
                <c:pt idx="135" formatCode="0.0">
                  <c:v>18.029399999999995</c:v>
                </c:pt>
                <c:pt idx="136" formatCode="0.0">
                  <c:v>22.249099999999999</c:v>
                </c:pt>
                <c:pt idx="137" formatCode="0.0">
                  <c:v>8.17</c:v>
                </c:pt>
                <c:pt idx="138" formatCode="0.0">
                  <c:v>16.568199999999997</c:v>
                </c:pt>
                <c:pt idx="139" formatCode="0.0">
                  <c:v>14.2265</c:v>
                </c:pt>
                <c:pt idx="140" formatCode="0.0">
                  <c:v>21.519599999999997</c:v>
                </c:pt>
                <c:pt idx="141" formatCode="0.0">
                  <c:v>27.657</c:v>
                </c:pt>
                <c:pt idx="142" formatCode="0.0">
                  <c:v>28.362000000000002</c:v>
                </c:pt>
                <c:pt idx="143" formatCode="0.0">
                  <c:v>26.341899999999995</c:v>
                </c:pt>
                <c:pt idx="144" formatCode="0.0">
                  <c:v>7.7022000000000004</c:v>
                </c:pt>
                <c:pt idx="145" formatCode="0.0">
                  <c:v>20.131200000000003</c:v>
                </c:pt>
                <c:pt idx="146" formatCode="0.0">
                  <c:v>10.2005</c:v>
                </c:pt>
                <c:pt idx="147" formatCode="0.0">
                  <c:v>15.36</c:v>
                </c:pt>
                <c:pt idx="148" formatCode="0.0">
                  <c:v>11.544</c:v>
                </c:pt>
                <c:pt idx="149" formatCode="0.0">
                  <c:v>10.362500000000001</c:v>
                </c:pt>
                <c:pt idx="150" formatCode="0.0">
                  <c:v>29.510399999999997</c:v>
                </c:pt>
                <c:pt idx="151" formatCode="0.0">
                  <c:v>27.387499999999999</c:v>
                </c:pt>
                <c:pt idx="152" formatCode="0.0">
                  <c:v>12.6295</c:v>
                </c:pt>
                <c:pt idx="153" formatCode="0.0">
                  <c:v>36.571200000000005</c:v>
                </c:pt>
                <c:pt idx="154" formatCode="0.0">
                  <c:v>26.419500000000003</c:v>
                </c:pt>
                <c:pt idx="155" formatCode="0.0">
                  <c:v>41.855199999999996</c:v>
                </c:pt>
                <c:pt idx="156" formatCode="0.0">
                  <c:v>37.546800000000005</c:v>
                </c:pt>
                <c:pt idx="157" formatCode="0.0">
                  <c:v>16.1616</c:v>
                </c:pt>
                <c:pt idx="158" formatCode="0.0">
                  <c:v>16.012499999999999</c:v>
                </c:pt>
                <c:pt idx="159" formatCode="0.0">
                  <c:v>31.275300000000001</c:v>
                </c:pt>
                <c:pt idx="160" formatCode="0.0">
                  <c:v>8.2208000000000006</c:v>
                </c:pt>
                <c:pt idx="161" formatCode="0.0">
                  <c:v>10.117799999999999</c:v>
                </c:pt>
                <c:pt idx="162" formatCode="0.0">
                  <c:v>30.893999999999998</c:v>
                </c:pt>
                <c:pt idx="163" formatCode="0.0">
                  <c:v>24.680600000000002</c:v>
                </c:pt>
                <c:pt idx="164" formatCode="0.0">
                  <c:v>9.5485000000000007</c:v>
                </c:pt>
                <c:pt idx="165" formatCode="0.0">
                  <c:v>15.8025</c:v>
                </c:pt>
                <c:pt idx="166" formatCode="0.0">
                  <c:v>12.9514</c:v>
                </c:pt>
                <c:pt idx="167" formatCode="0.0">
                  <c:v>16.707599999999999</c:v>
                </c:pt>
                <c:pt idx="168" formatCode="0.0">
                  <c:v>24.303999999999998</c:v>
                </c:pt>
                <c:pt idx="169" formatCode="0.0">
                  <c:v>26.224</c:v>
                </c:pt>
                <c:pt idx="170" formatCode="0.0">
                  <c:v>21.6111</c:v>
                </c:pt>
                <c:pt idx="171" formatCode="0.0">
                  <c:v>19.024199999999997</c:v>
                </c:pt>
                <c:pt idx="172" formatCode="0.0">
                  <c:v>27.1791000000000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45F-4BDE-BD8B-6CBEF8FBBF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5716352"/>
        <c:axId val="107161088"/>
      </c:scatterChart>
      <c:valAx>
        <c:axId val="85716352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>
                    <a:solidFill>
                      <a:schemeClr val="tx1"/>
                    </a:solidFill>
                  </a:rPr>
                  <a:t>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07161088"/>
        <c:crosses val="autoZero"/>
        <c:crossBetween val="midCat"/>
        <c:majorUnit val="20"/>
        <c:minorUnit val="4"/>
      </c:valAx>
      <c:valAx>
        <c:axId val="107161088"/>
        <c:scaling>
          <c:orientation val="minMax"/>
        </c:scaling>
        <c:delete val="0"/>
        <c:axPos val="l"/>
        <c:numFmt formatCode="0.0" sourceLinked="1"/>
        <c:majorTickMark val="in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857163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 i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94791666666666"/>
          <c:y val="2.9545370370370371E-2"/>
          <c:w val="0.75852326388888891"/>
          <c:h val="0.81182222222222233"/>
        </c:manualLayout>
      </c:layout>
      <c:scatterChart>
        <c:scatterStyle val="line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CD31-Me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B$2:$B$609</c:f>
              <c:numCache>
                <c:formatCode>0.0</c:formatCode>
                <c:ptCount val="608"/>
                <c:pt idx="0">
                  <c:v>33.408000000000001</c:v>
                </c:pt>
                <c:pt idx="1">
                  <c:v>36.379600000000003</c:v>
                </c:pt>
                <c:pt idx="2">
                  <c:v>36.834199999999996</c:v>
                </c:pt>
                <c:pt idx="3">
                  <c:v>22.151999999999997</c:v>
                </c:pt>
                <c:pt idx="4">
                  <c:v>21.33</c:v>
                </c:pt>
                <c:pt idx="5">
                  <c:v>30.849500000000003</c:v>
                </c:pt>
                <c:pt idx="6">
                  <c:v>27.950900000000001</c:v>
                </c:pt>
                <c:pt idx="7">
                  <c:v>42.391500000000001</c:v>
                </c:pt>
                <c:pt idx="8">
                  <c:v>39.776000000000003</c:v>
                </c:pt>
                <c:pt idx="9">
                  <c:v>33.649700000000003</c:v>
                </c:pt>
                <c:pt idx="10">
                  <c:v>44.132399999999997</c:v>
                </c:pt>
                <c:pt idx="11">
                  <c:v>23.698499999999999</c:v>
                </c:pt>
                <c:pt idx="12">
                  <c:v>41.537099999999995</c:v>
                </c:pt>
                <c:pt idx="13">
                  <c:v>24.697500000000002</c:v>
                </c:pt>
                <c:pt idx="14">
                  <c:v>25.2273</c:v>
                </c:pt>
                <c:pt idx="15">
                  <c:v>34.711399999999998</c:v>
                </c:pt>
                <c:pt idx="16">
                  <c:v>34.762500000000003</c:v>
                </c:pt>
                <c:pt idx="17">
                  <c:v>41.981500000000004</c:v>
                </c:pt>
                <c:pt idx="18">
                  <c:v>40.433999999999997</c:v>
                </c:pt>
                <c:pt idx="19">
                  <c:v>33.010899999999999</c:v>
                </c:pt>
                <c:pt idx="20">
                  <c:v>38.836800000000004</c:v>
                </c:pt>
                <c:pt idx="21">
                  <c:v>32.981900000000003</c:v>
                </c:pt>
                <c:pt idx="22">
                  <c:v>36.964799999999997</c:v>
                </c:pt>
                <c:pt idx="23">
                  <c:v>30.178800000000003</c:v>
                </c:pt>
                <c:pt idx="24">
                  <c:v>42.58979999999999</c:v>
                </c:pt>
                <c:pt idx="25">
                  <c:v>40.591999999999999</c:v>
                </c:pt>
                <c:pt idx="26">
                  <c:v>46.796800000000005</c:v>
                </c:pt>
                <c:pt idx="27">
                  <c:v>41.861199999999997</c:v>
                </c:pt>
                <c:pt idx="28">
                  <c:v>34.209000000000003</c:v>
                </c:pt>
                <c:pt idx="29">
                  <c:v>36.379600000000003</c:v>
                </c:pt>
                <c:pt idx="30">
                  <c:v>39.459600000000002</c:v>
                </c:pt>
                <c:pt idx="31">
                  <c:v>43.148400000000002</c:v>
                </c:pt>
                <c:pt idx="32">
                  <c:v>50.377800000000001</c:v>
                </c:pt>
                <c:pt idx="33">
                  <c:v>48.094900000000003</c:v>
                </c:pt>
                <c:pt idx="34">
                  <c:v>49.430400000000006</c:v>
                </c:pt>
                <c:pt idx="35">
                  <c:v>28.285500000000003</c:v>
                </c:pt>
                <c:pt idx="36">
                  <c:v>38.4373</c:v>
                </c:pt>
                <c:pt idx="37">
                  <c:v>45.267499999999998</c:v>
                </c:pt>
                <c:pt idx="38">
                  <c:v>31.3794</c:v>
                </c:pt>
                <c:pt idx="39">
                  <c:v>45.190200000000004</c:v>
                </c:pt>
                <c:pt idx="40">
                  <c:v>41.534999999999997</c:v>
                </c:pt>
                <c:pt idx="41">
                  <c:v>43.2</c:v>
                </c:pt>
                <c:pt idx="42">
                  <c:v>54.637099999999997</c:v>
                </c:pt>
                <c:pt idx="43">
                  <c:v>41.351700000000001</c:v>
                </c:pt>
                <c:pt idx="44">
                  <c:v>32.0505</c:v>
                </c:pt>
                <c:pt idx="45">
                  <c:v>49.248000000000005</c:v>
                </c:pt>
                <c:pt idx="46">
                  <c:v>30.870400000000004</c:v>
                </c:pt>
                <c:pt idx="47">
                  <c:v>31.674099999999999</c:v>
                </c:pt>
                <c:pt idx="48">
                  <c:v>65.688000000000002</c:v>
                </c:pt>
                <c:pt idx="49">
                  <c:v>27.214400000000001</c:v>
                </c:pt>
                <c:pt idx="50">
                  <c:v>53.576200000000007</c:v>
                </c:pt>
                <c:pt idx="51">
                  <c:v>47.613</c:v>
                </c:pt>
                <c:pt idx="52">
                  <c:v>65.200400000000002</c:v>
                </c:pt>
                <c:pt idx="53">
                  <c:v>41.887999999999998</c:v>
                </c:pt>
                <c:pt idx="54">
                  <c:v>22.9068</c:v>
                </c:pt>
                <c:pt idx="55">
                  <c:v>54.447900000000004</c:v>
                </c:pt>
                <c:pt idx="56">
                  <c:v>37.046399999999991</c:v>
                </c:pt>
                <c:pt idx="57">
                  <c:v>47.682000000000002</c:v>
                </c:pt>
                <c:pt idx="58">
                  <c:v>45.689000000000007</c:v>
                </c:pt>
                <c:pt idx="59">
                  <c:v>52.15</c:v>
                </c:pt>
                <c:pt idx="60">
                  <c:v>51.463400000000007</c:v>
                </c:pt>
                <c:pt idx="61">
                  <c:v>35.431199999999997</c:v>
                </c:pt>
                <c:pt idx="62">
                  <c:v>41.571000000000005</c:v>
                </c:pt>
                <c:pt idx="63">
                  <c:v>33.998600000000003</c:v>
                </c:pt>
                <c:pt idx="64">
                  <c:v>41.7136</c:v>
                </c:pt>
                <c:pt idx="65">
                  <c:v>33.541199999999996</c:v>
                </c:pt>
                <c:pt idx="66">
                  <c:v>48.798900000000003</c:v>
                </c:pt>
                <c:pt idx="67">
                  <c:v>24.115000000000002</c:v>
                </c:pt>
                <c:pt idx="68">
                  <c:v>54.093399999999995</c:v>
                </c:pt>
                <c:pt idx="69">
                  <c:v>58.364599999999996</c:v>
                </c:pt>
                <c:pt idx="70">
                  <c:v>32.736400000000003</c:v>
                </c:pt>
                <c:pt idx="71">
                  <c:v>44.582799999999999</c:v>
                </c:pt>
                <c:pt idx="72">
                  <c:v>33.781799999999997</c:v>
                </c:pt>
                <c:pt idx="73">
                  <c:v>28.576899999999998</c:v>
                </c:pt>
                <c:pt idx="74">
                  <c:v>48.177999999999997</c:v>
                </c:pt>
                <c:pt idx="75">
                  <c:v>38.239199999999997</c:v>
                </c:pt>
                <c:pt idx="76">
                  <c:v>54.875</c:v>
                </c:pt>
                <c:pt idx="77">
                  <c:v>29.762699999999995</c:v>
                </c:pt>
                <c:pt idx="78">
                  <c:v>52.1556</c:v>
                </c:pt>
                <c:pt idx="79">
                  <c:v>50.519900000000007</c:v>
                </c:pt>
                <c:pt idx="80">
                  <c:v>64.313199999999995</c:v>
                </c:pt>
                <c:pt idx="81">
                  <c:v>45.934199999999997</c:v>
                </c:pt>
                <c:pt idx="82">
                  <c:v>61.834000000000003</c:v>
                </c:pt>
                <c:pt idx="83">
                  <c:v>45.368000000000002</c:v>
                </c:pt>
                <c:pt idx="84">
                  <c:v>49.95</c:v>
                </c:pt>
                <c:pt idx="85">
                  <c:v>46.380399999999995</c:v>
                </c:pt>
                <c:pt idx="86">
                  <c:v>33.653900000000007</c:v>
                </c:pt>
                <c:pt idx="87">
                  <c:v>56.547199999999997</c:v>
                </c:pt>
                <c:pt idx="88">
                  <c:v>48.681600000000003</c:v>
                </c:pt>
                <c:pt idx="89">
                  <c:v>49.457699999999996</c:v>
                </c:pt>
                <c:pt idx="90">
                  <c:v>42.96</c:v>
                </c:pt>
                <c:pt idx="91">
                  <c:v>45.977600000000002</c:v>
                </c:pt>
                <c:pt idx="92">
                  <c:v>25.739599999999999</c:v>
                </c:pt>
                <c:pt idx="93">
                  <c:v>38.1443999999999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D6B-4550-9762-021BB777E28D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Spalte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C$2:$C$609</c:f>
              <c:numCache>
                <c:formatCode>General</c:formatCode>
                <c:ptCount val="608"/>
                <c:pt idx="95" formatCode="0.0">
                  <c:v>23.372799999999998</c:v>
                </c:pt>
                <c:pt idx="96" formatCode="0.0">
                  <c:v>35.135100000000001</c:v>
                </c:pt>
                <c:pt idx="97" formatCode="0.0">
                  <c:v>28.901399999999995</c:v>
                </c:pt>
                <c:pt idx="98" formatCode="0.0">
                  <c:v>19.737900000000003</c:v>
                </c:pt>
                <c:pt idx="99" formatCode="0.0">
                  <c:v>44.311199999999999</c:v>
                </c:pt>
                <c:pt idx="100" formatCode="0.0">
                  <c:v>13.33</c:v>
                </c:pt>
                <c:pt idx="101" formatCode="0.0">
                  <c:v>55.569599999999994</c:v>
                </c:pt>
                <c:pt idx="102" formatCode="0.0">
                  <c:v>31.922799999999999</c:v>
                </c:pt>
                <c:pt idx="103" formatCode="0.0">
                  <c:v>46.238400000000006</c:v>
                </c:pt>
                <c:pt idx="104" formatCode="0.0">
                  <c:v>37.350899999999996</c:v>
                </c:pt>
                <c:pt idx="105" formatCode="0.0">
                  <c:v>42.552399999999999</c:v>
                </c:pt>
                <c:pt idx="106" formatCode="0.0">
                  <c:v>34.214400000000005</c:v>
                </c:pt>
                <c:pt idx="107" formatCode="0.0">
                  <c:v>42.0608</c:v>
                </c:pt>
                <c:pt idx="108" formatCode="0.0">
                  <c:v>40.005899999999997</c:v>
                </c:pt>
                <c:pt idx="109" formatCode="0.0">
                  <c:v>36.760000000000005</c:v>
                </c:pt>
                <c:pt idx="110" formatCode="0.0">
                  <c:v>44.467000000000006</c:v>
                </c:pt>
                <c:pt idx="111" formatCode="0.0">
                  <c:v>39.238</c:v>
                </c:pt>
                <c:pt idx="112" formatCode="0.0">
                  <c:v>35.920499999999997</c:v>
                </c:pt>
                <c:pt idx="113" formatCode="0.0">
                  <c:v>21.4008</c:v>
                </c:pt>
                <c:pt idx="114" formatCode="0.0">
                  <c:v>37.454399999999993</c:v>
                </c:pt>
                <c:pt idx="115" formatCode="0.0">
                  <c:v>44.488599999999998</c:v>
                </c:pt>
                <c:pt idx="116" formatCode="0.0">
                  <c:v>32.904299999999999</c:v>
                </c:pt>
                <c:pt idx="117" formatCode="0.0">
                  <c:v>49.050400000000003</c:v>
                </c:pt>
                <c:pt idx="118" formatCode="0.0">
                  <c:v>42.151399999999995</c:v>
                </c:pt>
                <c:pt idx="119" formatCode="0.0">
                  <c:v>52.479599999999998</c:v>
                </c:pt>
                <c:pt idx="120" formatCode="0.0">
                  <c:v>36.1875</c:v>
                </c:pt>
                <c:pt idx="121" formatCode="0.0">
                  <c:v>46.788500000000006</c:v>
                </c:pt>
                <c:pt idx="122" formatCode="0.0">
                  <c:v>41.5443</c:v>
                </c:pt>
                <c:pt idx="123" formatCode="0.0">
                  <c:v>51.036799999999999</c:v>
                </c:pt>
                <c:pt idx="124" formatCode="0.0">
                  <c:v>48.260399999999997</c:v>
                </c:pt>
                <c:pt idx="125" formatCode="0.0">
                  <c:v>41.722000000000001</c:v>
                </c:pt>
                <c:pt idx="126" formatCode="0.0">
                  <c:v>22.136800000000001</c:v>
                </c:pt>
                <c:pt idx="127" formatCode="0.0">
                  <c:v>32.3232</c:v>
                </c:pt>
                <c:pt idx="128" formatCode="0.0">
                  <c:v>45.8643</c:v>
                </c:pt>
                <c:pt idx="129" formatCode="0.0">
                  <c:v>13.812799999999999</c:v>
                </c:pt>
                <c:pt idx="130" formatCode="0.0">
                  <c:v>38.675000000000004</c:v>
                </c:pt>
                <c:pt idx="131" formatCode="0.0">
                  <c:v>34.279199999999996</c:v>
                </c:pt>
                <c:pt idx="132" formatCode="0.0">
                  <c:v>31.594999999999999</c:v>
                </c:pt>
                <c:pt idx="133" formatCode="0.0">
                  <c:v>22.761000000000003</c:v>
                </c:pt>
                <c:pt idx="134" formatCode="0.0">
                  <c:v>27.241199999999999</c:v>
                </c:pt>
                <c:pt idx="135" formatCode="0.0">
                  <c:v>46.749599999999994</c:v>
                </c:pt>
                <c:pt idx="136" formatCode="0.0">
                  <c:v>31.280100000000001</c:v>
                </c:pt>
                <c:pt idx="137" formatCode="0.0">
                  <c:v>63.467999999999996</c:v>
                </c:pt>
                <c:pt idx="138" formatCode="0.0">
                  <c:v>49.084399999999995</c:v>
                </c:pt>
                <c:pt idx="139" formatCode="0.0">
                  <c:v>41.6798</c:v>
                </c:pt>
                <c:pt idx="140" formatCode="0.0">
                  <c:v>36.592399999999991</c:v>
                </c:pt>
                <c:pt idx="141" formatCode="0.0">
                  <c:v>33.451799999999999</c:v>
                </c:pt>
                <c:pt idx="142" formatCode="0.0">
                  <c:v>39.324000000000005</c:v>
                </c:pt>
                <c:pt idx="143" formatCode="0.0">
                  <c:v>31.275499999999997</c:v>
                </c:pt>
                <c:pt idx="144" formatCode="0.0">
                  <c:v>34.621000000000002</c:v>
                </c:pt>
                <c:pt idx="145" formatCode="0.0">
                  <c:v>45.964800000000011</c:v>
                </c:pt>
                <c:pt idx="146" formatCode="0.0">
                  <c:v>30.512799999999999</c:v>
                </c:pt>
                <c:pt idx="147" formatCode="0.0">
                  <c:v>30</c:v>
                </c:pt>
                <c:pt idx="148" formatCode="0.0">
                  <c:v>58.519200000000005</c:v>
                </c:pt>
                <c:pt idx="149" formatCode="0.0">
                  <c:v>42.776400000000002</c:v>
                </c:pt>
                <c:pt idx="150" formatCode="0.0">
                  <c:v>47.142399999999995</c:v>
                </c:pt>
                <c:pt idx="151" formatCode="0.0">
                  <c:v>21.175000000000001</c:v>
                </c:pt>
                <c:pt idx="152" formatCode="0.0">
                  <c:v>50.430900000000001</c:v>
                </c:pt>
                <c:pt idx="153" formatCode="0.0">
                  <c:v>23.620799999999999</c:v>
                </c:pt>
                <c:pt idx="154" formatCode="0.0">
                  <c:v>39.953700000000005</c:v>
                </c:pt>
                <c:pt idx="155" formatCode="0.0">
                  <c:v>17.537599999999998</c:v>
                </c:pt>
                <c:pt idx="156" formatCode="0.0">
                  <c:v>24.284000000000002</c:v>
                </c:pt>
                <c:pt idx="157" formatCode="0.0">
                  <c:v>47.863199999999999</c:v>
                </c:pt>
                <c:pt idx="158" formatCode="0.0">
                  <c:v>44.362500000000004</c:v>
                </c:pt>
                <c:pt idx="159" formatCode="0.0">
                  <c:v>32.5398</c:v>
                </c:pt>
                <c:pt idx="160" formatCode="0.0">
                  <c:v>45.948400000000007</c:v>
                </c:pt>
                <c:pt idx="161" formatCode="0.0">
                  <c:v>48.260299999999994</c:v>
                </c:pt>
                <c:pt idx="162" formatCode="0.0">
                  <c:v>33.2517</c:v>
                </c:pt>
                <c:pt idx="163" formatCode="0.0">
                  <c:v>38.771600000000007</c:v>
                </c:pt>
                <c:pt idx="164" formatCode="0.0">
                  <c:v>64.980500000000006</c:v>
                </c:pt>
                <c:pt idx="165" formatCode="0.0">
                  <c:v>51.922499999999999</c:v>
                </c:pt>
                <c:pt idx="166" formatCode="0.0">
                  <c:v>44.320700000000002</c:v>
                </c:pt>
                <c:pt idx="167" formatCode="0.0">
                  <c:v>47.117199999999997</c:v>
                </c:pt>
                <c:pt idx="168" formatCode="0.0">
                  <c:v>33.070799999999998</c:v>
                </c:pt>
                <c:pt idx="169" formatCode="0.0">
                  <c:v>37.488</c:v>
                </c:pt>
                <c:pt idx="170" formatCode="0.0">
                  <c:v>45.030299999999997</c:v>
                </c:pt>
                <c:pt idx="171" formatCode="0.0">
                  <c:v>48.8613</c:v>
                </c:pt>
                <c:pt idx="172" formatCode="0.0">
                  <c:v>49.33500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D6B-4550-9762-021BB777E2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7475712"/>
        <c:axId val="107477632"/>
      </c:scatterChart>
      <c:valAx>
        <c:axId val="107475712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>
                    <a:solidFill>
                      <a:schemeClr val="tx1"/>
                    </a:solidFill>
                  </a:rPr>
                  <a:t>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07477632"/>
        <c:crosses val="autoZero"/>
        <c:crossBetween val="midCat"/>
        <c:majorUnit val="20"/>
        <c:minorUnit val="4"/>
      </c:valAx>
      <c:valAx>
        <c:axId val="107477632"/>
        <c:scaling>
          <c:orientation val="minMax"/>
        </c:scaling>
        <c:delete val="0"/>
        <c:axPos val="l"/>
        <c:numFmt formatCode="0.0" sourceLinked="1"/>
        <c:majorTickMark val="in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074757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 i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94791666666666"/>
          <c:y val="2.9545370370370371E-2"/>
          <c:w val="0.75852326388888891"/>
          <c:h val="0.81182222222222233"/>
        </c:manualLayout>
      </c:layout>
      <c:scatterChart>
        <c:scatterStyle val="line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RTE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25400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B$2:$B$609</c:f>
              <c:numCache>
                <c:formatCode>0.0</c:formatCode>
                <c:ptCount val="608"/>
                <c:pt idx="0">
                  <c:v>1.1501999999999999</c:v>
                </c:pt>
                <c:pt idx="1">
                  <c:v>3.0245000000000002</c:v>
                </c:pt>
                <c:pt idx="2">
                  <c:v>1.1867999999999999</c:v>
                </c:pt>
                <c:pt idx="3">
                  <c:v>1.6280000000000001</c:v>
                </c:pt>
                <c:pt idx="4">
                  <c:v>2.8811999999999998</c:v>
                </c:pt>
                <c:pt idx="5">
                  <c:v>2.7136</c:v>
                </c:pt>
                <c:pt idx="6">
                  <c:v>2.1518000000000002</c:v>
                </c:pt>
                <c:pt idx="7">
                  <c:v>2.8136999999999999</c:v>
                </c:pt>
                <c:pt idx="8">
                  <c:v>2.2515000000000001</c:v>
                </c:pt>
                <c:pt idx="9">
                  <c:v>2.0792000000000002</c:v>
                </c:pt>
                <c:pt idx="10">
                  <c:v>3.4644999999999997</c:v>
                </c:pt>
                <c:pt idx="11">
                  <c:v>1.3515000000000001</c:v>
                </c:pt>
                <c:pt idx="12">
                  <c:v>1.1856</c:v>
                </c:pt>
                <c:pt idx="13">
                  <c:v>1.5466000000000002</c:v>
                </c:pt>
                <c:pt idx="14">
                  <c:v>1.1399999999999999</c:v>
                </c:pt>
                <c:pt idx="15">
                  <c:v>2.5055999999999998</c:v>
                </c:pt>
                <c:pt idx="16">
                  <c:v>1.3896000000000002</c:v>
                </c:pt>
                <c:pt idx="17">
                  <c:v>0.86009999999999998</c:v>
                </c:pt>
                <c:pt idx="18">
                  <c:v>1.8998000000000004</c:v>
                </c:pt>
                <c:pt idx="19">
                  <c:v>2.9750000000000001</c:v>
                </c:pt>
                <c:pt idx="20">
                  <c:v>1.3973999999999998</c:v>
                </c:pt>
                <c:pt idx="21">
                  <c:v>3.1065</c:v>
                </c:pt>
                <c:pt idx="22">
                  <c:v>1.3392000000000002</c:v>
                </c:pt>
                <c:pt idx="23">
                  <c:v>2.0609999999999999</c:v>
                </c:pt>
                <c:pt idx="24">
                  <c:v>1.5444000000000002</c:v>
                </c:pt>
                <c:pt idx="25">
                  <c:v>1.4420000000000002</c:v>
                </c:pt>
                <c:pt idx="26">
                  <c:v>0.70550000000000013</c:v>
                </c:pt>
                <c:pt idx="27">
                  <c:v>1.5579999999999998</c:v>
                </c:pt>
                <c:pt idx="28">
                  <c:v>0.54449999999999998</c:v>
                </c:pt>
                <c:pt idx="29">
                  <c:v>1.9422000000000001</c:v>
                </c:pt>
                <c:pt idx="30">
                  <c:v>0.90720000000000001</c:v>
                </c:pt>
                <c:pt idx="31">
                  <c:v>0.96250000000000002</c:v>
                </c:pt>
                <c:pt idx="32">
                  <c:v>1.6563999999999997</c:v>
                </c:pt>
                <c:pt idx="33">
                  <c:v>1.7430000000000001</c:v>
                </c:pt>
                <c:pt idx="34">
                  <c:v>1.1351999999999998</c:v>
                </c:pt>
                <c:pt idx="35">
                  <c:v>2.4758999999999998</c:v>
                </c:pt>
                <c:pt idx="36">
                  <c:v>0.98039999999999994</c:v>
                </c:pt>
                <c:pt idx="37">
                  <c:v>0.55459999999999998</c:v>
                </c:pt>
                <c:pt idx="38">
                  <c:v>0.9345</c:v>
                </c:pt>
                <c:pt idx="39">
                  <c:v>1.0475999999999999</c:v>
                </c:pt>
                <c:pt idx="40">
                  <c:v>0.4672</c:v>
                </c:pt>
                <c:pt idx="41">
                  <c:v>1.4006000000000001</c:v>
                </c:pt>
                <c:pt idx="42">
                  <c:v>1.2036</c:v>
                </c:pt>
                <c:pt idx="43">
                  <c:v>1.5606</c:v>
                </c:pt>
                <c:pt idx="44">
                  <c:v>0.77</c:v>
                </c:pt>
                <c:pt idx="45">
                  <c:v>0.74819999999999987</c:v>
                </c:pt>
                <c:pt idx="46">
                  <c:v>1.2272000000000001</c:v>
                </c:pt>
                <c:pt idx="47">
                  <c:v>2.1843999999999997</c:v>
                </c:pt>
                <c:pt idx="48">
                  <c:v>0.47399999999999998</c:v>
                </c:pt>
                <c:pt idx="49">
                  <c:v>0.77880000000000005</c:v>
                </c:pt>
                <c:pt idx="50">
                  <c:v>0.54610000000000003</c:v>
                </c:pt>
                <c:pt idx="51">
                  <c:v>0.64980000000000004</c:v>
                </c:pt>
                <c:pt idx="52">
                  <c:v>0.35670000000000002</c:v>
                </c:pt>
                <c:pt idx="53">
                  <c:v>0.71500000000000008</c:v>
                </c:pt>
                <c:pt idx="54">
                  <c:v>1.2329999999999999</c:v>
                </c:pt>
                <c:pt idx="55">
                  <c:v>0.81370000000000009</c:v>
                </c:pt>
                <c:pt idx="56">
                  <c:v>1.3286</c:v>
                </c:pt>
                <c:pt idx="57">
                  <c:v>0.96279999999999999</c:v>
                </c:pt>
                <c:pt idx="58">
                  <c:v>0.68159999999999987</c:v>
                </c:pt>
                <c:pt idx="59">
                  <c:v>0.85089999999999999</c:v>
                </c:pt>
                <c:pt idx="60">
                  <c:v>0.17820000000000003</c:v>
                </c:pt>
                <c:pt idx="61">
                  <c:v>1.1211</c:v>
                </c:pt>
                <c:pt idx="62">
                  <c:v>0.27600000000000002</c:v>
                </c:pt>
                <c:pt idx="63">
                  <c:v>0.9</c:v>
                </c:pt>
                <c:pt idx="64">
                  <c:v>0.53</c:v>
                </c:pt>
                <c:pt idx="65">
                  <c:v>0.51</c:v>
                </c:pt>
                <c:pt idx="66">
                  <c:v>0.53459999999999996</c:v>
                </c:pt>
                <c:pt idx="67">
                  <c:v>0.60029999999999994</c:v>
                </c:pt>
                <c:pt idx="68">
                  <c:v>0.30940000000000001</c:v>
                </c:pt>
                <c:pt idx="69">
                  <c:v>0.61020000000000008</c:v>
                </c:pt>
                <c:pt idx="70">
                  <c:v>1.1016000000000001</c:v>
                </c:pt>
                <c:pt idx="71">
                  <c:v>0.432</c:v>
                </c:pt>
                <c:pt idx="72">
                  <c:v>0.98560000000000003</c:v>
                </c:pt>
                <c:pt idx="73">
                  <c:v>0.64499999999999991</c:v>
                </c:pt>
                <c:pt idx="74">
                  <c:v>0.26450000000000001</c:v>
                </c:pt>
                <c:pt idx="75">
                  <c:v>0.60160000000000002</c:v>
                </c:pt>
                <c:pt idx="76">
                  <c:v>0.48399999999999999</c:v>
                </c:pt>
                <c:pt idx="77">
                  <c:v>0.84480000000000011</c:v>
                </c:pt>
                <c:pt idx="78">
                  <c:v>0.2109</c:v>
                </c:pt>
                <c:pt idx="79">
                  <c:v>0.28520000000000001</c:v>
                </c:pt>
                <c:pt idx="80">
                  <c:v>0.14040000000000002</c:v>
                </c:pt>
                <c:pt idx="81">
                  <c:v>0.81840000000000013</c:v>
                </c:pt>
                <c:pt idx="82">
                  <c:v>0.33750000000000002</c:v>
                </c:pt>
                <c:pt idx="83">
                  <c:v>0.54339999999999999</c:v>
                </c:pt>
                <c:pt idx="84">
                  <c:v>0.75460000000000005</c:v>
                </c:pt>
                <c:pt idx="85">
                  <c:v>0.25229999999999997</c:v>
                </c:pt>
                <c:pt idx="86">
                  <c:v>0.34029999999999999</c:v>
                </c:pt>
                <c:pt idx="87">
                  <c:v>0.27600000000000002</c:v>
                </c:pt>
                <c:pt idx="88">
                  <c:v>0.54400000000000004</c:v>
                </c:pt>
                <c:pt idx="89">
                  <c:v>0.21839999999999998</c:v>
                </c:pt>
                <c:pt idx="90">
                  <c:v>0.21</c:v>
                </c:pt>
                <c:pt idx="91">
                  <c:v>0.18359999999999999</c:v>
                </c:pt>
                <c:pt idx="92">
                  <c:v>0.50629999999999997</c:v>
                </c:pt>
                <c:pt idx="93">
                  <c:v>0.6261999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3AE-49F4-98D5-F946B35F76F0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SL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C$2:$C$609</c:f>
              <c:numCache>
                <c:formatCode>General</c:formatCode>
                <c:ptCount val="608"/>
                <c:pt idx="95" formatCode="0.0">
                  <c:v>1.0491999999999999</c:v>
                </c:pt>
                <c:pt idx="96" formatCode="0.0">
                  <c:v>3.0939999999999999</c:v>
                </c:pt>
                <c:pt idx="97" formatCode="0.0">
                  <c:v>1.0925</c:v>
                </c:pt>
                <c:pt idx="98" formatCode="0.0">
                  <c:v>2.4978000000000002</c:v>
                </c:pt>
                <c:pt idx="99" formatCode="0.0">
                  <c:v>1.0211999999999999</c:v>
                </c:pt>
                <c:pt idx="100" formatCode="0.0">
                  <c:v>3.3880000000000003</c:v>
                </c:pt>
                <c:pt idx="101" formatCode="0.0">
                  <c:v>0.80039999999999989</c:v>
                </c:pt>
                <c:pt idx="102" formatCode="0.0">
                  <c:v>1.1222999999999999</c:v>
                </c:pt>
                <c:pt idx="103" formatCode="0.0">
                  <c:v>1.1000000000000001</c:v>
                </c:pt>
                <c:pt idx="104" formatCode="0.0">
                  <c:v>2.8079999999999998</c:v>
                </c:pt>
                <c:pt idx="105" formatCode="0.0">
                  <c:v>2.7384000000000004</c:v>
                </c:pt>
                <c:pt idx="106" formatCode="0.0">
                  <c:v>1.5110999999999999</c:v>
                </c:pt>
                <c:pt idx="107" formatCode="0.0">
                  <c:v>1.0281</c:v>
                </c:pt>
                <c:pt idx="108" formatCode="0.0">
                  <c:v>1.2312000000000001</c:v>
                </c:pt>
                <c:pt idx="109" formatCode="0.0">
                  <c:v>2.0960000000000001</c:v>
                </c:pt>
                <c:pt idx="110" formatCode="0.0">
                  <c:v>1.0720000000000001</c:v>
                </c:pt>
                <c:pt idx="111" formatCode="0.0">
                  <c:v>0.5616000000000001</c:v>
                </c:pt>
                <c:pt idx="112" formatCode="0.0">
                  <c:v>0.29480000000000006</c:v>
                </c:pt>
                <c:pt idx="113" formatCode="0.0">
                  <c:v>2.8637999999999999</c:v>
                </c:pt>
                <c:pt idx="114" formatCode="0.0">
                  <c:v>0.99630000000000007</c:v>
                </c:pt>
                <c:pt idx="115" formatCode="0.0">
                  <c:v>0.84750000000000003</c:v>
                </c:pt>
                <c:pt idx="116" formatCode="0.0">
                  <c:v>0.81199999999999994</c:v>
                </c:pt>
                <c:pt idx="117" formatCode="0.0">
                  <c:v>1.1934</c:v>
                </c:pt>
                <c:pt idx="118" formatCode="0.0">
                  <c:v>0.98209999999999997</c:v>
                </c:pt>
                <c:pt idx="119" formatCode="0.0">
                  <c:v>0.54120000000000001</c:v>
                </c:pt>
                <c:pt idx="120" formatCode="0.0">
                  <c:v>2.08</c:v>
                </c:pt>
                <c:pt idx="121" formatCode="0.0">
                  <c:v>0.91199999999999992</c:v>
                </c:pt>
                <c:pt idx="122" formatCode="0.0">
                  <c:v>0.65800000000000003</c:v>
                </c:pt>
                <c:pt idx="123" formatCode="0.0">
                  <c:v>0.26519999999999999</c:v>
                </c:pt>
                <c:pt idx="124" formatCode="0.0">
                  <c:v>0.86580000000000001</c:v>
                </c:pt>
                <c:pt idx="125" formatCode="0.0">
                  <c:v>1.3206000000000002</c:v>
                </c:pt>
                <c:pt idx="126" formatCode="0.0">
                  <c:v>0.74399999999999999</c:v>
                </c:pt>
                <c:pt idx="127" formatCode="0.0">
                  <c:v>1.1544000000000001</c:v>
                </c:pt>
                <c:pt idx="128" formatCode="0.0">
                  <c:v>0.60719999999999996</c:v>
                </c:pt>
                <c:pt idx="129" formatCode="0.0">
                  <c:v>2.7652000000000001</c:v>
                </c:pt>
                <c:pt idx="130" formatCode="0.0">
                  <c:v>0.58499999999999996</c:v>
                </c:pt>
                <c:pt idx="131" formatCode="0.0">
                  <c:v>0.63270000000000004</c:v>
                </c:pt>
                <c:pt idx="132" formatCode="0.0">
                  <c:v>1.8468000000000004</c:v>
                </c:pt>
                <c:pt idx="133" formatCode="0.0">
                  <c:v>1.6168</c:v>
                </c:pt>
                <c:pt idx="134" formatCode="0.0">
                  <c:v>2.6659999999999999</c:v>
                </c:pt>
                <c:pt idx="135" formatCode="0.0">
                  <c:v>0.54520000000000002</c:v>
                </c:pt>
                <c:pt idx="136" formatCode="0.0">
                  <c:v>0.94869999999999988</c:v>
                </c:pt>
                <c:pt idx="137" formatCode="0.0">
                  <c:v>0.27800000000000002</c:v>
                </c:pt>
                <c:pt idx="138" formatCode="0.0">
                  <c:v>0.59800000000000009</c:v>
                </c:pt>
                <c:pt idx="139" formatCode="0.0">
                  <c:v>0.94709999999999994</c:v>
                </c:pt>
                <c:pt idx="140" formatCode="0.0">
                  <c:v>0.63480000000000003</c:v>
                </c:pt>
                <c:pt idx="141" formatCode="0.0">
                  <c:v>0.65339999999999998</c:v>
                </c:pt>
                <c:pt idx="142" formatCode="0.0">
                  <c:v>0.41280000000000006</c:v>
                </c:pt>
                <c:pt idx="143" formatCode="0.0">
                  <c:v>0.75520000000000009</c:v>
                </c:pt>
                <c:pt idx="144" formatCode="0.0">
                  <c:v>1.0535000000000001</c:v>
                </c:pt>
                <c:pt idx="145" formatCode="0.0">
                  <c:v>0.45900000000000002</c:v>
                </c:pt>
                <c:pt idx="146" formatCode="0.0">
                  <c:v>1.2431999999999999</c:v>
                </c:pt>
                <c:pt idx="147" formatCode="0.0">
                  <c:v>2.6200999999999999</c:v>
                </c:pt>
                <c:pt idx="148" formatCode="0.0">
                  <c:v>0.39199999999999996</c:v>
                </c:pt>
                <c:pt idx="149" formatCode="0.0">
                  <c:v>1.4450000000000001</c:v>
                </c:pt>
                <c:pt idx="150" formatCode="0.0">
                  <c:v>0.35499999999999998</c:v>
                </c:pt>
                <c:pt idx="151" formatCode="0.0">
                  <c:v>0.44640000000000002</c:v>
                </c:pt>
                <c:pt idx="152" formatCode="0.0">
                  <c:v>1.1867999999999999</c:v>
                </c:pt>
                <c:pt idx="153" formatCode="0.0">
                  <c:v>0.24359999999999996</c:v>
                </c:pt>
                <c:pt idx="154" formatCode="0.0">
                  <c:v>0.38689999999999997</c:v>
                </c:pt>
                <c:pt idx="155" formatCode="0.0">
                  <c:v>0.60160000000000002</c:v>
                </c:pt>
                <c:pt idx="156" formatCode="0.0">
                  <c:v>0.85140000000000005</c:v>
                </c:pt>
                <c:pt idx="157" formatCode="0.0">
                  <c:v>0.55500000000000005</c:v>
                </c:pt>
                <c:pt idx="158" formatCode="0.0">
                  <c:v>1.1160000000000001</c:v>
                </c:pt>
                <c:pt idx="159" formatCode="0.0">
                  <c:v>0.84780000000000011</c:v>
                </c:pt>
                <c:pt idx="160" formatCode="0.0">
                  <c:v>1.0865</c:v>
                </c:pt>
                <c:pt idx="161" formatCode="0.0">
                  <c:v>0.80359999999999998</c:v>
                </c:pt>
                <c:pt idx="162" formatCode="0.0">
                  <c:v>1.0009999999999999</c:v>
                </c:pt>
                <c:pt idx="163" formatCode="0.0">
                  <c:v>0.17399999999999999</c:v>
                </c:pt>
                <c:pt idx="164" formatCode="0.0">
                  <c:v>0.42559999999999998</c:v>
                </c:pt>
                <c:pt idx="165" formatCode="0.0">
                  <c:v>0.40739999999999998</c:v>
                </c:pt>
                <c:pt idx="166" formatCode="0.0">
                  <c:v>0.82679999999999998</c:v>
                </c:pt>
                <c:pt idx="167" formatCode="0.0">
                  <c:v>0.36480000000000001</c:v>
                </c:pt>
                <c:pt idx="168" formatCode="0.0">
                  <c:v>1.5065</c:v>
                </c:pt>
                <c:pt idx="169" formatCode="0.0">
                  <c:v>0.4879</c:v>
                </c:pt>
                <c:pt idx="170" formatCode="0.0">
                  <c:v>0.31740000000000002</c:v>
                </c:pt>
                <c:pt idx="171" formatCode="0.0">
                  <c:v>0.24310000000000001</c:v>
                </c:pt>
                <c:pt idx="172" formatCode="0.0">
                  <c:v>0.285599999999999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3AE-49F4-98D5-F946B35F76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369856"/>
        <c:axId val="115372032"/>
      </c:scatterChart>
      <c:valAx>
        <c:axId val="115369856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>
                    <a:solidFill>
                      <a:schemeClr val="tx1"/>
                    </a:solidFill>
                  </a:rPr>
                  <a:t>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5372032"/>
        <c:crosses val="autoZero"/>
        <c:crossBetween val="midCat"/>
        <c:majorUnit val="20"/>
        <c:minorUnit val="4"/>
      </c:valAx>
      <c:valAx>
        <c:axId val="115372032"/>
        <c:scaling>
          <c:orientation val="minMax"/>
          <c:min val="0"/>
        </c:scaling>
        <c:delete val="0"/>
        <c:axPos val="l"/>
        <c:numFmt formatCode="0.0" sourceLinked="1"/>
        <c:majorTickMark val="in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53698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 i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94791666666666"/>
          <c:y val="2.9545370370370371E-2"/>
          <c:w val="0.75852326388888891"/>
          <c:h val="0.8118222222222223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B$2:$B$609</c:f>
              <c:numCache>
                <c:formatCode>0.0</c:formatCode>
                <c:ptCount val="608"/>
                <c:pt idx="0">
                  <c:v>0.39759999999999995</c:v>
                </c:pt>
                <c:pt idx="1">
                  <c:v>1.2075</c:v>
                </c:pt>
                <c:pt idx="2">
                  <c:v>0.77399999999999991</c:v>
                </c:pt>
                <c:pt idx="3">
                  <c:v>0.57720000000000005</c:v>
                </c:pt>
                <c:pt idx="4">
                  <c:v>1.4504000000000001</c:v>
                </c:pt>
                <c:pt idx="5">
                  <c:v>0.39680000000000004</c:v>
                </c:pt>
                <c:pt idx="6">
                  <c:v>1.0282</c:v>
                </c:pt>
                <c:pt idx="7">
                  <c:v>0.39550000000000002</c:v>
                </c:pt>
                <c:pt idx="8">
                  <c:v>0.49400000000000005</c:v>
                </c:pt>
                <c:pt idx="9">
                  <c:v>0.50600000000000001</c:v>
                </c:pt>
                <c:pt idx="10">
                  <c:v>1.7237999999999998</c:v>
                </c:pt>
                <c:pt idx="11">
                  <c:v>0.85850000000000004</c:v>
                </c:pt>
                <c:pt idx="12">
                  <c:v>0.36660000000000004</c:v>
                </c:pt>
                <c:pt idx="13">
                  <c:v>0.74740000000000006</c:v>
                </c:pt>
                <c:pt idx="14">
                  <c:v>0.79199999999999993</c:v>
                </c:pt>
                <c:pt idx="15">
                  <c:v>0.6379999999999999</c:v>
                </c:pt>
                <c:pt idx="16">
                  <c:v>0.60480000000000012</c:v>
                </c:pt>
                <c:pt idx="17">
                  <c:v>0.34159999999999996</c:v>
                </c:pt>
                <c:pt idx="18">
                  <c:v>0.54279999999999995</c:v>
                </c:pt>
                <c:pt idx="19">
                  <c:v>0.58750000000000002</c:v>
                </c:pt>
                <c:pt idx="20">
                  <c:v>0.33659999999999995</c:v>
                </c:pt>
                <c:pt idx="21">
                  <c:v>0.47960000000000003</c:v>
                </c:pt>
                <c:pt idx="22">
                  <c:v>0.61380000000000001</c:v>
                </c:pt>
                <c:pt idx="23">
                  <c:v>0.78299999999999992</c:v>
                </c:pt>
                <c:pt idx="24">
                  <c:v>1.026</c:v>
                </c:pt>
                <c:pt idx="25">
                  <c:v>0.75600000000000012</c:v>
                </c:pt>
                <c:pt idx="26">
                  <c:v>1.1475000000000002</c:v>
                </c:pt>
                <c:pt idx="27">
                  <c:v>0.43459999999999993</c:v>
                </c:pt>
                <c:pt idx="28">
                  <c:v>0.63800000000000001</c:v>
                </c:pt>
                <c:pt idx="29">
                  <c:v>1.6379999999999999</c:v>
                </c:pt>
                <c:pt idx="30">
                  <c:v>0.3906</c:v>
                </c:pt>
                <c:pt idx="31">
                  <c:v>1.65</c:v>
                </c:pt>
                <c:pt idx="32">
                  <c:v>0.83830000000000005</c:v>
                </c:pt>
                <c:pt idx="33">
                  <c:v>0.94499999999999995</c:v>
                </c:pt>
                <c:pt idx="34">
                  <c:v>0.24939999999999998</c:v>
                </c:pt>
                <c:pt idx="35">
                  <c:v>1.3362000000000001</c:v>
                </c:pt>
                <c:pt idx="36">
                  <c:v>0.73959999999999992</c:v>
                </c:pt>
                <c:pt idx="37">
                  <c:v>0.55459999999999998</c:v>
                </c:pt>
                <c:pt idx="38">
                  <c:v>0.2205</c:v>
                </c:pt>
                <c:pt idx="39">
                  <c:v>0.83419999999999983</c:v>
                </c:pt>
                <c:pt idx="40">
                  <c:v>0.80299999999999994</c:v>
                </c:pt>
                <c:pt idx="41">
                  <c:v>0.89300000000000002</c:v>
                </c:pt>
                <c:pt idx="42">
                  <c:v>0.74340000000000006</c:v>
                </c:pt>
                <c:pt idx="43">
                  <c:v>0.69359999999999988</c:v>
                </c:pt>
                <c:pt idx="44">
                  <c:v>1.2950000000000002</c:v>
                </c:pt>
                <c:pt idx="45">
                  <c:v>0.80840000000000001</c:v>
                </c:pt>
                <c:pt idx="46">
                  <c:v>0.41300000000000003</c:v>
                </c:pt>
                <c:pt idx="47">
                  <c:v>1.5136000000000001</c:v>
                </c:pt>
                <c:pt idx="48">
                  <c:v>0.37919999999999998</c:v>
                </c:pt>
                <c:pt idx="49">
                  <c:v>0.9174000000000001</c:v>
                </c:pt>
                <c:pt idx="50">
                  <c:v>0.29209999999999997</c:v>
                </c:pt>
                <c:pt idx="51">
                  <c:v>1.1628000000000001</c:v>
                </c:pt>
                <c:pt idx="52">
                  <c:v>0.95940000000000003</c:v>
                </c:pt>
                <c:pt idx="53">
                  <c:v>0.312</c:v>
                </c:pt>
                <c:pt idx="54">
                  <c:v>0.747</c:v>
                </c:pt>
                <c:pt idx="55">
                  <c:v>0.67980000000000007</c:v>
                </c:pt>
                <c:pt idx="56">
                  <c:v>0.71889999999999998</c:v>
                </c:pt>
                <c:pt idx="57">
                  <c:v>0.51039999999999996</c:v>
                </c:pt>
                <c:pt idx="58">
                  <c:v>1.7039999999999997</c:v>
                </c:pt>
                <c:pt idx="59">
                  <c:v>1.1811</c:v>
                </c:pt>
                <c:pt idx="60">
                  <c:v>0.32340000000000002</c:v>
                </c:pt>
                <c:pt idx="61">
                  <c:v>1.0655999999999999</c:v>
                </c:pt>
                <c:pt idx="62">
                  <c:v>0.91770000000000007</c:v>
                </c:pt>
                <c:pt idx="63">
                  <c:v>1.3</c:v>
                </c:pt>
                <c:pt idx="64">
                  <c:v>0.5</c:v>
                </c:pt>
                <c:pt idx="65">
                  <c:v>0.39</c:v>
                </c:pt>
                <c:pt idx="66">
                  <c:v>0.61560000000000004</c:v>
                </c:pt>
                <c:pt idx="67">
                  <c:v>1.7661</c:v>
                </c:pt>
                <c:pt idx="68">
                  <c:v>0.53550000000000009</c:v>
                </c:pt>
                <c:pt idx="69">
                  <c:v>0.8701000000000001</c:v>
                </c:pt>
                <c:pt idx="70">
                  <c:v>0.7128000000000001</c:v>
                </c:pt>
                <c:pt idx="71">
                  <c:v>0.44999999999999996</c:v>
                </c:pt>
                <c:pt idx="72">
                  <c:v>0.85470000000000002</c:v>
                </c:pt>
                <c:pt idx="73">
                  <c:v>0.43859999999999993</c:v>
                </c:pt>
                <c:pt idx="74">
                  <c:v>0.437</c:v>
                </c:pt>
                <c:pt idx="75">
                  <c:v>1.4006000000000001</c:v>
                </c:pt>
                <c:pt idx="76">
                  <c:v>1.2584</c:v>
                </c:pt>
                <c:pt idx="77">
                  <c:v>0.42240000000000005</c:v>
                </c:pt>
                <c:pt idx="78">
                  <c:v>0.33300000000000002</c:v>
                </c:pt>
                <c:pt idx="79">
                  <c:v>2.2080000000000002</c:v>
                </c:pt>
                <c:pt idx="80">
                  <c:v>0.82080000000000009</c:v>
                </c:pt>
                <c:pt idx="81">
                  <c:v>0.75330000000000008</c:v>
                </c:pt>
                <c:pt idx="82">
                  <c:v>1.6335</c:v>
                </c:pt>
                <c:pt idx="83">
                  <c:v>0.62920000000000009</c:v>
                </c:pt>
                <c:pt idx="84">
                  <c:v>0.43120000000000003</c:v>
                </c:pt>
                <c:pt idx="85">
                  <c:v>0.87869999999999993</c:v>
                </c:pt>
                <c:pt idx="86">
                  <c:v>0.63080000000000003</c:v>
                </c:pt>
                <c:pt idx="87">
                  <c:v>0.52439999999999998</c:v>
                </c:pt>
                <c:pt idx="88">
                  <c:v>0.312</c:v>
                </c:pt>
                <c:pt idx="89">
                  <c:v>0.3276</c:v>
                </c:pt>
                <c:pt idx="90">
                  <c:v>0.38850000000000001</c:v>
                </c:pt>
                <c:pt idx="91">
                  <c:v>0.29579999999999995</c:v>
                </c:pt>
                <c:pt idx="92">
                  <c:v>0.32369999999999999</c:v>
                </c:pt>
                <c:pt idx="93">
                  <c:v>1.9391999999999998</c:v>
                </c:pt>
              </c:numCache>
            </c:numRef>
          </c:y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>
                      <c:ext uri="{02D57815-91ED-43cb-92C2-25804820EDAC}">
                        <c15:formulaRef>
                          <c15:sqref>Tabelle1!$B$1</c15:sqref>
                        </c15:formulaRef>
                      </c:ext>
                    </c:extLst>
                    <c:strCache>
                      <c:ptCount val="1"/>
                      <c:pt idx="0">
                        <c:v>CD31+Mem</c:v>
                      </c:pt>
                    </c:strCache>
                  </c:strRef>
                </c15:tx>
              </c15:filteredSeriesTitle>
            </c:ext>
            <c:ext xmlns:c16="http://schemas.microsoft.com/office/drawing/2014/chart" uri="{C3380CC4-5D6E-409C-BE32-E72D297353CC}">
              <c16:uniqueId val="{00000001-23A7-40B2-9119-427F25152A0F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C$2:$C$609</c:f>
              <c:numCache>
                <c:formatCode>General</c:formatCode>
                <c:ptCount val="608"/>
                <c:pt idx="95" formatCode="0.0">
                  <c:v>0.44719999999999999</c:v>
                </c:pt>
                <c:pt idx="96" formatCode="0.0">
                  <c:v>0.52779999999999994</c:v>
                </c:pt>
                <c:pt idx="97" formatCode="0.0">
                  <c:v>0.96899999999999997</c:v>
                </c:pt>
                <c:pt idx="98" formatCode="0.0">
                  <c:v>0.88690000000000013</c:v>
                </c:pt>
                <c:pt idx="99" formatCode="0.0">
                  <c:v>1.0655999999999999</c:v>
                </c:pt>
                <c:pt idx="100" formatCode="0.0">
                  <c:v>0.75600000000000012</c:v>
                </c:pt>
                <c:pt idx="101" formatCode="0.0">
                  <c:v>1.0856000000000001</c:v>
                </c:pt>
                <c:pt idx="102" formatCode="0.0">
                  <c:v>0.54180000000000006</c:v>
                </c:pt>
                <c:pt idx="103" formatCode="0.0">
                  <c:v>0.95040000000000013</c:v>
                </c:pt>
                <c:pt idx="104" formatCode="0.0">
                  <c:v>0.85409999999999997</c:v>
                </c:pt>
                <c:pt idx="105" formatCode="0.0">
                  <c:v>1.2225000000000001</c:v>
                </c:pt>
                <c:pt idx="106" formatCode="0.0">
                  <c:v>2.6909999999999998</c:v>
                </c:pt>
                <c:pt idx="107" formatCode="0.0">
                  <c:v>1.1473</c:v>
                </c:pt>
                <c:pt idx="108" formatCode="0.0">
                  <c:v>1.8468000000000004</c:v>
                </c:pt>
                <c:pt idx="109" formatCode="0.0">
                  <c:v>0.54400000000000004</c:v>
                </c:pt>
                <c:pt idx="110" formatCode="0.0">
                  <c:v>1.44</c:v>
                </c:pt>
                <c:pt idx="111" formatCode="0.0">
                  <c:v>1.0944</c:v>
                </c:pt>
                <c:pt idx="112" formatCode="0.0">
                  <c:v>0.4355</c:v>
                </c:pt>
                <c:pt idx="113" formatCode="0.0">
                  <c:v>0.9101999999999999</c:v>
                </c:pt>
                <c:pt idx="114" formatCode="0.0">
                  <c:v>0.83430000000000004</c:v>
                </c:pt>
                <c:pt idx="115" formatCode="0.0">
                  <c:v>0.77250000000000008</c:v>
                </c:pt>
                <c:pt idx="116" formatCode="0.0">
                  <c:v>1.4151999999999998</c:v>
                </c:pt>
                <c:pt idx="117" formatCode="0.0">
                  <c:v>0.60060000000000002</c:v>
                </c:pt>
                <c:pt idx="118" formatCode="0.0">
                  <c:v>1.6905000000000001</c:v>
                </c:pt>
                <c:pt idx="119" formatCode="0.0">
                  <c:v>2.0460000000000003</c:v>
                </c:pt>
                <c:pt idx="120" formatCode="0.0">
                  <c:v>3.9104000000000005</c:v>
                </c:pt>
                <c:pt idx="121" formatCode="0.0">
                  <c:v>0.68400000000000005</c:v>
                </c:pt>
                <c:pt idx="122" formatCode="0.0">
                  <c:v>0.82720000000000005</c:v>
                </c:pt>
                <c:pt idx="123" formatCode="0.0">
                  <c:v>0.90609999999999991</c:v>
                </c:pt>
                <c:pt idx="124" formatCode="0.0">
                  <c:v>0.60060000000000002</c:v>
                </c:pt>
                <c:pt idx="125" formatCode="0.0">
                  <c:v>0.78120000000000012</c:v>
                </c:pt>
                <c:pt idx="126" formatCode="0.0">
                  <c:v>0.33599999999999997</c:v>
                </c:pt>
                <c:pt idx="127" formatCode="0.0">
                  <c:v>0.2109</c:v>
                </c:pt>
                <c:pt idx="128" formatCode="0.0">
                  <c:v>1.452</c:v>
                </c:pt>
                <c:pt idx="129" formatCode="0.0">
                  <c:v>1.115</c:v>
                </c:pt>
                <c:pt idx="130" formatCode="0.0">
                  <c:v>0.67499999999999993</c:v>
                </c:pt>
                <c:pt idx="131" formatCode="0.0">
                  <c:v>0.99180000000000001</c:v>
                </c:pt>
                <c:pt idx="132" formatCode="0.0">
                  <c:v>0.3024</c:v>
                </c:pt>
                <c:pt idx="133" formatCode="0.0">
                  <c:v>0.58279999999999998</c:v>
                </c:pt>
                <c:pt idx="134" formatCode="0.0">
                  <c:v>0.87719999999999987</c:v>
                </c:pt>
                <c:pt idx="135" formatCode="0.0">
                  <c:v>0.56400000000000006</c:v>
                </c:pt>
                <c:pt idx="136" formatCode="0.0">
                  <c:v>0.53699999999999992</c:v>
                </c:pt>
                <c:pt idx="137" formatCode="0.0">
                  <c:v>0.72280000000000011</c:v>
                </c:pt>
                <c:pt idx="138" formatCode="0.0">
                  <c:v>0.79350000000000009</c:v>
                </c:pt>
                <c:pt idx="139" formatCode="0.0">
                  <c:v>1.0857000000000001</c:v>
                </c:pt>
                <c:pt idx="140" formatCode="0.0">
                  <c:v>0.63480000000000003</c:v>
                </c:pt>
                <c:pt idx="141" formatCode="0.0">
                  <c:v>0.59289999999999998</c:v>
                </c:pt>
                <c:pt idx="142" formatCode="0.0">
                  <c:v>0.89010000000000011</c:v>
                </c:pt>
                <c:pt idx="143" formatCode="0.0">
                  <c:v>0.6372000000000001</c:v>
                </c:pt>
                <c:pt idx="144" formatCode="0.0">
                  <c:v>1.204</c:v>
                </c:pt>
                <c:pt idx="145" formatCode="0.0">
                  <c:v>0.82350000000000001</c:v>
                </c:pt>
                <c:pt idx="146" formatCode="0.0">
                  <c:v>1.008</c:v>
                </c:pt>
                <c:pt idx="147" formatCode="0.0">
                  <c:v>1.6351</c:v>
                </c:pt>
                <c:pt idx="148" formatCode="0.0">
                  <c:v>2.3743999999999996</c:v>
                </c:pt>
                <c:pt idx="149" formatCode="0.0">
                  <c:v>1.2750000000000001</c:v>
                </c:pt>
                <c:pt idx="150" formatCode="0.0">
                  <c:v>0.14199999999999999</c:v>
                </c:pt>
                <c:pt idx="151" formatCode="0.0">
                  <c:v>1.0292000000000001</c:v>
                </c:pt>
                <c:pt idx="152" formatCode="0.0">
                  <c:v>1.3545</c:v>
                </c:pt>
                <c:pt idx="153" formatCode="0.0">
                  <c:v>0.47849999999999998</c:v>
                </c:pt>
                <c:pt idx="154" formatCode="0.0">
                  <c:v>0.86869999999999992</c:v>
                </c:pt>
                <c:pt idx="155" formatCode="0.0">
                  <c:v>0.3196</c:v>
                </c:pt>
                <c:pt idx="156" formatCode="0.0">
                  <c:v>0.38280000000000003</c:v>
                </c:pt>
                <c:pt idx="157" formatCode="0.0">
                  <c:v>1.2987</c:v>
                </c:pt>
                <c:pt idx="158" formatCode="0.0">
                  <c:v>1.1779999999999999</c:v>
                </c:pt>
                <c:pt idx="159" formatCode="0.0">
                  <c:v>1.3031000000000001</c:v>
                </c:pt>
                <c:pt idx="160" formatCode="0.0">
                  <c:v>1.6430000000000002</c:v>
                </c:pt>
                <c:pt idx="161" formatCode="0.0">
                  <c:v>1.6464000000000001</c:v>
                </c:pt>
                <c:pt idx="162" formatCode="0.0">
                  <c:v>0.85540000000000005</c:v>
                </c:pt>
                <c:pt idx="163" formatCode="0.0">
                  <c:v>0.754</c:v>
                </c:pt>
                <c:pt idx="164" formatCode="0.0">
                  <c:v>0.83599999999999997</c:v>
                </c:pt>
                <c:pt idx="165" formatCode="0.0">
                  <c:v>0.43649999999999994</c:v>
                </c:pt>
                <c:pt idx="166" formatCode="0.0">
                  <c:v>0.95159999999999989</c:v>
                </c:pt>
                <c:pt idx="167" formatCode="0.0">
                  <c:v>0.51300000000000001</c:v>
                </c:pt>
                <c:pt idx="168" formatCode="0.0">
                  <c:v>0.83840000000000003</c:v>
                </c:pt>
                <c:pt idx="169" formatCode="0.0">
                  <c:v>1.7136000000000002</c:v>
                </c:pt>
                <c:pt idx="170" formatCode="0.0">
                  <c:v>0.92460000000000009</c:v>
                </c:pt>
                <c:pt idx="171" formatCode="0.0">
                  <c:v>0.95369999999999988</c:v>
                </c:pt>
                <c:pt idx="172" formatCode="0.0">
                  <c:v>0.52019999999999988</c:v>
                </c:pt>
              </c:numCache>
            </c:numRef>
          </c:y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>
                      <c:ext uri="{02D57815-91ED-43cb-92C2-25804820EDAC}">
                        <c15:formulaRef>
                          <c15:sqref>Tabelle1!$C$1</c15:sqref>
                        </c15:formulaRef>
                      </c:ext>
                    </c:extLst>
                    <c:strCache>
                      <c:ptCount val="1"/>
                      <c:pt idx="0">
                        <c:v>Spalte1</c:v>
                      </c:pt>
                    </c:strCache>
                  </c:strRef>
                </c15:tx>
              </c15:filteredSeriesTitle>
            </c:ext>
            <c:ext xmlns:c16="http://schemas.microsoft.com/office/drawing/2014/chart" uri="{C3380CC4-5D6E-409C-BE32-E72D297353CC}">
              <c16:uniqueId val="{00000003-23A7-40B2-9119-427F25152A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420160"/>
        <c:axId val="115459200"/>
      </c:scatterChart>
      <c:valAx>
        <c:axId val="115420160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>
                    <a:solidFill>
                      <a:schemeClr val="tx1"/>
                    </a:solidFill>
                  </a:rPr>
                  <a:t>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5459200"/>
        <c:crosses val="autoZero"/>
        <c:crossBetween val="midCat"/>
        <c:majorUnit val="20"/>
        <c:minorUnit val="4"/>
      </c:valAx>
      <c:valAx>
        <c:axId val="115459200"/>
        <c:scaling>
          <c:orientation val="minMax"/>
        </c:scaling>
        <c:delete val="0"/>
        <c:axPos val="l"/>
        <c:numFmt formatCode="0.0" sourceLinked="1"/>
        <c:majorTickMark val="in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54201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 i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94791666666666"/>
          <c:y val="2.9545370370370371E-2"/>
          <c:w val="0.75852326388888891"/>
          <c:h val="0.81182222222222233"/>
        </c:manualLayout>
      </c:layout>
      <c:scatterChart>
        <c:scatterStyle val="line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RTE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25400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B$2:$B$609</c:f>
              <c:numCache>
                <c:formatCode>0.0</c:formatCode>
                <c:ptCount val="608"/>
                <c:pt idx="0">
                  <c:v>41.4816</c:v>
                </c:pt>
                <c:pt idx="1">
                  <c:v>34.790199999999999</c:v>
                </c:pt>
                <c:pt idx="2">
                  <c:v>41.038600000000002</c:v>
                </c:pt>
                <c:pt idx="3">
                  <c:v>43.934799999999996</c:v>
                </c:pt>
                <c:pt idx="4">
                  <c:v>53.730000000000004</c:v>
                </c:pt>
                <c:pt idx="5">
                  <c:v>35.629000000000005</c:v>
                </c:pt>
                <c:pt idx="6">
                  <c:v>43.756999999999998</c:v>
                </c:pt>
                <c:pt idx="7">
                  <c:v>34.515000000000001</c:v>
                </c:pt>
                <c:pt idx="8">
                  <c:v>34.984800000000007</c:v>
                </c:pt>
                <c:pt idx="9">
                  <c:v>35.100900000000003</c:v>
                </c:pt>
                <c:pt idx="10">
                  <c:v>20.1204</c:v>
                </c:pt>
                <c:pt idx="11">
                  <c:v>32.756999999999998</c:v>
                </c:pt>
                <c:pt idx="12">
                  <c:v>34.1691</c:v>
                </c:pt>
                <c:pt idx="13">
                  <c:v>46.62</c:v>
                </c:pt>
                <c:pt idx="14">
                  <c:v>35.951099999999997</c:v>
                </c:pt>
                <c:pt idx="15">
                  <c:v>33.125599999999999</c:v>
                </c:pt>
                <c:pt idx="16">
                  <c:v>40.973400000000005</c:v>
                </c:pt>
                <c:pt idx="17">
                  <c:v>26.928000000000001</c:v>
                </c:pt>
                <c:pt idx="18">
                  <c:v>26.0184</c:v>
                </c:pt>
                <c:pt idx="19">
                  <c:v>38.498200000000004</c:v>
                </c:pt>
                <c:pt idx="20">
                  <c:v>25.711400000000001</c:v>
                </c:pt>
                <c:pt idx="21">
                  <c:v>39.827199999999998</c:v>
                </c:pt>
                <c:pt idx="22">
                  <c:v>36.330599999999997</c:v>
                </c:pt>
                <c:pt idx="23">
                  <c:v>43.450200000000002</c:v>
                </c:pt>
                <c:pt idx="24">
                  <c:v>22.8096</c:v>
                </c:pt>
                <c:pt idx="25">
                  <c:v>21.757999999999999</c:v>
                </c:pt>
                <c:pt idx="26">
                  <c:v>19.8338</c:v>
                </c:pt>
                <c:pt idx="27">
                  <c:v>31.235599999999998</c:v>
                </c:pt>
                <c:pt idx="28">
                  <c:v>37.705499999999994</c:v>
                </c:pt>
                <c:pt idx="29">
                  <c:v>34.966799999999999</c:v>
                </c:pt>
                <c:pt idx="30">
                  <c:v>17.1981</c:v>
                </c:pt>
                <c:pt idx="31">
                  <c:v>27.187000000000001</c:v>
                </c:pt>
                <c:pt idx="32">
                  <c:v>21.462199999999999</c:v>
                </c:pt>
                <c:pt idx="33">
                  <c:v>21.424900000000001</c:v>
                </c:pt>
                <c:pt idx="34">
                  <c:v>25.080000000000002</c:v>
                </c:pt>
                <c:pt idx="35">
                  <c:v>37.713999999999999</c:v>
                </c:pt>
                <c:pt idx="36">
                  <c:v>35.241799999999998</c:v>
                </c:pt>
                <c:pt idx="37">
                  <c:v>15.915099999999999</c:v>
                </c:pt>
                <c:pt idx="38">
                  <c:v>32.988599999999998</c:v>
                </c:pt>
                <c:pt idx="39">
                  <c:v>23.903000000000002</c:v>
                </c:pt>
                <c:pt idx="40">
                  <c:v>28.336099999999998</c:v>
                </c:pt>
                <c:pt idx="41">
                  <c:v>25.470000000000002</c:v>
                </c:pt>
                <c:pt idx="42">
                  <c:v>22.188100000000002</c:v>
                </c:pt>
                <c:pt idx="43">
                  <c:v>32.381700000000002</c:v>
                </c:pt>
                <c:pt idx="44">
                  <c:v>40.597300000000004</c:v>
                </c:pt>
                <c:pt idx="45">
                  <c:v>16.780799999999999</c:v>
                </c:pt>
                <c:pt idx="46">
                  <c:v>22.6266</c:v>
                </c:pt>
                <c:pt idx="47">
                  <c:v>29.110400000000006</c:v>
                </c:pt>
                <c:pt idx="48">
                  <c:v>9.9360000000000017</c:v>
                </c:pt>
                <c:pt idx="49">
                  <c:v>25.723200000000002</c:v>
                </c:pt>
                <c:pt idx="50">
                  <c:v>13.459600000000002</c:v>
                </c:pt>
                <c:pt idx="51">
                  <c:v>22.921499999999998</c:v>
                </c:pt>
                <c:pt idx="52">
                  <c:v>9.2644000000000002</c:v>
                </c:pt>
                <c:pt idx="53">
                  <c:v>27.0215</c:v>
                </c:pt>
                <c:pt idx="54">
                  <c:v>48.631500000000003</c:v>
                </c:pt>
                <c:pt idx="55">
                  <c:v>15.4284</c:v>
                </c:pt>
                <c:pt idx="56">
                  <c:v>35.593600000000002</c:v>
                </c:pt>
                <c:pt idx="57">
                  <c:v>19.161100000000001</c:v>
                </c:pt>
                <c:pt idx="58">
                  <c:v>12.8954</c:v>
                </c:pt>
                <c:pt idx="59">
                  <c:v>15.049999999999999</c:v>
                </c:pt>
                <c:pt idx="60">
                  <c:v>10.554200000000002</c:v>
                </c:pt>
                <c:pt idx="61">
                  <c:v>27.883199999999999</c:v>
                </c:pt>
                <c:pt idx="62">
                  <c:v>15.624000000000002</c:v>
                </c:pt>
                <c:pt idx="63">
                  <c:v>23.772800000000004</c:v>
                </c:pt>
                <c:pt idx="64">
                  <c:v>21.665900000000001</c:v>
                </c:pt>
                <c:pt idx="65">
                  <c:v>25.779599999999999</c:v>
                </c:pt>
                <c:pt idx="66">
                  <c:v>17.552900000000001</c:v>
                </c:pt>
                <c:pt idx="67">
                  <c:v>20.293000000000003</c:v>
                </c:pt>
                <c:pt idx="68">
                  <c:v>4.7573999999999996</c:v>
                </c:pt>
                <c:pt idx="69">
                  <c:v>11.531000000000001</c:v>
                </c:pt>
                <c:pt idx="70">
                  <c:v>28.990000000000002</c:v>
                </c:pt>
                <c:pt idx="71">
                  <c:v>17.5244</c:v>
                </c:pt>
                <c:pt idx="72">
                  <c:v>34.981699999999996</c:v>
                </c:pt>
                <c:pt idx="73">
                  <c:v>29.489899999999995</c:v>
                </c:pt>
                <c:pt idx="74">
                  <c:v>9.1052</c:v>
                </c:pt>
                <c:pt idx="75">
                  <c:v>29.2896</c:v>
                </c:pt>
                <c:pt idx="76">
                  <c:v>15.277199999999999</c:v>
                </c:pt>
                <c:pt idx="77">
                  <c:v>42.731399999999994</c:v>
                </c:pt>
                <c:pt idx="78">
                  <c:v>11.8858</c:v>
                </c:pt>
                <c:pt idx="79">
                  <c:v>7.6188000000000002</c:v>
                </c:pt>
                <c:pt idx="80">
                  <c:v>8.1172000000000004</c:v>
                </c:pt>
                <c:pt idx="81">
                  <c:v>20.384999999999998</c:v>
                </c:pt>
                <c:pt idx="82">
                  <c:v>3.9559999999999995</c:v>
                </c:pt>
                <c:pt idx="83">
                  <c:v>14.894399999999999</c:v>
                </c:pt>
                <c:pt idx="84">
                  <c:v>13.23</c:v>
                </c:pt>
                <c:pt idx="85">
                  <c:v>16.525300000000001</c:v>
                </c:pt>
                <c:pt idx="86">
                  <c:v>10.087</c:v>
                </c:pt>
                <c:pt idx="87">
                  <c:v>5.5167999999999999</c:v>
                </c:pt>
                <c:pt idx="88">
                  <c:v>17.241399999999999</c:v>
                </c:pt>
                <c:pt idx="89">
                  <c:v>6.1707000000000001</c:v>
                </c:pt>
                <c:pt idx="90">
                  <c:v>8.234</c:v>
                </c:pt>
                <c:pt idx="91">
                  <c:v>5.5676000000000005</c:v>
                </c:pt>
                <c:pt idx="92">
                  <c:v>27.021999999999998</c:v>
                </c:pt>
                <c:pt idx="93">
                  <c:v>9.416399999999999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D25-4717-AEC9-8D3082AA75D6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Spalte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C$2:$C$609</c:f>
              <c:numCache>
                <c:formatCode>General</c:formatCode>
                <c:ptCount val="608"/>
                <c:pt idx="95" formatCode="0.0">
                  <c:v>51.219299999999997</c:v>
                </c:pt>
                <c:pt idx="96" formatCode="0.0">
                  <c:v>33.742800000000003</c:v>
                </c:pt>
                <c:pt idx="97" formatCode="0.0">
                  <c:v>33.6126</c:v>
                </c:pt>
                <c:pt idx="98" formatCode="0.0">
                  <c:v>42.669900000000005</c:v>
                </c:pt>
                <c:pt idx="99" formatCode="0.0">
                  <c:v>20.867999999999999</c:v>
                </c:pt>
                <c:pt idx="100" formatCode="0.0">
                  <c:v>59.167999999999999</c:v>
                </c:pt>
                <c:pt idx="101" formatCode="0.0">
                  <c:v>21.973599999999998</c:v>
                </c:pt>
                <c:pt idx="102" formatCode="0.0">
                  <c:v>31.922799999999999</c:v>
                </c:pt>
                <c:pt idx="103" formatCode="0.0">
                  <c:v>30.187200000000001</c:v>
                </c:pt>
                <c:pt idx="104" formatCode="0.0">
                  <c:v>39.9116</c:v>
                </c:pt>
                <c:pt idx="105" formatCode="0.0">
                  <c:v>25.163599999999999</c:v>
                </c:pt>
                <c:pt idx="106" formatCode="0.0">
                  <c:v>15.127200000000002</c:v>
                </c:pt>
                <c:pt idx="107" formatCode="0.0">
                  <c:v>28.492799999999999</c:v>
                </c:pt>
                <c:pt idx="108" formatCode="0.0">
                  <c:v>27.353699999999996</c:v>
                </c:pt>
                <c:pt idx="109" formatCode="0.0">
                  <c:v>36.851900000000001</c:v>
                </c:pt>
                <c:pt idx="110" formatCode="0.0">
                  <c:v>13.843500000000001</c:v>
                </c:pt>
                <c:pt idx="111" formatCode="0.0">
                  <c:v>20.983800000000002</c:v>
                </c:pt>
                <c:pt idx="112" formatCode="0.0">
                  <c:v>37.4133</c:v>
                </c:pt>
                <c:pt idx="113" formatCode="0.0">
                  <c:v>46.531199999999998</c:v>
                </c:pt>
                <c:pt idx="114" formatCode="0.0">
                  <c:v>36.536399999999993</c:v>
                </c:pt>
                <c:pt idx="115" formatCode="0.0">
                  <c:v>28.520699999999998</c:v>
                </c:pt>
                <c:pt idx="116" formatCode="0.0">
                  <c:v>21.6294</c:v>
                </c:pt>
                <c:pt idx="117" formatCode="0.0">
                  <c:v>29.135200000000001</c:v>
                </c:pt>
                <c:pt idx="118" formatCode="0.0">
                  <c:v>27.151199999999999</c:v>
                </c:pt>
                <c:pt idx="119" formatCode="0.0">
                  <c:v>13.942600000000001</c:v>
                </c:pt>
                <c:pt idx="120" formatCode="0.0">
                  <c:v>11.1168</c:v>
                </c:pt>
                <c:pt idx="121" formatCode="0.0">
                  <c:v>24.797000000000001</c:v>
                </c:pt>
                <c:pt idx="122" formatCode="0.0">
                  <c:v>24.877800000000001</c:v>
                </c:pt>
                <c:pt idx="123" formatCode="0.0">
                  <c:v>17.193800000000003</c:v>
                </c:pt>
                <c:pt idx="124" formatCode="0.0">
                  <c:v>20.998799999999999</c:v>
                </c:pt>
                <c:pt idx="125" formatCode="0.0">
                  <c:v>24.942500000000003</c:v>
                </c:pt>
                <c:pt idx="126" formatCode="0.0">
                  <c:v>33.580399999999997</c:v>
                </c:pt>
                <c:pt idx="127" formatCode="0.0">
                  <c:v>38.805600000000005</c:v>
                </c:pt>
                <c:pt idx="128" formatCode="0.0">
                  <c:v>18.900600000000001</c:v>
                </c:pt>
                <c:pt idx="129" formatCode="0.0">
                  <c:v>40.895199999999996</c:v>
                </c:pt>
                <c:pt idx="130" formatCode="0.0">
                  <c:v>34.216000000000001</c:v>
                </c:pt>
                <c:pt idx="131" formatCode="0.0">
                  <c:v>28.317600000000002</c:v>
                </c:pt>
                <c:pt idx="132" formatCode="0.0">
                  <c:v>32.04</c:v>
                </c:pt>
                <c:pt idx="133" formatCode="0.0">
                  <c:v>34.182000000000002</c:v>
                </c:pt>
                <c:pt idx="134" formatCode="0.0">
                  <c:v>35.107199999999999</c:v>
                </c:pt>
                <c:pt idx="135" formatCode="0.0">
                  <c:v>20.747399999999995</c:v>
                </c:pt>
                <c:pt idx="136" formatCode="0.0">
                  <c:v>25.697299999999998</c:v>
                </c:pt>
                <c:pt idx="137" formatCode="0.0">
                  <c:v>10.32</c:v>
                </c:pt>
                <c:pt idx="138" formatCode="0.0">
                  <c:v>16.745399999999997</c:v>
                </c:pt>
                <c:pt idx="139" formatCode="0.0">
                  <c:v>17.2256</c:v>
                </c:pt>
                <c:pt idx="140" formatCode="0.0">
                  <c:v>29.328399999999995</c:v>
                </c:pt>
                <c:pt idx="141" formatCode="0.0">
                  <c:v>24.8474</c:v>
                </c:pt>
                <c:pt idx="142" formatCode="0.0">
                  <c:v>15.834</c:v>
                </c:pt>
                <c:pt idx="143" formatCode="0.0">
                  <c:v>28.103899999999996</c:v>
                </c:pt>
                <c:pt idx="144" formatCode="0.0">
                  <c:v>31.664600000000004</c:v>
                </c:pt>
                <c:pt idx="145" formatCode="0.0">
                  <c:v>15.379200000000003</c:v>
                </c:pt>
                <c:pt idx="146" formatCode="0.0">
                  <c:v>41.866400000000006</c:v>
                </c:pt>
                <c:pt idx="147" formatCode="0.0">
                  <c:v>30.080000000000002</c:v>
                </c:pt>
                <c:pt idx="148" formatCode="0.0">
                  <c:v>9.8567999999999998</c:v>
                </c:pt>
                <c:pt idx="149" formatCode="0.0">
                  <c:v>24.123900000000003</c:v>
                </c:pt>
                <c:pt idx="150" formatCode="0.0">
                  <c:v>14.2912</c:v>
                </c:pt>
                <c:pt idx="151" formatCode="0.0">
                  <c:v>36.487500000000004</c:v>
                </c:pt>
                <c:pt idx="152" formatCode="0.0">
                  <c:v>18.3781</c:v>
                </c:pt>
                <c:pt idx="153" formatCode="0.0">
                  <c:v>28.819200000000002</c:v>
                </c:pt>
                <c:pt idx="154" formatCode="0.0">
                  <c:v>20.301300000000001</c:v>
                </c:pt>
                <c:pt idx="155" formatCode="0.0">
                  <c:v>29.741599999999998</c:v>
                </c:pt>
                <c:pt idx="156" formatCode="0.0">
                  <c:v>28.860600000000002</c:v>
                </c:pt>
                <c:pt idx="157" formatCode="0.0">
                  <c:v>16.1616</c:v>
                </c:pt>
                <c:pt idx="158" formatCode="0.0">
                  <c:v>21.175000000000001</c:v>
                </c:pt>
                <c:pt idx="159" formatCode="0.0">
                  <c:v>15.932699999999999</c:v>
                </c:pt>
                <c:pt idx="160" formatCode="0.0">
                  <c:v>12.845000000000002</c:v>
                </c:pt>
                <c:pt idx="161" formatCode="0.0">
                  <c:v>13.410099999999998</c:v>
                </c:pt>
                <c:pt idx="162" formatCode="0.0">
                  <c:v>14.8779</c:v>
                </c:pt>
                <c:pt idx="163" formatCode="0.0">
                  <c:v>17.250800000000002</c:v>
                </c:pt>
                <c:pt idx="164" formatCode="0.0">
                  <c:v>5.9994999999999994</c:v>
                </c:pt>
                <c:pt idx="165" formatCode="0.0">
                  <c:v>18.782400000000003</c:v>
                </c:pt>
                <c:pt idx="166" formatCode="0.0">
                  <c:v>22.034199999999998</c:v>
                </c:pt>
                <c:pt idx="167" formatCode="0.0">
                  <c:v>21.658000000000001</c:v>
                </c:pt>
                <c:pt idx="168" formatCode="0.0">
                  <c:v>26.04</c:v>
                </c:pt>
                <c:pt idx="169" formatCode="0.0">
                  <c:v>16.984000000000002</c:v>
                </c:pt>
                <c:pt idx="170" formatCode="0.0">
                  <c:v>14.895300000000001</c:v>
                </c:pt>
                <c:pt idx="171" formatCode="0.0">
                  <c:v>8.0487000000000002</c:v>
                </c:pt>
                <c:pt idx="172" formatCode="0.0">
                  <c:v>10.22580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4D25-4717-AEC9-8D3082AA75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834880"/>
        <c:axId val="115836800"/>
      </c:scatterChart>
      <c:valAx>
        <c:axId val="115834880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>
                    <a:solidFill>
                      <a:schemeClr val="tx1"/>
                    </a:solidFill>
                  </a:rPr>
                  <a:t>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5836800"/>
        <c:crosses val="autoZero"/>
        <c:crossBetween val="midCat"/>
        <c:majorUnit val="20"/>
        <c:minorUnit val="4"/>
      </c:valAx>
      <c:valAx>
        <c:axId val="115836800"/>
        <c:scaling>
          <c:orientation val="minMax"/>
          <c:min val="0"/>
        </c:scaling>
        <c:delete val="0"/>
        <c:axPos val="l"/>
        <c:numFmt formatCode="0.0" sourceLinked="1"/>
        <c:majorTickMark val="in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58348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 i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94791666666666"/>
          <c:y val="2.9545370370370371E-2"/>
          <c:w val="0.75852326388888891"/>
          <c:h val="0.8118222222222223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B$2:$B$609</c:f>
              <c:numCache>
                <c:formatCode>0.0</c:formatCode>
                <c:ptCount val="608"/>
                <c:pt idx="0">
                  <c:v>2.6911999999999998</c:v>
                </c:pt>
                <c:pt idx="1">
                  <c:v>4.8565000000000005</c:v>
                </c:pt>
                <c:pt idx="2">
                  <c:v>5.1184000000000003</c:v>
                </c:pt>
                <c:pt idx="3">
                  <c:v>2.6766999999999999</c:v>
                </c:pt>
                <c:pt idx="4">
                  <c:v>6.03</c:v>
                </c:pt>
                <c:pt idx="5">
                  <c:v>1.4773000000000001</c:v>
                </c:pt>
                <c:pt idx="6">
                  <c:v>9.0192999999999994</c:v>
                </c:pt>
                <c:pt idx="7">
                  <c:v>2.3010000000000002</c:v>
                </c:pt>
                <c:pt idx="8">
                  <c:v>2.8024</c:v>
                </c:pt>
                <c:pt idx="9">
                  <c:v>2.8117000000000001</c:v>
                </c:pt>
                <c:pt idx="10">
                  <c:v>6.4583999999999993</c:v>
                </c:pt>
                <c:pt idx="11">
                  <c:v>4.6665000000000001</c:v>
                </c:pt>
                <c:pt idx="12">
                  <c:v>4.3286999999999995</c:v>
                </c:pt>
                <c:pt idx="13">
                  <c:v>4.3475000000000001</c:v>
                </c:pt>
                <c:pt idx="14">
                  <c:v>2.7248999999999999</c:v>
                </c:pt>
                <c:pt idx="15">
                  <c:v>3.1715999999999998</c:v>
                </c:pt>
                <c:pt idx="16">
                  <c:v>4.2641999999999998</c:v>
                </c:pt>
                <c:pt idx="17">
                  <c:v>3.74</c:v>
                </c:pt>
                <c:pt idx="18">
                  <c:v>2.637</c:v>
                </c:pt>
                <c:pt idx="19">
                  <c:v>2.5259</c:v>
                </c:pt>
                <c:pt idx="20">
                  <c:v>1.6182000000000001</c:v>
                </c:pt>
                <c:pt idx="21">
                  <c:v>3.6448999999999998</c:v>
                </c:pt>
                <c:pt idx="22">
                  <c:v>4.077</c:v>
                </c:pt>
                <c:pt idx="23">
                  <c:v>4.0905000000000005</c:v>
                </c:pt>
                <c:pt idx="24">
                  <c:v>6.1478999999999999</c:v>
                </c:pt>
                <c:pt idx="25">
                  <c:v>3.5259999999999998</c:v>
                </c:pt>
                <c:pt idx="26">
                  <c:v>9.6883999999999997</c:v>
                </c:pt>
                <c:pt idx="27">
                  <c:v>3.5723999999999996</c:v>
                </c:pt>
                <c:pt idx="28">
                  <c:v>4.5359999999999996</c:v>
                </c:pt>
                <c:pt idx="29">
                  <c:v>7.8587000000000007</c:v>
                </c:pt>
                <c:pt idx="30">
                  <c:v>1.6586999999999998</c:v>
                </c:pt>
                <c:pt idx="31">
                  <c:v>9.9977999999999998</c:v>
                </c:pt>
                <c:pt idx="32">
                  <c:v>7.902400000000001</c:v>
                </c:pt>
                <c:pt idx="33">
                  <c:v>6.5786000000000007</c:v>
                </c:pt>
                <c:pt idx="34">
                  <c:v>2.1888000000000001</c:v>
                </c:pt>
                <c:pt idx="35">
                  <c:v>5.6224999999999996</c:v>
                </c:pt>
                <c:pt idx="36">
                  <c:v>5.6605999999999996</c:v>
                </c:pt>
                <c:pt idx="37">
                  <c:v>8.577</c:v>
                </c:pt>
                <c:pt idx="38">
                  <c:v>1.0728</c:v>
                </c:pt>
                <c:pt idx="39">
                  <c:v>5.3218000000000005</c:v>
                </c:pt>
                <c:pt idx="40">
                  <c:v>5.2610999999999999</c:v>
                </c:pt>
                <c:pt idx="41">
                  <c:v>6.57</c:v>
                </c:pt>
                <c:pt idx="42">
                  <c:v>3.3325999999999998</c:v>
                </c:pt>
                <c:pt idx="43">
                  <c:v>4.3953000000000007</c:v>
                </c:pt>
                <c:pt idx="44">
                  <c:v>11.055100000000001</c:v>
                </c:pt>
                <c:pt idx="45">
                  <c:v>7.0224000000000002</c:v>
                </c:pt>
                <c:pt idx="46">
                  <c:v>1.3155000000000001</c:v>
                </c:pt>
                <c:pt idx="47">
                  <c:v>5.7890000000000006</c:v>
                </c:pt>
                <c:pt idx="48">
                  <c:v>4.0480000000000009</c:v>
                </c:pt>
                <c:pt idx="49">
                  <c:v>6.8968000000000007</c:v>
                </c:pt>
                <c:pt idx="50">
                  <c:v>1.6606000000000001</c:v>
                </c:pt>
                <c:pt idx="51">
                  <c:v>7.7880000000000011</c:v>
                </c:pt>
                <c:pt idx="52">
                  <c:v>5.156600000000001</c:v>
                </c:pt>
                <c:pt idx="53">
                  <c:v>2.8985000000000003</c:v>
                </c:pt>
                <c:pt idx="54">
                  <c:v>4.0905000000000005</c:v>
                </c:pt>
                <c:pt idx="55">
                  <c:v>3.2292000000000001</c:v>
                </c:pt>
                <c:pt idx="56">
                  <c:v>3.5411999999999995</c:v>
                </c:pt>
                <c:pt idx="57">
                  <c:v>3.0905</c:v>
                </c:pt>
                <c:pt idx="58">
                  <c:v>7.8568000000000007</c:v>
                </c:pt>
                <c:pt idx="59">
                  <c:v>7.9624999999999995</c:v>
                </c:pt>
                <c:pt idx="60">
                  <c:v>3.0821999999999998</c:v>
                </c:pt>
                <c:pt idx="61">
                  <c:v>6.7488000000000001</c:v>
                </c:pt>
                <c:pt idx="62">
                  <c:v>8.277000000000001</c:v>
                </c:pt>
                <c:pt idx="63">
                  <c:v>6.5550000000000006</c:v>
                </c:pt>
                <c:pt idx="64">
                  <c:v>3.0566</c:v>
                </c:pt>
                <c:pt idx="65">
                  <c:v>3.1415999999999999</c:v>
                </c:pt>
                <c:pt idx="66">
                  <c:v>4.7788000000000004</c:v>
                </c:pt>
                <c:pt idx="67">
                  <c:v>8.6449999999999996</c:v>
                </c:pt>
                <c:pt idx="68">
                  <c:v>4.2287999999999997</c:v>
                </c:pt>
                <c:pt idx="69">
                  <c:v>7.0960000000000001</c:v>
                </c:pt>
                <c:pt idx="70">
                  <c:v>4.2816000000000001</c:v>
                </c:pt>
                <c:pt idx="71">
                  <c:v>5.2663999999999991</c:v>
                </c:pt>
                <c:pt idx="72">
                  <c:v>8.3992999999999984</c:v>
                </c:pt>
                <c:pt idx="73">
                  <c:v>3.6519999999999997</c:v>
                </c:pt>
                <c:pt idx="74">
                  <c:v>3.1823999999999999</c:v>
                </c:pt>
                <c:pt idx="75">
                  <c:v>9.0400000000000009</c:v>
                </c:pt>
                <c:pt idx="76">
                  <c:v>10.3604</c:v>
                </c:pt>
                <c:pt idx="77">
                  <c:v>5.6912999999999991</c:v>
                </c:pt>
                <c:pt idx="78">
                  <c:v>3.6366999999999998</c:v>
                </c:pt>
                <c:pt idx="79">
                  <c:v>9.9770000000000003</c:v>
                </c:pt>
                <c:pt idx="80">
                  <c:v>6.1548000000000007</c:v>
                </c:pt>
                <c:pt idx="81">
                  <c:v>4.2581999999999995</c:v>
                </c:pt>
                <c:pt idx="82">
                  <c:v>8.6859999999999999</c:v>
                </c:pt>
                <c:pt idx="83">
                  <c:v>4.3655999999999997</c:v>
                </c:pt>
                <c:pt idx="84">
                  <c:v>2.9699999999999998</c:v>
                </c:pt>
                <c:pt idx="85">
                  <c:v>10.1343</c:v>
                </c:pt>
                <c:pt idx="86">
                  <c:v>2.5676000000000001</c:v>
                </c:pt>
                <c:pt idx="87">
                  <c:v>2.2412000000000001</c:v>
                </c:pt>
                <c:pt idx="88">
                  <c:v>2.8582000000000001</c:v>
                </c:pt>
                <c:pt idx="89">
                  <c:v>2.6708999999999996</c:v>
                </c:pt>
                <c:pt idx="90">
                  <c:v>2.5059999999999998</c:v>
                </c:pt>
                <c:pt idx="91">
                  <c:v>1.8858000000000001</c:v>
                </c:pt>
                <c:pt idx="92">
                  <c:v>8.4271999999999991</c:v>
                </c:pt>
                <c:pt idx="93">
                  <c:v>3.9899999999999998</c:v>
                </c:pt>
              </c:numCache>
            </c:numRef>
          </c:y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>
                      <c:ext uri="{02D57815-91ED-43cb-92C2-25804820EDAC}">
                        <c15:formulaRef>
                          <c15:sqref>Tabelle1!$B$1</c15:sqref>
                        </c15:formulaRef>
                      </c:ext>
                    </c:extLst>
                    <c:strCache>
                      <c:ptCount val="1"/>
                      <c:pt idx="0">
                        <c:v>CD31+-Mem</c:v>
                      </c:pt>
                    </c:strCache>
                  </c:strRef>
                </c15:tx>
              </c15:filteredSeriesTitle>
            </c:ext>
            <c:ext xmlns:c16="http://schemas.microsoft.com/office/drawing/2014/chart" uri="{C3380CC4-5D6E-409C-BE32-E72D297353CC}">
              <c16:uniqueId val="{00000001-07F5-4A14-B12E-FF74D1DE9B43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:$A$609</c:f>
              <c:numCache>
                <c:formatCode>0</c:formatCode>
                <c:ptCount val="608"/>
                <c:pt idx="0">
                  <c:v>18</c:v>
                </c:pt>
                <c:pt idx="1">
                  <c:v>21</c:v>
                </c:pt>
                <c:pt idx="2">
                  <c:v>21</c:v>
                </c:pt>
                <c:pt idx="3">
                  <c:v>22</c:v>
                </c:pt>
                <c:pt idx="4">
                  <c:v>22</c:v>
                </c:pt>
                <c:pt idx="5">
                  <c:v>23</c:v>
                </c:pt>
                <c:pt idx="6">
                  <c:v>23</c:v>
                </c:pt>
                <c:pt idx="7">
                  <c:v>23</c:v>
                </c:pt>
                <c:pt idx="8">
                  <c:v>23</c:v>
                </c:pt>
                <c:pt idx="9">
                  <c:v>23</c:v>
                </c:pt>
                <c:pt idx="10">
                  <c:v>24</c:v>
                </c:pt>
                <c:pt idx="11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5</c:v>
                </c:pt>
                <c:pt idx="15">
                  <c:v>25</c:v>
                </c:pt>
                <c:pt idx="16">
                  <c:v>25</c:v>
                </c:pt>
                <c:pt idx="17">
                  <c:v>25</c:v>
                </c:pt>
                <c:pt idx="18">
                  <c:v>26</c:v>
                </c:pt>
                <c:pt idx="19">
                  <c:v>26</c:v>
                </c:pt>
                <c:pt idx="20">
                  <c:v>28</c:v>
                </c:pt>
                <c:pt idx="21">
                  <c:v>28</c:v>
                </c:pt>
                <c:pt idx="22">
                  <c:v>28</c:v>
                </c:pt>
                <c:pt idx="23">
                  <c:v>29</c:v>
                </c:pt>
                <c:pt idx="24">
                  <c:v>29</c:v>
                </c:pt>
                <c:pt idx="25">
                  <c:v>29</c:v>
                </c:pt>
                <c:pt idx="26">
                  <c:v>31</c:v>
                </c:pt>
                <c:pt idx="27">
                  <c:v>31</c:v>
                </c:pt>
                <c:pt idx="28">
                  <c:v>32</c:v>
                </c:pt>
                <c:pt idx="29">
                  <c:v>32</c:v>
                </c:pt>
                <c:pt idx="30">
                  <c:v>32</c:v>
                </c:pt>
                <c:pt idx="31">
                  <c:v>34</c:v>
                </c:pt>
                <c:pt idx="32">
                  <c:v>35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0</c:v>
                </c:pt>
                <c:pt idx="41">
                  <c:v>40</c:v>
                </c:pt>
                <c:pt idx="42">
                  <c:v>40</c:v>
                </c:pt>
                <c:pt idx="43">
                  <c:v>41</c:v>
                </c:pt>
                <c:pt idx="44">
                  <c:v>41</c:v>
                </c:pt>
                <c:pt idx="45">
                  <c:v>42</c:v>
                </c:pt>
                <c:pt idx="46">
                  <c:v>42</c:v>
                </c:pt>
                <c:pt idx="47">
                  <c:v>43</c:v>
                </c:pt>
                <c:pt idx="48">
                  <c:v>43</c:v>
                </c:pt>
                <c:pt idx="49">
                  <c:v>44</c:v>
                </c:pt>
                <c:pt idx="50">
                  <c:v>45</c:v>
                </c:pt>
                <c:pt idx="51">
                  <c:v>48</c:v>
                </c:pt>
                <c:pt idx="52">
                  <c:v>48</c:v>
                </c:pt>
                <c:pt idx="53">
                  <c:v>48</c:v>
                </c:pt>
                <c:pt idx="54">
                  <c:v>50</c:v>
                </c:pt>
                <c:pt idx="55">
                  <c:v>50</c:v>
                </c:pt>
                <c:pt idx="56">
                  <c:v>50</c:v>
                </c:pt>
                <c:pt idx="57">
                  <c:v>50</c:v>
                </c:pt>
                <c:pt idx="58">
                  <c:v>50</c:v>
                </c:pt>
                <c:pt idx="59">
                  <c:v>51</c:v>
                </c:pt>
                <c:pt idx="60">
                  <c:v>52</c:v>
                </c:pt>
                <c:pt idx="61">
                  <c:v>52</c:v>
                </c:pt>
                <c:pt idx="62">
                  <c:v>52</c:v>
                </c:pt>
                <c:pt idx="63">
                  <c:v>53</c:v>
                </c:pt>
                <c:pt idx="64">
                  <c:v>54</c:v>
                </c:pt>
                <c:pt idx="65">
                  <c:v>54</c:v>
                </c:pt>
                <c:pt idx="66">
                  <c:v>54</c:v>
                </c:pt>
                <c:pt idx="67">
                  <c:v>55</c:v>
                </c:pt>
                <c:pt idx="68">
                  <c:v>55</c:v>
                </c:pt>
                <c:pt idx="69">
                  <c:v>55</c:v>
                </c:pt>
                <c:pt idx="70">
                  <c:v>56</c:v>
                </c:pt>
                <c:pt idx="71">
                  <c:v>57</c:v>
                </c:pt>
                <c:pt idx="72">
                  <c:v>59</c:v>
                </c:pt>
                <c:pt idx="73">
                  <c:v>60</c:v>
                </c:pt>
                <c:pt idx="74">
                  <c:v>60</c:v>
                </c:pt>
                <c:pt idx="75">
                  <c:v>63</c:v>
                </c:pt>
                <c:pt idx="76">
                  <c:v>65</c:v>
                </c:pt>
                <c:pt idx="77">
                  <c:v>66</c:v>
                </c:pt>
                <c:pt idx="78">
                  <c:v>66</c:v>
                </c:pt>
                <c:pt idx="79">
                  <c:v>70</c:v>
                </c:pt>
                <c:pt idx="80">
                  <c:v>71</c:v>
                </c:pt>
                <c:pt idx="81">
                  <c:v>71</c:v>
                </c:pt>
                <c:pt idx="82">
                  <c:v>71</c:v>
                </c:pt>
                <c:pt idx="83">
                  <c:v>73</c:v>
                </c:pt>
                <c:pt idx="84">
                  <c:v>73</c:v>
                </c:pt>
                <c:pt idx="85">
                  <c:v>73</c:v>
                </c:pt>
                <c:pt idx="86">
                  <c:v>73</c:v>
                </c:pt>
                <c:pt idx="87">
                  <c:v>74</c:v>
                </c:pt>
                <c:pt idx="88">
                  <c:v>75</c:v>
                </c:pt>
                <c:pt idx="89">
                  <c:v>77</c:v>
                </c:pt>
                <c:pt idx="90">
                  <c:v>78</c:v>
                </c:pt>
                <c:pt idx="91">
                  <c:v>83</c:v>
                </c:pt>
                <c:pt idx="92">
                  <c:v>84</c:v>
                </c:pt>
                <c:pt idx="93">
                  <c:v>87</c:v>
                </c:pt>
                <c:pt idx="95">
                  <c:v>20</c:v>
                </c:pt>
                <c:pt idx="96">
                  <c:v>21</c:v>
                </c:pt>
                <c:pt idx="97">
                  <c:v>23</c:v>
                </c:pt>
                <c:pt idx="98">
                  <c:v>23</c:v>
                </c:pt>
                <c:pt idx="99">
                  <c:v>26</c:v>
                </c:pt>
                <c:pt idx="100">
                  <c:v>26</c:v>
                </c:pt>
                <c:pt idx="101">
                  <c:v>26</c:v>
                </c:pt>
                <c:pt idx="102">
                  <c:v>26</c:v>
                </c:pt>
                <c:pt idx="103">
                  <c:v>26</c:v>
                </c:pt>
                <c:pt idx="104">
                  <c:v>27</c:v>
                </c:pt>
                <c:pt idx="105">
                  <c:v>27</c:v>
                </c:pt>
                <c:pt idx="106">
                  <c:v>29</c:v>
                </c:pt>
                <c:pt idx="107">
                  <c:v>30</c:v>
                </c:pt>
                <c:pt idx="108">
                  <c:v>31</c:v>
                </c:pt>
                <c:pt idx="109">
                  <c:v>31</c:v>
                </c:pt>
                <c:pt idx="110">
                  <c:v>31</c:v>
                </c:pt>
                <c:pt idx="111">
                  <c:v>32</c:v>
                </c:pt>
                <c:pt idx="112">
                  <c:v>33</c:v>
                </c:pt>
                <c:pt idx="113">
                  <c:v>33</c:v>
                </c:pt>
                <c:pt idx="114">
                  <c:v>33</c:v>
                </c:pt>
                <c:pt idx="115">
                  <c:v>35</c:v>
                </c:pt>
                <c:pt idx="116">
                  <c:v>35</c:v>
                </c:pt>
                <c:pt idx="117">
                  <c:v>35</c:v>
                </c:pt>
                <c:pt idx="118">
                  <c:v>35</c:v>
                </c:pt>
                <c:pt idx="119">
                  <c:v>35</c:v>
                </c:pt>
                <c:pt idx="120">
                  <c:v>36</c:v>
                </c:pt>
                <c:pt idx="121">
                  <c:v>40</c:v>
                </c:pt>
                <c:pt idx="122">
                  <c:v>40</c:v>
                </c:pt>
                <c:pt idx="123">
                  <c:v>40</c:v>
                </c:pt>
                <c:pt idx="124">
                  <c:v>40</c:v>
                </c:pt>
                <c:pt idx="125">
                  <c:v>40</c:v>
                </c:pt>
                <c:pt idx="126">
                  <c:v>41</c:v>
                </c:pt>
                <c:pt idx="127">
                  <c:v>42</c:v>
                </c:pt>
                <c:pt idx="128">
                  <c:v>42</c:v>
                </c:pt>
                <c:pt idx="129">
                  <c:v>42</c:v>
                </c:pt>
                <c:pt idx="130">
                  <c:v>42</c:v>
                </c:pt>
                <c:pt idx="131">
                  <c:v>42</c:v>
                </c:pt>
                <c:pt idx="132">
                  <c:v>42</c:v>
                </c:pt>
                <c:pt idx="133">
                  <c:v>43</c:v>
                </c:pt>
                <c:pt idx="134">
                  <c:v>44</c:v>
                </c:pt>
                <c:pt idx="135">
                  <c:v>44</c:v>
                </c:pt>
                <c:pt idx="136">
                  <c:v>45</c:v>
                </c:pt>
                <c:pt idx="137">
                  <c:v>46</c:v>
                </c:pt>
                <c:pt idx="138">
                  <c:v>47</c:v>
                </c:pt>
                <c:pt idx="139">
                  <c:v>49</c:v>
                </c:pt>
                <c:pt idx="140">
                  <c:v>50</c:v>
                </c:pt>
                <c:pt idx="141">
                  <c:v>50</c:v>
                </c:pt>
                <c:pt idx="142">
                  <c:v>50</c:v>
                </c:pt>
                <c:pt idx="143">
                  <c:v>50</c:v>
                </c:pt>
                <c:pt idx="144">
                  <c:v>50</c:v>
                </c:pt>
                <c:pt idx="145">
                  <c:v>51</c:v>
                </c:pt>
                <c:pt idx="146">
                  <c:v>51</c:v>
                </c:pt>
                <c:pt idx="147">
                  <c:v>53</c:v>
                </c:pt>
                <c:pt idx="148">
                  <c:v>53</c:v>
                </c:pt>
                <c:pt idx="149">
                  <c:v>53</c:v>
                </c:pt>
                <c:pt idx="150">
                  <c:v>54</c:v>
                </c:pt>
                <c:pt idx="151">
                  <c:v>56</c:v>
                </c:pt>
                <c:pt idx="152">
                  <c:v>56</c:v>
                </c:pt>
                <c:pt idx="153">
                  <c:v>56</c:v>
                </c:pt>
                <c:pt idx="154">
                  <c:v>57</c:v>
                </c:pt>
                <c:pt idx="155">
                  <c:v>57</c:v>
                </c:pt>
                <c:pt idx="156">
                  <c:v>58</c:v>
                </c:pt>
                <c:pt idx="157">
                  <c:v>58</c:v>
                </c:pt>
                <c:pt idx="158">
                  <c:v>58</c:v>
                </c:pt>
                <c:pt idx="159">
                  <c:v>59</c:v>
                </c:pt>
                <c:pt idx="160">
                  <c:v>61</c:v>
                </c:pt>
                <c:pt idx="161">
                  <c:v>61</c:v>
                </c:pt>
                <c:pt idx="162">
                  <c:v>62</c:v>
                </c:pt>
                <c:pt idx="163">
                  <c:v>64</c:v>
                </c:pt>
                <c:pt idx="164">
                  <c:v>65</c:v>
                </c:pt>
                <c:pt idx="165">
                  <c:v>66</c:v>
                </c:pt>
                <c:pt idx="166">
                  <c:v>66</c:v>
                </c:pt>
                <c:pt idx="167">
                  <c:v>69</c:v>
                </c:pt>
                <c:pt idx="168">
                  <c:v>72</c:v>
                </c:pt>
                <c:pt idx="169">
                  <c:v>72</c:v>
                </c:pt>
                <c:pt idx="170">
                  <c:v>74</c:v>
                </c:pt>
                <c:pt idx="171">
                  <c:v>80</c:v>
                </c:pt>
                <c:pt idx="172">
                  <c:v>80</c:v>
                </c:pt>
              </c:numCache>
            </c:numRef>
          </c:xVal>
          <c:yVal>
            <c:numRef>
              <c:f>Tabelle1!$C$2:$C$609</c:f>
              <c:numCache>
                <c:formatCode>General</c:formatCode>
                <c:ptCount val="608"/>
                <c:pt idx="95" formatCode="0.0">
                  <c:v>3.1041999999999996</c:v>
                </c:pt>
                <c:pt idx="96" formatCode="0.0">
                  <c:v>1.3104000000000002</c:v>
                </c:pt>
                <c:pt idx="97" formatCode="0.0">
                  <c:v>5.6171999999999995</c:v>
                </c:pt>
                <c:pt idx="98" formatCode="0.0">
                  <c:v>1.9656</c:v>
                </c:pt>
                <c:pt idx="99" formatCode="0.0">
                  <c:v>6.4824000000000002</c:v>
                </c:pt>
                <c:pt idx="100" formatCode="0.0">
                  <c:v>1.72</c:v>
                </c:pt>
                <c:pt idx="101" formatCode="0.0">
                  <c:v>8.4443999999999999</c:v>
                </c:pt>
                <c:pt idx="102" formatCode="0.0">
                  <c:v>2.3679000000000001</c:v>
                </c:pt>
                <c:pt idx="103" formatCode="0.0">
                  <c:v>6.4752000000000001</c:v>
                </c:pt>
                <c:pt idx="104" formatCode="0.0">
                  <c:v>4.8565000000000005</c:v>
                </c:pt>
                <c:pt idx="105" formatCode="0.0">
                  <c:v>4.18</c:v>
                </c:pt>
                <c:pt idx="106" formatCode="0.0">
                  <c:v>6.8112000000000004</c:v>
                </c:pt>
                <c:pt idx="107" formatCode="0.0">
                  <c:v>3.7312000000000003</c:v>
                </c:pt>
                <c:pt idx="108" formatCode="0.0">
                  <c:v>8.3753999999999991</c:v>
                </c:pt>
                <c:pt idx="109" formatCode="0.0">
                  <c:v>4.6868999999999996</c:v>
                </c:pt>
                <c:pt idx="110" formatCode="0.0">
                  <c:v>4.9501000000000008</c:v>
                </c:pt>
                <c:pt idx="111" formatCode="0.0">
                  <c:v>4.1797000000000004</c:v>
                </c:pt>
                <c:pt idx="112" formatCode="0.0">
                  <c:v>3.7319999999999998</c:v>
                </c:pt>
                <c:pt idx="113" formatCode="0.0">
                  <c:v>4.5287999999999995</c:v>
                </c:pt>
                <c:pt idx="114" formatCode="0.0">
                  <c:v>5.2325999999999997</c:v>
                </c:pt>
                <c:pt idx="115" formatCode="0.0">
                  <c:v>7.9377999999999993</c:v>
                </c:pt>
                <c:pt idx="116" formatCode="0.0">
                  <c:v>2.5310999999999999</c:v>
                </c:pt>
                <c:pt idx="117" formatCode="0.0">
                  <c:v>4.0568000000000008</c:v>
                </c:pt>
                <c:pt idx="118" formatCode="0.0">
                  <c:v>6.7039999999999997</c:v>
                </c:pt>
                <c:pt idx="119" formatCode="0.0">
                  <c:v>9.3528000000000002</c:v>
                </c:pt>
                <c:pt idx="120" formatCode="0.0">
                  <c:v>4.1108999999999991</c:v>
                </c:pt>
                <c:pt idx="121" formatCode="0.0">
                  <c:v>4.2535000000000007</c:v>
                </c:pt>
                <c:pt idx="122" formatCode="0.0">
                  <c:v>2.2763999999999998</c:v>
                </c:pt>
                <c:pt idx="123" formatCode="0.0">
                  <c:v>3.1898</c:v>
                </c:pt>
                <c:pt idx="124" formatCode="0.0">
                  <c:v>4.4207999999999998</c:v>
                </c:pt>
                <c:pt idx="125" formatCode="0.0">
                  <c:v>5.1699000000000002</c:v>
                </c:pt>
                <c:pt idx="126" formatCode="0.0">
                  <c:v>2.6263999999999998</c:v>
                </c:pt>
                <c:pt idx="127" formatCode="0.0">
                  <c:v>1.0655999999999999</c:v>
                </c:pt>
                <c:pt idx="128" formatCode="0.0">
                  <c:v>7.7163000000000004</c:v>
                </c:pt>
                <c:pt idx="129" formatCode="0.0">
                  <c:v>1.7847999999999997</c:v>
                </c:pt>
                <c:pt idx="130" formatCode="0.0">
                  <c:v>4.4590000000000005</c:v>
                </c:pt>
                <c:pt idx="131" formatCode="0.0">
                  <c:v>2.7323999999999997</c:v>
                </c:pt>
                <c:pt idx="132" formatCode="0.0">
                  <c:v>1.78</c:v>
                </c:pt>
                <c:pt idx="133" formatCode="0.0">
                  <c:v>3.1590000000000003</c:v>
                </c:pt>
                <c:pt idx="134" formatCode="0.0">
                  <c:v>3.0636000000000001</c:v>
                </c:pt>
                <c:pt idx="135" formatCode="0.0">
                  <c:v>5.073599999999999</c:v>
                </c:pt>
                <c:pt idx="136" formatCode="0.0">
                  <c:v>2.8734999999999999</c:v>
                </c:pt>
                <c:pt idx="137" formatCode="0.0">
                  <c:v>4.0419999999999998</c:v>
                </c:pt>
                <c:pt idx="138" formatCode="0.0">
                  <c:v>6.2019999999999991</c:v>
                </c:pt>
                <c:pt idx="139" formatCode="0.0">
                  <c:v>3.7681000000000004</c:v>
                </c:pt>
                <c:pt idx="140" formatCode="0.0">
                  <c:v>3.3595999999999999</c:v>
                </c:pt>
                <c:pt idx="141" formatCode="0.0">
                  <c:v>2.8096000000000001</c:v>
                </c:pt>
                <c:pt idx="142" formatCode="0.0">
                  <c:v>3.48</c:v>
                </c:pt>
                <c:pt idx="143" formatCode="0.0">
                  <c:v>2.3786999999999998</c:v>
                </c:pt>
                <c:pt idx="144" formatCode="0.0">
                  <c:v>3.7343999999999999</c:v>
                </c:pt>
                <c:pt idx="145" formatCode="0.0">
                  <c:v>4.9248000000000003</c:v>
                </c:pt>
                <c:pt idx="146" formatCode="0.0">
                  <c:v>6.1203000000000003</c:v>
                </c:pt>
                <c:pt idx="147" formatCode="0.0">
                  <c:v>4.5600000000000005</c:v>
                </c:pt>
                <c:pt idx="148" formatCode="0.0">
                  <c:v>8.8800000000000008</c:v>
                </c:pt>
                <c:pt idx="149" formatCode="0.0">
                  <c:v>5.5543000000000005</c:v>
                </c:pt>
                <c:pt idx="150" formatCode="0.0">
                  <c:v>1.7631999999999999</c:v>
                </c:pt>
                <c:pt idx="151" formatCode="0.0">
                  <c:v>2.5375000000000001</c:v>
                </c:pt>
                <c:pt idx="152" formatCode="0.0">
                  <c:v>5.6615000000000002</c:v>
                </c:pt>
                <c:pt idx="153" formatCode="0.0">
                  <c:v>2.1888000000000001</c:v>
                </c:pt>
                <c:pt idx="154" formatCode="0.0">
                  <c:v>5.9328000000000003</c:v>
                </c:pt>
                <c:pt idx="155" formatCode="0.0">
                  <c:v>1.3560000000000001</c:v>
                </c:pt>
                <c:pt idx="156" formatCode="0.0">
                  <c:v>2.802</c:v>
                </c:pt>
                <c:pt idx="157" formatCode="0.0">
                  <c:v>8.6135999999999999</c:v>
                </c:pt>
                <c:pt idx="158" formatCode="0.0">
                  <c:v>5.95</c:v>
                </c:pt>
                <c:pt idx="159" formatCode="0.0">
                  <c:v>4.5522</c:v>
                </c:pt>
                <c:pt idx="160" formatCode="0.0">
                  <c:v>6.3858000000000006</c:v>
                </c:pt>
                <c:pt idx="161" formatCode="0.0">
                  <c:v>8.5117999999999991</c:v>
                </c:pt>
                <c:pt idx="162" formatCode="0.0">
                  <c:v>2.2763999999999998</c:v>
                </c:pt>
                <c:pt idx="163" formatCode="0.0">
                  <c:v>4.611600000000001</c:v>
                </c:pt>
                <c:pt idx="164" formatCode="0.0">
                  <c:v>4.3940000000000001</c:v>
                </c:pt>
                <c:pt idx="165" formatCode="0.0">
                  <c:v>3.8828999999999998</c:v>
                </c:pt>
                <c:pt idx="166" formatCode="0.0">
                  <c:v>4.8777999999999997</c:v>
                </c:pt>
                <c:pt idx="167" formatCode="0.0">
                  <c:v>2.9171999999999998</c:v>
                </c:pt>
                <c:pt idx="168" formatCode="0.0">
                  <c:v>3.472</c:v>
                </c:pt>
                <c:pt idx="169" formatCode="0.0">
                  <c:v>7.3920000000000003</c:v>
                </c:pt>
                <c:pt idx="170" formatCode="0.0">
                  <c:v>4.5632999999999999</c:v>
                </c:pt>
                <c:pt idx="171" formatCode="0.0">
                  <c:v>5.3657999999999992</c:v>
                </c:pt>
                <c:pt idx="172" formatCode="0.0">
                  <c:v>3.0497999999999998</c:v>
                </c:pt>
              </c:numCache>
            </c:numRef>
          </c:y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>
                      <c:ext uri="{02D57815-91ED-43cb-92C2-25804820EDAC}">
                        <c15:formulaRef>
                          <c15:sqref>Tabelle1!$C$1</c15:sqref>
                        </c15:formulaRef>
                      </c:ext>
                    </c:extLst>
                    <c:strCache>
                      <c:ptCount val="1"/>
                      <c:pt idx="0">
                        <c:v>Spalte1</c:v>
                      </c:pt>
                    </c:strCache>
                  </c:strRef>
                </c15:tx>
              </c15:filteredSeriesTitle>
            </c:ext>
            <c:ext xmlns:c16="http://schemas.microsoft.com/office/drawing/2014/chart" uri="{C3380CC4-5D6E-409C-BE32-E72D297353CC}">
              <c16:uniqueId val="{00000003-07F5-4A14-B12E-FF74D1DE9B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126848"/>
        <c:axId val="116128768"/>
      </c:scatterChart>
      <c:valAx>
        <c:axId val="116126848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 dirty="0">
                    <a:solidFill>
                      <a:schemeClr val="tx1"/>
                    </a:solidFill>
                  </a:rPr>
                  <a:t>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6128768"/>
        <c:crosses val="autoZero"/>
        <c:crossBetween val="midCat"/>
        <c:majorUnit val="20"/>
        <c:minorUnit val="4"/>
      </c:valAx>
      <c:valAx>
        <c:axId val="116128768"/>
        <c:scaling>
          <c:orientation val="minMax"/>
        </c:scaling>
        <c:delete val="0"/>
        <c:axPos val="l"/>
        <c:numFmt formatCode="0.0" sourceLinked="1"/>
        <c:majorTickMark val="in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61268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 i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8336</cdr:x>
      <cdr:y>0.74083</cdr:y>
    </cdr:from>
    <cdr:to>
      <cdr:x>0.4067</cdr:x>
      <cdr:y>0.85332</cdr:y>
    </cdr:to>
    <cdr:sp macro="" textlink="">
      <cdr:nvSpPr>
        <cdr:cNvPr id="2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AA337760-B00D-42B4-9405-F1C6AD2F6B43}"/>
            </a:ext>
          </a:extLst>
        </cdr:cNvPr>
        <cdr:cNvSpPr txBox="1"/>
      </cdr:nvSpPr>
      <cdr:spPr>
        <a:xfrm xmlns:a="http://schemas.openxmlformats.org/drawingml/2006/main">
          <a:off x="501683" y="1520182"/>
          <a:ext cx="611059" cy="23082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900" b="1" dirty="0">
              <a:solidFill>
                <a:schemeClr val="tx1"/>
              </a:solidFill>
            </a:rPr>
            <a:t>p &lt; 0.05</a:t>
          </a:r>
        </a:p>
      </cdr:txBody>
    </cdr:sp>
  </cdr:relSizeAnchor>
  <cdr:relSizeAnchor xmlns:cdr="http://schemas.openxmlformats.org/drawingml/2006/chartDrawing">
    <cdr:from>
      <cdr:x>0.54171</cdr:x>
      <cdr:y>0.0822</cdr:y>
    </cdr:from>
    <cdr:to>
      <cdr:x>1</cdr:x>
      <cdr:y>0.23219</cdr:y>
    </cdr:to>
    <cdr:sp macro="" textlink="">
      <cdr:nvSpPr>
        <cdr:cNvPr id="3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45595CAA-9DC9-40ED-BB59-AE74DEDE6AF0}"/>
            </a:ext>
          </a:extLst>
        </cdr:cNvPr>
        <cdr:cNvSpPr txBox="1"/>
      </cdr:nvSpPr>
      <cdr:spPr>
        <a:xfrm xmlns:a="http://schemas.openxmlformats.org/drawingml/2006/main">
          <a:off x="1482132" y="168671"/>
          <a:ext cx="1253869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1400" b="1" dirty="0">
              <a:solidFill>
                <a:srgbClr val="FF0000"/>
              </a:solidFill>
            </a:rPr>
            <a:t>↑ p* &lt; 0.0001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1425</cdr:x>
      <cdr:y>0.73779</cdr:y>
    </cdr:from>
    <cdr:to>
      <cdr:x>0.48446</cdr:x>
      <cdr:y>0.85028</cdr:y>
    </cdr:to>
    <cdr:sp macro="" textlink="">
      <cdr:nvSpPr>
        <cdr:cNvPr id="2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E5BBAC11-BCC1-44F0-BA76-7B7AA89A4409}"/>
            </a:ext>
          </a:extLst>
        </cdr:cNvPr>
        <cdr:cNvSpPr txBox="1"/>
      </cdr:nvSpPr>
      <cdr:spPr>
        <a:xfrm xmlns:a="http://schemas.openxmlformats.org/drawingml/2006/main">
          <a:off x="586176" y="1513955"/>
          <a:ext cx="739295" cy="23082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900" b="1" dirty="0">
              <a:solidFill>
                <a:schemeClr val="tx1"/>
              </a:solidFill>
            </a:rPr>
            <a:t>p &lt; 0.0001</a:t>
          </a:r>
        </a:p>
      </cdr:txBody>
    </cdr:sp>
  </cdr:relSizeAnchor>
  <cdr:relSizeAnchor xmlns:cdr="http://schemas.openxmlformats.org/drawingml/2006/chartDrawing">
    <cdr:from>
      <cdr:x>0.52325</cdr:x>
      <cdr:y>0.08045</cdr:y>
    </cdr:from>
    <cdr:to>
      <cdr:x>0.98153</cdr:x>
      <cdr:y>0.23044</cdr:y>
    </cdr:to>
    <cdr:sp macro="" textlink="">
      <cdr:nvSpPr>
        <cdr:cNvPr id="3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5220D502-BCE3-4EAA-BA7D-381D7CC50D2B}"/>
            </a:ext>
          </a:extLst>
        </cdr:cNvPr>
        <cdr:cNvSpPr txBox="1"/>
      </cdr:nvSpPr>
      <cdr:spPr>
        <a:xfrm xmlns:a="http://schemas.openxmlformats.org/drawingml/2006/main">
          <a:off x="1431610" y="165076"/>
          <a:ext cx="1253869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1400" b="1" dirty="0">
              <a:solidFill>
                <a:srgbClr val="FF0000"/>
              </a:solidFill>
            </a:rPr>
            <a:t>↑ p* &lt; 0.0001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2979</cdr:x>
      <cdr:y>0.09747</cdr:y>
    </cdr:from>
    <cdr:to>
      <cdr:x>0.5</cdr:x>
      <cdr:y>0.20996</cdr:y>
    </cdr:to>
    <cdr:sp macro="" textlink="">
      <cdr:nvSpPr>
        <cdr:cNvPr id="3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7703C55E-CC3C-4D8C-9D0C-1F35ED45D963}"/>
            </a:ext>
          </a:extLst>
        </cdr:cNvPr>
        <cdr:cNvSpPr txBox="1"/>
      </cdr:nvSpPr>
      <cdr:spPr>
        <a:xfrm xmlns:a="http://schemas.openxmlformats.org/drawingml/2006/main">
          <a:off x="628695" y="200001"/>
          <a:ext cx="739305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de-D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900" b="1" dirty="0">
              <a:solidFill>
                <a:schemeClr val="tx1"/>
              </a:solidFill>
            </a:rPr>
            <a:t>p &lt; 0.0001</a:t>
          </a:r>
        </a:p>
      </cdr:txBody>
    </cdr:sp>
  </cdr:relSizeAnchor>
  <cdr:relSizeAnchor xmlns:cdr="http://schemas.openxmlformats.org/drawingml/2006/chartDrawing">
    <cdr:from>
      <cdr:x>0.23165</cdr:x>
      <cdr:y>0.17847</cdr:y>
    </cdr:from>
    <cdr:to>
      <cdr:x>0.45499</cdr:x>
      <cdr:y>0.29096</cdr:y>
    </cdr:to>
    <cdr:sp macro="" textlink="">
      <cdr:nvSpPr>
        <cdr:cNvPr id="4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920FAE2C-792F-4551-8F7D-85ACC615C210}"/>
            </a:ext>
          </a:extLst>
        </cdr:cNvPr>
        <cdr:cNvSpPr txBox="1"/>
      </cdr:nvSpPr>
      <cdr:spPr>
        <a:xfrm xmlns:a="http://schemas.openxmlformats.org/drawingml/2006/main">
          <a:off x="633793" y="366217"/>
          <a:ext cx="611065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de-D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900" b="1" dirty="0">
              <a:solidFill>
                <a:srgbClr val="FF0000"/>
              </a:solidFill>
            </a:rPr>
            <a:t>p &lt; 0.01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85</cdr:x>
      <cdr:y>0.66292</cdr:y>
    </cdr:from>
    <cdr:to>
      <cdr:x>0.45521</cdr:x>
      <cdr:y>0.77541</cdr:y>
    </cdr:to>
    <cdr:sp macro="" textlink="">
      <cdr:nvSpPr>
        <cdr:cNvPr id="2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E8998E5F-BD1F-4FB2-8D51-7029673CC5E3}"/>
            </a:ext>
          </a:extLst>
        </cdr:cNvPr>
        <cdr:cNvSpPr txBox="1"/>
      </cdr:nvSpPr>
      <cdr:spPr>
        <a:xfrm xmlns:a="http://schemas.openxmlformats.org/drawingml/2006/main">
          <a:off x="506160" y="1360309"/>
          <a:ext cx="739305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900" b="1" dirty="0">
              <a:solidFill>
                <a:schemeClr val="tx1"/>
              </a:solidFill>
            </a:rPr>
            <a:t>p &lt; 0.0001</a:t>
          </a:r>
        </a:p>
      </cdr:txBody>
    </cdr:sp>
  </cdr:relSizeAnchor>
  <cdr:relSizeAnchor xmlns:cdr="http://schemas.openxmlformats.org/drawingml/2006/chartDrawing">
    <cdr:from>
      <cdr:x>0.185</cdr:x>
      <cdr:y>0.74339</cdr:y>
    </cdr:from>
    <cdr:to>
      <cdr:x>0.45521</cdr:x>
      <cdr:y>0.85588</cdr:y>
    </cdr:to>
    <cdr:sp macro="" textlink="">
      <cdr:nvSpPr>
        <cdr:cNvPr id="3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81B0A732-0D8F-4305-923A-DB68BC64E2C8}"/>
            </a:ext>
          </a:extLst>
        </cdr:cNvPr>
        <cdr:cNvSpPr txBox="1"/>
      </cdr:nvSpPr>
      <cdr:spPr>
        <a:xfrm xmlns:a="http://schemas.openxmlformats.org/drawingml/2006/main">
          <a:off x="506160" y="1525427"/>
          <a:ext cx="739305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900" b="1" dirty="0">
              <a:solidFill>
                <a:srgbClr val="FF0000"/>
              </a:solidFill>
            </a:rPr>
            <a:t>p &lt; 0.0001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54196</cdr:x>
      <cdr:y>0.13499</cdr:y>
    </cdr:from>
    <cdr:to>
      <cdr:x>0.9276</cdr:x>
      <cdr:y>0.28498</cdr:y>
    </cdr:to>
    <cdr:sp macro="" textlink="">
      <cdr:nvSpPr>
        <cdr:cNvPr id="2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A4052296-AFBF-4011-9538-3445E48F7779}"/>
            </a:ext>
          </a:extLst>
        </cdr:cNvPr>
        <cdr:cNvSpPr txBox="1"/>
      </cdr:nvSpPr>
      <cdr:spPr>
        <a:xfrm xmlns:a="http://schemas.openxmlformats.org/drawingml/2006/main">
          <a:off x="1482816" y="276999"/>
          <a:ext cx="1055097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1400" b="1" dirty="0">
              <a:solidFill>
                <a:srgbClr val="FF0000"/>
              </a:solidFill>
            </a:rPr>
            <a:t>↑ p* &lt; 0.01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17758</cdr:x>
      <cdr:y>0.64794</cdr:y>
    </cdr:from>
    <cdr:to>
      <cdr:x>0.44779</cdr:x>
      <cdr:y>0.76043</cdr:y>
    </cdr:to>
    <cdr:sp macro="" textlink="">
      <cdr:nvSpPr>
        <cdr:cNvPr id="2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72CF7C1A-0A9C-4005-8A22-C4CD89496E98}"/>
            </a:ext>
          </a:extLst>
        </cdr:cNvPr>
        <cdr:cNvSpPr txBox="1"/>
      </cdr:nvSpPr>
      <cdr:spPr>
        <a:xfrm xmlns:a="http://schemas.openxmlformats.org/drawingml/2006/main">
          <a:off x="485847" y="1329574"/>
          <a:ext cx="739305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900" b="1" dirty="0">
              <a:solidFill>
                <a:schemeClr val="tx1"/>
              </a:solidFill>
            </a:rPr>
            <a:t>p &lt; 0.0001</a:t>
          </a:r>
        </a:p>
      </cdr:txBody>
    </cdr:sp>
  </cdr:relSizeAnchor>
  <cdr:relSizeAnchor xmlns:cdr="http://schemas.openxmlformats.org/drawingml/2006/chartDrawing">
    <cdr:from>
      <cdr:x>0.17735</cdr:x>
      <cdr:y>0.7302</cdr:y>
    </cdr:from>
    <cdr:to>
      <cdr:x>0.44757</cdr:x>
      <cdr:y>0.84269</cdr:y>
    </cdr:to>
    <cdr:sp macro="" textlink="">
      <cdr:nvSpPr>
        <cdr:cNvPr id="4" name="Textfeld 24">
          <a:extLst xmlns:a="http://schemas.openxmlformats.org/drawingml/2006/main">
            <a:ext uri="{FF2B5EF4-FFF2-40B4-BE49-F238E27FC236}">
              <a16:creationId xmlns="" xmlns:a16="http://schemas.microsoft.com/office/drawing/2014/main" id="{8A3F0D12-8242-4347-ADEA-4084953E15ED}"/>
            </a:ext>
          </a:extLst>
        </cdr:cNvPr>
        <cdr:cNvSpPr txBox="1"/>
      </cdr:nvSpPr>
      <cdr:spPr>
        <a:xfrm xmlns:a="http://schemas.openxmlformats.org/drawingml/2006/main">
          <a:off x="485233" y="1498369"/>
          <a:ext cx="739305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de-DE" sz="900" b="1" dirty="0">
              <a:solidFill>
                <a:srgbClr val="FF0000"/>
              </a:solidFill>
            </a:rPr>
            <a:t>p &lt; 0.0001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5286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6757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1738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1922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9475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893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312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3952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3784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3953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9170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E1198-B6FD-46F9-A2F6-87858E0D7F93}" type="datetimeFigureOut">
              <a:rPr lang="de-DE" smtClean="0"/>
              <a:t>19.10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F35495-438C-4C95-B555-E3B0BE218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11337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201669" y="148112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Fig.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-1270000" y="120039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de-DE" dirty="0"/>
          </a:p>
        </p:txBody>
      </p:sp>
      <p:graphicFrame>
        <p:nvGraphicFramePr>
          <p:cNvPr id="18" name="Diagramm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5023178"/>
              </p:ext>
            </p:extLst>
          </p:nvPr>
        </p:nvGraphicFramePr>
        <p:xfrm>
          <a:off x="372915" y="3665262"/>
          <a:ext cx="2736001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Diagramm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9300584"/>
              </p:ext>
            </p:extLst>
          </p:nvPr>
        </p:nvGraphicFramePr>
        <p:xfrm>
          <a:off x="3272809" y="3668857"/>
          <a:ext cx="2736001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2" name="Textfeld 41"/>
          <p:cNvSpPr txBox="1"/>
          <p:nvPr/>
        </p:nvSpPr>
        <p:spPr>
          <a:xfrm rot="16200000">
            <a:off x="2801187" y="4391399"/>
            <a:ext cx="11977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/>
              <a:t> of CD4</a:t>
            </a:r>
            <a:r>
              <a:rPr lang="de-DE" sz="900" baseline="30000" dirty="0"/>
              <a:t>+</a:t>
            </a:r>
            <a:r>
              <a:rPr lang="de-DE" sz="900" dirty="0"/>
              <a:t>-T-</a:t>
            </a:r>
            <a:r>
              <a:rPr lang="de-DE" sz="900" dirty="0" err="1"/>
              <a:t>cells</a:t>
            </a:r>
            <a:r>
              <a:rPr lang="de-DE" sz="900" dirty="0"/>
              <a:t> [%]</a:t>
            </a:r>
          </a:p>
        </p:txBody>
      </p:sp>
      <p:sp>
        <p:nvSpPr>
          <p:cNvPr id="44" name="Textfeld 43"/>
          <p:cNvSpPr txBox="1"/>
          <p:nvPr/>
        </p:nvSpPr>
        <p:spPr>
          <a:xfrm rot="16200000">
            <a:off x="-113890" y="4387804"/>
            <a:ext cx="11977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/>
              <a:t> of CD4</a:t>
            </a:r>
            <a:r>
              <a:rPr lang="de-DE" sz="900" baseline="30000" dirty="0"/>
              <a:t>+</a:t>
            </a:r>
            <a:r>
              <a:rPr lang="de-DE" sz="900" dirty="0"/>
              <a:t>-T-</a:t>
            </a:r>
            <a:r>
              <a:rPr lang="de-DE" sz="900" dirty="0" err="1"/>
              <a:t>cells</a:t>
            </a:r>
            <a:r>
              <a:rPr lang="de-DE" sz="900" dirty="0"/>
              <a:t> [%]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1714971" y="3425814"/>
            <a:ext cx="8767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MN Tregs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4048361" y="3428139"/>
            <a:ext cx="17102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CD31</a:t>
            </a:r>
            <a:r>
              <a:rPr lang="de-DE" sz="1200" b="1" baseline="30000" dirty="0"/>
              <a:t>-</a:t>
            </a:r>
            <a:r>
              <a:rPr lang="de-DE" sz="1200" b="1" dirty="0"/>
              <a:t>-memory Tregs</a:t>
            </a:r>
          </a:p>
        </p:txBody>
      </p:sp>
      <p:graphicFrame>
        <p:nvGraphicFramePr>
          <p:cNvPr id="81" name="Diagramm 8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860663"/>
              </p:ext>
            </p:extLst>
          </p:nvPr>
        </p:nvGraphicFramePr>
        <p:xfrm>
          <a:off x="6182956" y="3672405"/>
          <a:ext cx="2736000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4" name="Textfeld 83"/>
          <p:cNvSpPr txBox="1"/>
          <p:nvPr/>
        </p:nvSpPr>
        <p:spPr>
          <a:xfrm rot="16200000">
            <a:off x="5696152" y="4394946"/>
            <a:ext cx="1197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/>
              <a:t> of CD4</a:t>
            </a:r>
            <a:r>
              <a:rPr lang="de-DE" sz="900" baseline="30000" dirty="0"/>
              <a:t>+</a:t>
            </a:r>
            <a:r>
              <a:rPr lang="de-DE" sz="900" dirty="0"/>
              <a:t>-T-</a:t>
            </a:r>
            <a:r>
              <a:rPr lang="de-DE" sz="900" dirty="0" err="1"/>
              <a:t>cells</a:t>
            </a:r>
            <a:r>
              <a:rPr lang="de-DE" sz="900" dirty="0"/>
              <a:t> [%]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7496743" y="3425813"/>
            <a:ext cx="969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MN-Tresps</a:t>
            </a:r>
            <a:endParaRPr lang="de-DE" sz="900" b="1" dirty="0"/>
          </a:p>
        </p:txBody>
      </p:sp>
      <p:graphicFrame>
        <p:nvGraphicFramePr>
          <p:cNvPr id="82" name="Diagramm 8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2303484"/>
              </p:ext>
            </p:extLst>
          </p:nvPr>
        </p:nvGraphicFramePr>
        <p:xfrm>
          <a:off x="9084753" y="3669142"/>
          <a:ext cx="2736000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3" name="Textfeld 82"/>
          <p:cNvSpPr txBox="1"/>
          <p:nvPr/>
        </p:nvSpPr>
        <p:spPr>
          <a:xfrm rot="16200000">
            <a:off x="8597949" y="4391683"/>
            <a:ext cx="1197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/>
              <a:t> of CD4</a:t>
            </a:r>
            <a:r>
              <a:rPr lang="de-DE" sz="900" baseline="30000" dirty="0"/>
              <a:t>+</a:t>
            </a:r>
            <a:r>
              <a:rPr lang="de-DE" sz="900" dirty="0"/>
              <a:t>-T-</a:t>
            </a:r>
            <a:r>
              <a:rPr lang="de-DE" sz="900" dirty="0" err="1"/>
              <a:t>cells</a:t>
            </a:r>
            <a:r>
              <a:rPr lang="de-DE" sz="900" dirty="0"/>
              <a:t> [%]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9912865" y="3429382"/>
            <a:ext cx="1795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CD31</a:t>
            </a:r>
            <a:r>
              <a:rPr lang="de-DE" sz="1200" b="1" baseline="30000" dirty="0"/>
              <a:t>-</a:t>
            </a:r>
            <a:r>
              <a:rPr lang="de-DE" sz="1200" b="1" dirty="0"/>
              <a:t>-memory Tresps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571001" y="95466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1642034" y="1081330"/>
            <a:ext cx="953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RTE-Tregs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4011123" y="1079468"/>
            <a:ext cx="17359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CD31</a:t>
            </a:r>
            <a:r>
              <a:rPr lang="de-DE" sz="1200" b="1" baseline="30000" dirty="0"/>
              <a:t>+</a:t>
            </a:r>
            <a:r>
              <a:rPr lang="de-DE" sz="1200" b="1" dirty="0"/>
              <a:t>-memory Tregs</a:t>
            </a:r>
          </a:p>
        </p:txBody>
      </p:sp>
      <p:sp>
        <p:nvSpPr>
          <p:cNvPr id="78" name="Textfeld 77"/>
          <p:cNvSpPr txBox="1"/>
          <p:nvPr/>
        </p:nvSpPr>
        <p:spPr>
          <a:xfrm>
            <a:off x="7427814" y="1086734"/>
            <a:ext cx="1038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RTE-Tresps</a:t>
            </a:r>
          </a:p>
        </p:txBody>
      </p:sp>
      <p:graphicFrame>
        <p:nvGraphicFramePr>
          <p:cNvPr id="9" name="Diagramm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5156527"/>
              </p:ext>
            </p:extLst>
          </p:nvPr>
        </p:nvGraphicFramePr>
        <p:xfrm>
          <a:off x="372915" y="1262887"/>
          <a:ext cx="2736001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" name="Diagramm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9188855"/>
              </p:ext>
            </p:extLst>
          </p:nvPr>
        </p:nvGraphicFramePr>
        <p:xfrm>
          <a:off x="3276383" y="1262887"/>
          <a:ext cx="2736001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Textfeld 1"/>
          <p:cNvSpPr txBox="1"/>
          <p:nvPr/>
        </p:nvSpPr>
        <p:spPr>
          <a:xfrm rot="16200000">
            <a:off x="-113889" y="2024314"/>
            <a:ext cx="1197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/>
              <a:t> of CD4</a:t>
            </a:r>
            <a:r>
              <a:rPr lang="de-DE" sz="900" baseline="30000" dirty="0"/>
              <a:t>+</a:t>
            </a:r>
            <a:r>
              <a:rPr lang="de-DE" sz="900" dirty="0"/>
              <a:t>-T-</a:t>
            </a:r>
            <a:r>
              <a:rPr lang="de-DE" sz="900" dirty="0" err="1"/>
              <a:t>cells</a:t>
            </a:r>
            <a:r>
              <a:rPr lang="de-DE" sz="900" dirty="0"/>
              <a:t> [%]</a:t>
            </a:r>
          </a:p>
        </p:txBody>
      </p:sp>
      <p:sp>
        <p:nvSpPr>
          <p:cNvPr id="46" name="Textfeld 45"/>
          <p:cNvSpPr txBox="1"/>
          <p:nvPr/>
        </p:nvSpPr>
        <p:spPr>
          <a:xfrm rot="16200000">
            <a:off x="2789579" y="2024314"/>
            <a:ext cx="11977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/>
              <a:t> of CD4</a:t>
            </a:r>
            <a:r>
              <a:rPr lang="de-DE" sz="900" baseline="30000" dirty="0"/>
              <a:t>+</a:t>
            </a:r>
            <a:r>
              <a:rPr lang="de-DE" sz="900" dirty="0"/>
              <a:t>-T-</a:t>
            </a:r>
            <a:r>
              <a:rPr lang="de-DE" sz="900" dirty="0" err="1"/>
              <a:t>cells</a:t>
            </a:r>
            <a:r>
              <a:rPr lang="de-DE" sz="900" dirty="0"/>
              <a:t> [%]</a:t>
            </a:r>
          </a:p>
        </p:txBody>
      </p:sp>
      <p:graphicFrame>
        <p:nvGraphicFramePr>
          <p:cNvPr id="75" name="Diagramm 7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1126284"/>
              </p:ext>
            </p:extLst>
          </p:nvPr>
        </p:nvGraphicFramePr>
        <p:xfrm>
          <a:off x="6182956" y="1269098"/>
          <a:ext cx="2736000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77" name="Textfeld 76"/>
          <p:cNvSpPr txBox="1"/>
          <p:nvPr/>
        </p:nvSpPr>
        <p:spPr>
          <a:xfrm rot="16200000">
            <a:off x="5696151" y="2059380"/>
            <a:ext cx="1197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/>
              <a:t> of CD4</a:t>
            </a:r>
            <a:r>
              <a:rPr lang="de-DE" sz="900" baseline="30000" dirty="0"/>
              <a:t>+</a:t>
            </a:r>
            <a:r>
              <a:rPr lang="de-DE" sz="900" dirty="0"/>
              <a:t>-T-</a:t>
            </a:r>
            <a:r>
              <a:rPr lang="de-DE" sz="900" dirty="0" err="1"/>
              <a:t>cells</a:t>
            </a:r>
            <a:r>
              <a:rPr lang="de-DE" sz="900" dirty="0"/>
              <a:t> [%]</a:t>
            </a:r>
          </a:p>
        </p:txBody>
      </p:sp>
      <p:graphicFrame>
        <p:nvGraphicFramePr>
          <p:cNvPr id="76" name="Diagramm 7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6219294"/>
              </p:ext>
            </p:extLst>
          </p:nvPr>
        </p:nvGraphicFramePr>
        <p:xfrm>
          <a:off x="9084753" y="1262887"/>
          <a:ext cx="2736000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79" name="Textfeld 78"/>
          <p:cNvSpPr txBox="1"/>
          <p:nvPr/>
        </p:nvSpPr>
        <p:spPr>
          <a:xfrm rot="16200000">
            <a:off x="8597949" y="2053169"/>
            <a:ext cx="1197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900" dirty="0"/>
              <a:t> of CD4</a:t>
            </a:r>
            <a:r>
              <a:rPr lang="de-DE" sz="900" baseline="30000" dirty="0"/>
              <a:t>+</a:t>
            </a:r>
            <a:r>
              <a:rPr lang="de-DE" sz="900" dirty="0"/>
              <a:t>-T-</a:t>
            </a:r>
            <a:r>
              <a:rPr lang="de-DE" sz="900" dirty="0" err="1"/>
              <a:t>cells</a:t>
            </a:r>
            <a:r>
              <a:rPr lang="de-DE" sz="900" dirty="0"/>
              <a:t> [%]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9887216" y="1086733"/>
            <a:ext cx="1820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CD31</a:t>
            </a:r>
            <a:r>
              <a:rPr lang="de-DE" sz="1200" b="1" baseline="30000" dirty="0"/>
              <a:t>+</a:t>
            </a:r>
            <a:r>
              <a:rPr lang="de-DE" sz="1200" b="1" dirty="0"/>
              <a:t>-memory Tresps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6368551" y="9546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32" name="Textfeld 24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7703C55E-CC3C-4D8C-9D0C-1F35ED45D963}"/>
              </a:ext>
            </a:extLst>
          </p:cNvPr>
          <p:cNvSpPr txBox="1"/>
          <p:nvPr/>
        </p:nvSpPr>
        <p:spPr>
          <a:xfrm>
            <a:off x="11032915" y="4878412"/>
            <a:ext cx="6751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DE" sz="900" b="1" dirty="0">
                <a:solidFill>
                  <a:schemeClr val="tx1"/>
                </a:solidFill>
              </a:rPr>
              <a:t>p &lt; </a:t>
            </a:r>
            <a:r>
              <a:rPr lang="de-DE" sz="900" b="1" dirty="0" smtClean="0">
                <a:solidFill>
                  <a:schemeClr val="tx1"/>
                </a:solidFill>
              </a:rPr>
              <a:t>0.001</a:t>
            </a:r>
            <a:endParaRPr lang="de-DE" sz="900" b="1" dirty="0">
              <a:solidFill>
                <a:schemeClr val="tx1"/>
              </a:solidFill>
            </a:endParaRPr>
          </a:p>
        </p:txBody>
      </p:sp>
      <p:sp>
        <p:nvSpPr>
          <p:cNvPr id="33" name="Textfeld 24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920FAE2C-792F-4551-8F7D-85ACC615C210}"/>
              </a:ext>
            </a:extLst>
          </p:cNvPr>
          <p:cNvSpPr txBox="1"/>
          <p:nvPr/>
        </p:nvSpPr>
        <p:spPr>
          <a:xfrm>
            <a:off x="11032915" y="5053791"/>
            <a:ext cx="6110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de-DE" sz="900" b="1" dirty="0">
                <a:solidFill>
                  <a:srgbClr val="FF0000"/>
                </a:solidFill>
              </a:rPr>
              <a:t>p &lt; </a:t>
            </a:r>
            <a:r>
              <a:rPr lang="de-DE" sz="900" b="1" dirty="0" smtClean="0">
                <a:solidFill>
                  <a:srgbClr val="FF0000"/>
                </a:solidFill>
              </a:rPr>
              <a:t>0.05</a:t>
            </a:r>
            <a:endParaRPr lang="de-DE" sz="9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754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7</Words>
  <Application>Microsoft Office PowerPoint</Application>
  <PresentationFormat>Benutzerdefiniert</PresentationFormat>
  <Paragraphs>4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laudius Gottschalk</dc:creator>
  <cp:lastModifiedBy>Steinborn, Andrea</cp:lastModifiedBy>
  <cp:revision>66</cp:revision>
  <cp:lastPrinted>2018-10-19T11:28:54Z</cp:lastPrinted>
  <dcterms:created xsi:type="dcterms:W3CDTF">2017-04-22T09:34:45Z</dcterms:created>
  <dcterms:modified xsi:type="dcterms:W3CDTF">2018-10-19T11:30:00Z</dcterms:modified>
</cp:coreProperties>
</file>